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8" r:id="rId2"/>
    <p:sldId id="278" r:id="rId3"/>
    <p:sldId id="267" r:id="rId4"/>
    <p:sldId id="263" r:id="rId5"/>
    <p:sldId id="259" r:id="rId6"/>
    <p:sldId id="273" r:id="rId7"/>
    <p:sldId id="269" r:id="rId8"/>
    <p:sldId id="270" r:id="rId9"/>
    <p:sldId id="277" r:id="rId10"/>
    <p:sldId id="271" r:id="rId11"/>
    <p:sldId id="272" r:id="rId1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ishi hiroki" initials="nh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294" autoAdjust="0"/>
    <p:restoredTop sz="94088"/>
  </p:normalViewPr>
  <p:slideViewPr>
    <p:cSldViewPr snapToGrid="0" snapToObjects="1">
      <p:cViewPr varScale="1">
        <p:scale>
          <a:sx n="48" d="100"/>
          <a:sy n="48" d="100"/>
        </p:scale>
        <p:origin x="229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25237;&#31295;paper\Takenaka%20essential%20AAs\nagata%20tomoshige%20data\delAA1wk%20mRNA&#12414;&#12392;&#12417;%20(&#33258;&#21205;&#20445;&#23384;&#28168;&#12415;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25237;&#31295;paper\Takenaka%20essential%20AAs\Takenaka%20data\&#34880;&#28479;&#65299;-M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C-USER\Desktop\&#23455;&#39443;\primary\primary1%20mRNA&#12414;&#12392;&#12417;.xlsx" TargetMode="Externa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5.xml"/><Relationship Id="rId1" Type="http://schemas.microsoft.com/office/2011/relationships/chartStyle" Target="style25.xml"/><Relationship Id="rId4" Type="http://schemas.openxmlformats.org/officeDocument/2006/relationships/oleObject" Target="file:///C:\Users\PC-USER\Desktop\&#23455;&#39443;\HepG2\HepG2%20+F,GH,ins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25237;&#31295;paper\Takenaka%20essential%20AAs\Takenaka%20data\muscle_LC3B_&#25968;&#20516;&#21270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shi%20Hiroki\Documents\&#12487;&#12540;&#12479;\2016&#24180;&#24230;\2016.12.9&#65374;&#12288;&#12521;&#12483;&#12488;&#23455;&#39443;&#65312;&#29287;&#22580;\&#12450;&#12511;&#12494;&#37240;&#12486;&#12441;&#12540;&#12479;&#12414;&#12392;&#12417;DY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E81B-49F9-856F-B0C78803E6CE}"/>
              </c:ext>
            </c:extLst>
          </c:dPt>
          <c:errBars>
            <c:errBarType val="both"/>
            <c:errValType val="cust"/>
            <c:noEndCap val="0"/>
            <c:plus>
              <c:numRef>
                <c:f>発表用!$C$79:$X$79</c:f>
                <c:numCache>
                  <c:formatCode>General</c:formatCode>
                  <c:ptCount val="22"/>
                  <c:pt idx="0">
                    <c:v>0.19189732715244345</c:v>
                  </c:pt>
                  <c:pt idx="1">
                    <c:v>7.3910155621960127E-2</c:v>
                  </c:pt>
                  <c:pt idx="2">
                    <c:v>0.18347142584576531</c:v>
                  </c:pt>
                  <c:pt idx="3">
                    <c:v>0.14890039800622792</c:v>
                  </c:pt>
                  <c:pt idx="4">
                    <c:v>0.13779877924633904</c:v>
                  </c:pt>
                  <c:pt idx="5">
                    <c:v>4.7012345869853346E-2</c:v>
                  </c:pt>
                  <c:pt idx="6">
                    <c:v>0.27099653511345023</c:v>
                  </c:pt>
                  <c:pt idx="7">
                    <c:v>0.68262837728800618</c:v>
                  </c:pt>
                  <c:pt idx="8">
                    <c:v>0.17839886143610079</c:v>
                  </c:pt>
                  <c:pt idx="9">
                    <c:v>0.28799261000647131</c:v>
                  </c:pt>
                  <c:pt idx="10">
                    <c:v>0.19935995186641764</c:v>
                  </c:pt>
                  <c:pt idx="11">
                    <c:v>0.12797760072658992</c:v>
                  </c:pt>
                  <c:pt idx="12">
                    <c:v>0.24473559420982396</c:v>
                  </c:pt>
                  <c:pt idx="13">
                    <c:v>4.5714209192854842E-2</c:v>
                  </c:pt>
                  <c:pt idx="14">
                    <c:v>0.59010684998100282</c:v>
                  </c:pt>
                  <c:pt idx="15">
                    <c:v>0.7334650630449342</c:v>
                  </c:pt>
                  <c:pt idx="16">
                    <c:v>0.33019838752413327</c:v>
                  </c:pt>
                  <c:pt idx="17">
                    <c:v>0.15617658787387456</c:v>
                  </c:pt>
                  <c:pt idx="18">
                    <c:v>0.21948572159353436</c:v>
                  </c:pt>
                  <c:pt idx="19">
                    <c:v>0.29658104096493015</c:v>
                  </c:pt>
                  <c:pt idx="20">
                    <c:v>4.2277635594027869E-2</c:v>
                  </c:pt>
                  <c:pt idx="21">
                    <c:v>0.22554721876640604</c:v>
                  </c:pt>
                </c:numCache>
                <c:extLst/>
              </c:numRef>
            </c:plus>
            <c:minus>
              <c:numRef>
                <c:f>発表用!$C$79:$X$79</c:f>
                <c:numCache>
                  <c:formatCode>General</c:formatCode>
                  <c:ptCount val="22"/>
                  <c:pt idx="0">
                    <c:v>0.19189732715244345</c:v>
                  </c:pt>
                  <c:pt idx="1">
                    <c:v>7.3910155621960127E-2</c:v>
                  </c:pt>
                  <c:pt idx="2">
                    <c:v>0.18347142584576531</c:v>
                  </c:pt>
                  <c:pt idx="3">
                    <c:v>0.14890039800622792</c:v>
                  </c:pt>
                  <c:pt idx="4">
                    <c:v>0.13779877924633904</c:v>
                  </c:pt>
                  <c:pt idx="5">
                    <c:v>4.7012345869853346E-2</c:v>
                  </c:pt>
                  <c:pt idx="6">
                    <c:v>0.27099653511345023</c:v>
                  </c:pt>
                  <c:pt idx="7">
                    <c:v>0.68262837728800618</c:v>
                  </c:pt>
                  <c:pt idx="8">
                    <c:v>0.17839886143610079</c:v>
                  </c:pt>
                  <c:pt idx="9">
                    <c:v>0.28799261000647131</c:v>
                  </c:pt>
                  <c:pt idx="10">
                    <c:v>0.19935995186641764</c:v>
                  </c:pt>
                  <c:pt idx="11">
                    <c:v>0.12797760072658992</c:v>
                  </c:pt>
                  <c:pt idx="12">
                    <c:v>0.24473559420982396</c:v>
                  </c:pt>
                  <c:pt idx="13">
                    <c:v>4.5714209192854842E-2</c:v>
                  </c:pt>
                  <c:pt idx="14">
                    <c:v>0.59010684998100282</c:v>
                  </c:pt>
                  <c:pt idx="15">
                    <c:v>0.7334650630449342</c:v>
                  </c:pt>
                  <c:pt idx="16">
                    <c:v>0.33019838752413327</c:v>
                  </c:pt>
                  <c:pt idx="17">
                    <c:v>0.15617658787387456</c:v>
                  </c:pt>
                  <c:pt idx="18">
                    <c:v>0.21948572159353436</c:v>
                  </c:pt>
                  <c:pt idx="19">
                    <c:v>0.29658104096493015</c:v>
                  </c:pt>
                  <c:pt idx="20">
                    <c:v>4.2277635594027869E-2</c:v>
                  </c:pt>
                  <c:pt idx="21">
                    <c:v>0.22554721876640604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発表用!$C$73:$X$73</c:f>
              <c:strCache>
                <c:ptCount val="22"/>
                <c:pt idx="0">
                  <c:v>CN</c:v>
                </c:pt>
                <c:pt idx="1">
                  <c:v>5AA</c:v>
                </c:pt>
                <c:pt idx="2">
                  <c:v>ΔIle</c:v>
                </c:pt>
                <c:pt idx="3">
                  <c:v>ΔPhe</c:v>
                </c:pt>
                <c:pt idx="4">
                  <c:v>ΔThr</c:v>
                </c:pt>
                <c:pt idx="5">
                  <c:v>ΔTrp</c:v>
                </c:pt>
                <c:pt idx="6">
                  <c:v>ΔVal</c:v>
                </c:pt>
                <c:pt idx="7">
                  <c:v>ΔLeu</c:v>
                </c:pt>
                <c:pt idx="8">
                  <c:v>ΔLys</c:v>
                </c:pt>
                <c:pt idx="9">
                  <c:v>ΔMet</c:v>
                </c:pt>
                <c:pt idx="10">
                  <c:v>ΔHis</c:v>
                </c:pt>
                <c:pt idx="11">
                  <c:v>ΔAla</c:v>
                </c:pt>
                <c:pt idx="12">
                  <c:v>ΔArg</c:v>
                </c:pt>
                <c:pt idx="13">
                  <c:v>ΔAsp</c:v>
                </c:pt>
                <c:pt idx="14">
                  <c:v>ΔAsn</c:v>
                </c:pt>
                <c:pt idx="15">
                  <c:v>ΔCys</c:v>
                </c:pt>
                <c:pt idx="16">
                  <c:v>ΔGlu</c:v>
                </c:pt>
                <c:pt idx="17">
                  <c:v>ΔGln</c:v>
                </c:pt>
                <c:pt idx="18">
                  <c:v>ΔGly</c:v>
                </c:pt>
                <c:pt idx="19">
                  <c:v>ΔPro</c:v>
                </c:pt>
                <c:pt idx="20">
                  <c:v>ΔSer</c:v>
                </c:pt>
                <c:pt idx="21">
                  <c:v>ΔTyr</c:v>
                </c:pt>
              </c:strCache>
              <c:extLst/>
            </c:strRef>
          </c:cat>
          <c:val>
            <c:numRef>
              <c:f>発表用!$C$78:$X$78</c:f>
              <c:numCache>
                <c:formatCode>General</c:formatCode>
                <c:ptCount val="22"/>
                <c:pt idx="0">
                  <c:v>1</c:v>
                </c:pt>
                <c:pt idx="1">
                  <c:v>0.58584998871083915</c:v>
                </c:pt>
                <c:pt idx="2">
                  <c:v>0.64411000630538107</c:v>
                </c:pt>
                <c:pt idx="3">
                  <c:v>0.49441158515493638</c:v>
                </c:pt>
                <c:pt idx="4">
                  <c:v>0.90027998057873326</c:v>
                </c:pt>
                <c:pt idx="5">
                  <c:v>0.50886542795637379</c:v>
                </c:pt>
                <c:pt idx="6">
                  <c:v>0.86892045419033848</c:v>
                </c:pt>
                <c:pt idx="7">
                  <c:v>1.7476925567398485</c:v>
                </c:pt>
                <c:pt idx="8">
                  <c:v>0.91658658589432196</c:v>
                </c:pt>
                <c:pt idx="9">
                  <c:v>1.5359253882584547</c:v>
                </c:pt>
                <c:pt idx="10">
                  <c:v>0.73684770432734525</c:v>
                </c:pt>
                <c:pt idx="11">
                  <c:v>0.96137148101514758</c:v>
                </c:pt>
                <c:pt idx="12">
                  <c:v>1.1124975187130222</c:v>
                </c:pt>
                <c:pt idx="13">
                  <c:v>0.43576772652402412</c:v>
                </c:pt>
                <c:pt idx="14">
                  <c:v>1.3601222251342744</c:v>
                </c:pt>
                <c:pt idx="15">
                  <c:v>2.2227292682400006</c:v>
                </c:pt>
                <c:pt idx="16">
                  <c:v>0.77168485950430321</c:v>
                </c:pt>
                <c:pt idx="17">
                  <c:v>0.94600333867234399</c:v>
                </c:pt>
                <c:pt idx="18">
                  <c:v>1.2577069575939777</c:v>
                </c:pt>
                <c:pt idx="19">
                  <c:v>0.96419126684808243</c:v>
                </c:pt>
                <c:pt idx="20">
                  <c:v>1.1253627405225481</c:v>
                </c:pt>
                <c:pt idx="21">
                  <c:v>1.1913125406337939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E81B-49F9-856F-B0C78803E6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734319416"/>
        <c:axId val="734320592"/>
      </c:barChart>
      <c:catAx>
        <c:axId val="734319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34320592"/>
        <c:crosses val="autoZero"/>
        <c:auto val="1"/>
        <c:lblAlgn val="ctr"/>
        <c:lblOffset val="100"/>
        <c:noMultiLvlLbl val="0"/>
      </c:catAx>
      <c:valAx>
        <c:axId val="7343205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34319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EB-46A8-954F-0D08E761F5F5}"/>
            </c:ext>
          </c:extLst>
        </c:ser>
        <c:ser>
          <c:idx val="1"/>
          <c:order val="1"/>
          <c:tx>
            <c:v>ΔTrp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94:$X$94</c:f>
                <c:numCache>
                  <c:formatCode>General</c:formatCode>
                  <c:ptCount val="20"/>
                  <c:pt idx="0">
                    <c:v>8.6037388333701198E-2</c:v>
                  </c:pt>
                  <c:pt idx="1">
                    <c:v>4.3200510100623285E-2</c:v>
                  </c:pt>
                  <c:pt idx="2">
                    <c:v>0.37478486552993906</c:v>
                  </c:pt>
                  <c:pt idx="3">
                    <c:v>2.6251583084572386E-2</c:v>
                  </c:pt>
                  <c:pt idx="4">
                    <c:v>0.23485587485126172</c:v>
                  </c:pt>
                  <c:pt idx="5">
                    <c:v>0.15559783879536185</c:v>
                  </c:pt>
                  <c:pt idx="6">
                    <c:v>0.13615976215709574</c:v>
                  </c:pt>
                  <c:pt idx="7">
                    <c:v>0.25860049400380369</c:v>
                  </c:pt>
                  <c:pt idx="8">
                    <c:v>4.002009838734253E-2</c:v>
                  </c:pt>
                  <c:pt idx="9">
                    <c:v>0.33338272893010157</c:v>
                  </c:pt>
                  <c:pt idx="10">
                    <c:v>3.0070169447620677E-2</c:v>
                  </c:pt>
                  <c:pt idx="11">
                    <c:v>4.9350133956755665E-2</c:v>
                  </c:pt>
                  <c:pt idx="12">
                    <c:v>5.8931904997766071E-2</c:v>
                  </c:pt>
                  <c:pt idx="13">
                    <c:v>2.1504250717456048E-2</c:v>
                  </c:pt>
                  <c:pt idx="14">
                    <c:v>4.330826949048177E-2</c:v>
                  </c:pt>
                  <c:pt idx="15">
                    <c:v>0.21490833437803411</c:v>
                  </c:pt>
                  <c:pt idx="16">
                    <c:v>0.16837973671032022</c:v>
                  </c:pt>
                  <c:pt idx="17">
                    <c:v>0.20209265845062144</c:v>
                  </c:pt>
                  <c:pt idx="18">
                    <c:v>0.25436800635448831</c:v>
                  </c:pt>
                  <c:pt idx="19">
                    <c:v>0.11678459247544709</c:v>
                  </c:pt>
                </c:numCache>
              </c:numRef>
            </c:plus>
            <c:minus>
              <c:numRef>
                <c:f>Sheet1!$E$94:$X$94</c:f>
                <c:numCache>
                  <c:formatCode>General</c:formatCode>
                  <c:ptCount val="20"/>
                  <c:pt idx="0">
                    <c:v>8.6037388333701198E-2</c:v>
                  </c:pt>
                  <c:pt idx="1">
                    <c:v>4.3200510100623285E-2</c:v>
                  </c:pt>
                  <c:pt idx="2">
                    <c:v>0.37478486552993906</c:v>
                  </c:pt>
                  <c:pt idx="3">
                    <c:v>2.6251583084572386E-2</c:v>
                  </c:pt>
                  <c:pt idx="4">
                    <c:v>0.23485587485126172</c:v>
                  </c:pt>
                  <c:pt idx="5">
                    <c:v>0.15559783879536185</c:v>
                  </c:pt>
                  <c:pt idx="6">
                    <c:v>0.13615976215709574</c:v>
                  </c:pt>
                  <c:pt idx="7">
                    <c:v>0.25860049400380369</c:v>
                  </c:pt>
                  <c:pt idx="8">
                    <c:v>4.002009838734253E-2</c:v>
                  </c:pt>
                  <c:pt idx="9">
                    <c:v>0.33338272893010157</c:v>
                  </c:pt>
                  <c:pt idx="10">
                    <c:v>3.0070169447620677E-2</c:v>
                  </c:pt>
                  <c:pt idx="11">
                    <c:v>4.9350133956755665E-2</c:v>
                  </c:pt>
                  <c:pt idx="12">
                    <c:v>5.8931904997766071E-2</c:v>
                  </c:pt>
                  <c:pt idx="13">
                    <c:v>2.1504250717456048E-2</c:v>
                  </c:pt>
                  <c:pt idx="14">
                    <c:v>4.330826949048177E-2</c:v>
                  </c:pt>
                  <c:pt idx="15">
                    <c:v>0.21490833437803411</c:v>
                  </c:pt>
                  <c:pt idx="16">
                    <c:v>0.16837973671032022</c:v>
                  </c:pt>
                  <c:pt idx="17">
                    <c:v>0.20209265845062144</c:v>
                  </c:pt>
                  <c:pt idx="18">
                    <c:v>0.25436800635448831</c:v>
                  </c:pt>
                  <c:pt idx="19">
                    <c:v>0.116784592475447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93:$X$93</c:f>
              <c:numCache>
                <c:formatCode>General</c:formatCode>
                <c:ptCount val="20"/>
                <c:pt idx="0">
                  <c:v>0.59723526948317174</c:v>
                </c:pt>
                <c:pt idx="1">
                  <c:v>0.40823867978368727</c:v>
                </c:pt>
                <c:pt idx="2">
                  <c:v>6.3383757678738988</c:v>
                </c:pt>
                <c:pt idx="3">
                  <c:v>0.14143926080554914</c:v>
                </c:pt>
                <c:pt idx="4">
                  <c:v>1.4449227373584581</c:v>
                </c:pt>
                <c:pt idx="5">
                  <c:v>1.0008595063605596</c:v>
                </c:pt>
                <c:pt idx="6">
                  <c:v>3.0368039179548094</c:v>
                </c:pt>
                <c:pt idx="7">
                  <c:v>1.1075508016878042</c:v>
                </c:pt>
                <c:pt idx="8">
                  <c:v>0.46533798773278517</c:v>
                </c:pt>
                <c:pt idx="9">
                  <c:v>3.4309669619294159</c:v>
                </c:pt>
                <c:pt idx="10">
                  <c:v>0.81863132991304066</c:v>
                </c:pt>
                <c:pt idx="11">
                  <c:v>0.69343613906247503</c:v>
                </c:pt>
                <c:pt idx="12">
                  <c:v>0.78281621242114785</c:v>
                </c:pt>
                <c:pt idx="13">
                  <c:v>0.26836713971076154</c:v>
                </c:pt>
                <c:pt idx="14">
                  <c:v>0.99705563548930376</c:v>
                </c:pt>
                <c:pt idx="15">
                  <c:v>6.2456784058893717</c:v>
                </c:pt>
                <c:pt idx="16">
                  <c:v>1.7262672655443074</c:v>
                </c:pt>
                <c:pt idx="17">
                  <c:v>1.0067959734383025</c:v>
                </c:pt>
                <c:pt idx="18">
                  <c:v>5.3076471744400777</c:v>
                </c:pt>
                <c:pt idx="19">
                  <c:v>0.756170136120987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CEB-46A8-954F-0D08E761F5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8810864"/>
        <c:axId val="358808120"/>
      </c:barChart>
      <c:catAx>
        <c:axId val="358810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08120"/>
        <c:crosses val="autoZero"/>
        <c:auto val="1"/>
        <c:lblAlgn val="ctr"/>
        <c:lblOffset val="100"/>
        <c:noMultiLvlLbl val="0"/>
      </c:catAx>
      <c:valAx>
        <c:axId val="358808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108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BFB-4C70-92A2-D929FA060FE7}"/>
            </c:ext>
          </c:extLst>
        </c:ser>
        <c:ser>
          <c:idx val="1"/>
          <c:order val="1"/>
          <c:tx>
            <c:v>ΔVal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96:$X$96</c:f>
                <c:numCache>
                  <c:formatCode>General</c:formatCode>
                  <c:ptCount val="20"/>
                  <c:pt idx="0">
                    <c:v>9.3787561922557217E-2</c:v>
                  </c:pt>
                  <c:pt idx="1">
                    <c:v>2.5574718616705058E-2</c:v>
                  </c:pt>
                  <c:pt idx="2">
                    <c:v>1.6072285571125211</c:v>
                  </c:pt>
                  <c:pt idx="3">
                    <c:v>4.849791544784212E-2</c:v>
                  </c:pt>
                  <c:pt idx="4">
                    <c:v>7.0640155945151883E-2</c:v>
                  </c:pt>
                  <c:pt idx="5">
                    <c:v>0.1824987553650777</c:v>
                  </c:pt>
                  <c:pt idx="6">
                    <c:v>0.40335097220935889</c:v>
                  </c:pt>
                  <c:pt idx="7">
                    <c:v>0.37779204751512313</c:v>
                  </c:pt>
                  <c:pt idx="8">
                    <c:v>6.5280029402085105E-2</c:v>
                  </c:pt>
                  <c:pt idx="9">
                    <c:v>0.25582094105184278</c:v>
                  </c:pt>
                  <c:pt idx="10">
                    <c:v>5.1952311974579772E-2</c:v>
                  </c:pt>
                  <c:pt idx="11">
                    <c:v>3.0929359542852992E-2</c:v>
                  </c:pt>
                  <c:pt idx="12">
                    <c:v>9.2309408869506712E-2</c:v>
                  </c:pt>
                  <c:pt idx="13">
                    <c:v>1.7407067090544549E-2</c:v>
                  </c:pt>
                  <c:pt idx="14">
                    <c:v>6.8650520077394306E-2</c:v>
                  </c:pt>
                  <c:pt idx="15">
                    <c:v>0.60707375216384263</c:v>
                  </c:pt>
                  <c:pt idx="16">
                    <c:v>0.38820143466112683</c:v>
                  </c:pt>
                  <c:pt idx="17">
                    <c:v>0.22091502262836935</c:v>
                  </c:pt>
                  <c:pt idx="18">
                    <c:v>0.40905711100414716</c:v>
                  </c:pt>
                  <c:pt idx="19">
                    <c:v>1.1978595435604405E-2</c:v>
                  </c:pt>
                </c:numCache>
              </c:numRef>
            </c:plus>
            <c:minus>
              <c:numRef>
                <c:f>Sheet1!$E$96:$X$96</c:f>
                <c:numCache>
                  <c:formatCode>General</c:formatCode>
                  <c:ptCount val="20"/>
                  <c:pt idx="0">
                    <c:v>9.3787561922557217E-2</c:v>
                  </c:pt>
                  <c:pt idx="1">
                    <c:v>2.5574718616705058E-2</c:v>
                  </c:pt>
                  <c:pt idx="2">
                    <c:v>1.6072285571125211</c:v>
                  </c:pt>
                  <c:pt idx="3">
                    <c:v>4.849791544784212E-2</c:v>
                  </c:pt>
                  <c:pt idx="4">
                    <c:v>7.0640155945151883E-2</c:v>
                  </c:pt>
                  <c:pt idx="5">
                    <c:v>0.1824987553650777</c:v>
                  </c:pt>
                  <c:pt idx="6">
                    <c:v>0.40335097220935889</c:v>
                  </c:pt>
                  <c:pt idx="7">
                    <c:v>0.37779204751512313</c:v>
                  </c:pt>
                  <c:pt idx="8">
                    <c:v>6.5280029402085105E-2</c:v>
                  </c:pt>
                  <c:pt idx="9">
                    <c:v>0.25582094105184278</c:v>
                  </c:pt>
                  <c:pt idx="10">
                    <c:v>5.1952311974579772E-2</c:v>
                  </c:pt>
                  <c:pt idx="11">
                    <c:v>3.0929359542852992E-2</c:v>
                  </c:pt>
                  <c:pt idx="12">
                    <c:v>9.2309408869506712E-2</c:v>
                  </c:pt>
                  <c:pt idx="13">
                    <c:v>1.7407067090544549E-2</c:v>
                  </c:pt>
                  <c:pt idx="14">
                    <c:v>6.8650520077394306E-2</c:v>
                  </c:pt>
                  <c:pt idx="15">
                    <c:v>0.60707375216384263</c:v>
                  </c:pt>
                  <c:pt idx="16">
                    <c:v>0.38820143466112683</c:v>
                  </c:pt>
                  <c:pt idx="17">
                    <c:v>0.22091502262836935</c:v>
                  </c:pt>
                  <c:pt idx="18">
                    <c:v>0.40905711100414716</c:v>
                  </c:pt>
                  <c:pt idx="19">
                    <c:v>1.197859543560440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95:$X$95</c:f>
              <c:numCache>
                <c:formatCode>General</c:formatCode>
                <c:ptCount val="20"/>
                <c:pt idx="0">
                  <c:v>0.49471897540041992</c:v>
                </c:pt>
                <c:pt idx="1">
                  <c:v>0.35235549255987975</c:v>
                </c:pt>
                <c:pt idx="2">
                  <c:v>5.7906124929571794</c:v>
                </c:pt>
                <c:pt idx="3">
                  <c:v>0.66562136140148576</c:v>
                </c:pt>
                <c:pt idx="4">
                  <c:v>0.32934181306296623</c:v>
                </c:pt>
                <c:pt idx="5">
                  <c:v>0.81272828971749178</c:v>
                </c:pt>
                <c:pt idx="6">
                  <c:v>2.4290636366687632</c:v>
                </c:pt>
                <c:pt idx="7">
                  <c:v>1.1212656421472478</c:v>
                </c:pt>
                <c:pt idx="8">
                  <c:v>0.48293051901312395</c:v>
                </c:pt>
                <c:pt idx="9">
                  <c:v>3.8846504109720663</c:v>
                </c:pt>
                <c:pt idx="10">
                  <c:v>0.65976581445784432</c:v>
                </c:pt>
                <c:pt idx="11">
                  <c:v>0.62991370219800114</c:v>
                </c:pt>
                <c:pt idx="12">
                  <c:v>0.89886975879573561</c:v>
                </c:pt>
                <c:pt idx="13">
                  <c:v>0.2632283622732664</c:v>
                </c:pt>
                <c:pt idx="14">
                  <c:v>0.89199410133621659</c:v>
                </c:pt>
                <c:pt idx="15">
                  <c:v>6.8144301190882075</c:v>
                </c:pt>
                <c:pt idx="16">
                  <c:v>2.8738433782780564</c:v>
                </c:pt>
                <c:pt idx="17">
                  <c:v>0.87280635634966208</c:v>
                </c:pt>
                <c:pt idx="18">
                  <c:v>6.3152105084968246</c:v>
                </c:pt>
                <c:pt idx="19">
                  <c:v>0.714057129482335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BFB-4C70-92A2-D929FA060F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8808512"/>
        <c:axId val="358808904"/>
      </c:barChart>
      <c:catAx>
        <c:axId val="358808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08904"/>
        <c:crosses val="autoZero"/>
        <c:auto val="1"/>
        <c:lblAlgn val="ctr"/>
        <c:lblOffset val="100"/>
        <c:noMultiLvlLbl val="0"/>
      </c:catAx>
      <c:valAx>
        <c:axId val="358808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08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50-41F3-A660-C5C7E7697856}"/>
            </c:ext>
          </c:extLst>
        </c:ser>
        <c:ser>
          <c:idx val="1"/>
          <c:order val="1"/>
          <c:tx>
            <c:v>ΔHis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98:$X$98</c:f>
                <c:numCache>
                  <c:formatCode>General</c:formatCode>
                  <c:ptCount val="20"/>
                  <c:pt idx="0">
                    <c:v>8.8948671118912359E-2</c:v>
                  </c:pt>
                  <c:pt idx="1">
                    <c:v>5.5638406316988805E-2</c:v>
                  </c:pt>
                  <c:pt idx="2">
                    <c:v>0.840951809681597</c:v>
                  </c:pt>
                  <c:pt idx="3">
                    <c:v>0.16010854855578491</c:v>
                  </c:pt>
                  <c:pt idx="4">
                    <c:v>0.22832738695179472</c:v>
                  </c:pt>
                  <c:pt idx="5">
                    <c:v>0.14587608872280564</c:v>
                  </c:pt>
                  <c:pt idx="6">
                    <c:v>0.37971144998427253</c:v>
                  </c:pt>
                  <c:pt idx="7">
                    <c:v>0.29550053480622934</c:v>
                  </c:pt>
                  <c:pt idx="8">
                    <c:v>1.549865061946889E-2</c:v>
                  </c:pt>
                  <c:pt idx="9">
                    <c:v>0.39680165081041813</c:v>
                  </c:pt>
                  <c:pt idx="10">
                    <c:v>8.719943404337932E-2</c:v>
                  </c:pt>
                  <c:pt idx="11">
                    <c:v>1.6393325992980275E-2</c:v>
                  </c:pt>
                  <c:pt idx="12">
                    <c:v>0.10498231960185342</c:v>
                  </c:pt>
                  <c:pt idx="13">
                    <c:v>2.0787429570199915E-2</c:v>
                  </c:pt>
                  <c:pt idx="14">
                    <c:v>8.9584391419880005E-2</c:v>
                  </c:pt>
                  <c:pt idx="15">
                    <c:v>0.55395687297568441</c:v>
                  </c:pt>
                  <c:pt idx="16">
                    <c:v>6.1611052293463628E-2</c:v>
                  </c:pt>
                  <c:pt idx="17">
                    <c:v>0.10885634633167396</c:v>
                  </c:pt>
                  <c:pt idx="18">
                    <c:v>0.4630028824885743</c:v>
                  </c:pt>
                  <c:pt idx="19">
                    <c:v>0.23379338041998513</c:v>
                  </c:pt>
                </c:numCache>
              </c:numRef>
            </c:plus>
            <c:minus>
              <c:numRef>
                <c:f>Sheet1!$E$98:$X$98</c:f>
                <c:numCache>
                  <c:formatCode>General</c:formatCode>
                  <c:ptCount val="20"/>
                  <c:pt idx="0">
                    <c:v>8.8948671118912359E-2</c:v>
                  </c:pt>
                  <c:pt idx="1">
                    <c:v>5.5638406316988805E-2</c:v>
                  </c:pt>
                  <c:pt idx="2">
                    <c:v>0.840951809681597</c:v>
                  </c:pt>
                  <c:pt idx="3">
                    <c:v>0.16010854855578491</c:v>
                  </c:pt>
                  <c:pt idx="4">
                    <c:v>0.22832738695179472</c:v>
                  </c:pt>
                  <c:pt idx="5">
                    <c:v>0.14587608872280564</c:v>
                  </c:pt>
                  <c:pt idx="6">
                    <c:v>0.37971144998427253</c:v>
                  </c:pt>
                  <c:pt idx="7">
                    <c:v>0.29550053480622934</c:v>
                  </c:pt>
                  <c:pt idx="8">
                    <c:v>1.549865061946889E-2</c:v>
                  </c:pt>
                  <c:pt idx="9">
                    <c:v>0.39680165081041813</c:v>
                  </c:pt>
                  <c:pt idx="10">
                    <c:v>8.719943404337932E-2</c:v>
                  </c:pt>
                  <c:pt idx="11">
                    <c:v>1.6393325992980275E-2</c:v>
                  </c:pt>
                  <c:pt idx="12">
                    <c:v>0.10498231960185342</c:v>
                  </c:pt>
                  <c:pt idx="13">
                    <c:v>2.0787429570199915E-2</c:v>
                  </c:pt>
                  <c:pt idx="14">
                    <c:v>8.9584391419880005E-2</c:v>
                  </c:pt>
                  <c:pt idx="15">
                    <c:v>0.55395687297568441</c:v>
                  </c:pt>
                  <c:pt idx="16">
                    <c:v>6.1611052293463628E-2</c:v>
                  </c:pt>
                  <c:pt idx="17">
                    <c:v>0.10885634633167396</c:v>
                  </c:pt>
                  <c:pt idx="18">
                    <c:v>0.4630028824885743</c:v>
                  </c:pt>
                  <c:pt idx="19">
                    <c:v>0.233793380419985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97:$X$97</c:f>
              <c:numCache>
                <c:formatCode>General</c:formatCode>
                <c:ptCount val="20"/>
                <c:pt idx="0">
                  <c:v>0.52360637811257316</c:v>
                </c:pt>
                <c:pt idx="1">
                  <c:v>0.38031937721380077</c:v>
                </c:pt>
                <c:pt idx="2">
                  <c:v>5.2303888376597385</c:v>
                </c:pt>
                <c:pt idx="3">
                  <c:v>0.69359438453680244</c:v>
                </c:pt>
                <c:pt idx="4">
                  <c:v>1.225534069388716</c:v>
                </c:pt>
                <c:pt idx="5">
                  <c:v>0.83357101308849835</c:v>
                </c:pt>
                <c:pt idx="6">
                  <c:v>2.5393495233065431</c:v>
                </c:pt>
                <c:pt idx="7">
                  <c:v>0.95739475830014431</c:v>
                </c:pt>
                <c:pt idx="8">
                  <c:v>9.8284718680418229E-2</c:v>
                </c:pt>
                <c:pt idx="9">
                  <c:v>3.4980905374246958</c:v>
                </c:pt>
                <c:pt idx="10">
                  <c:v>0.69187212432965539</c:v>
                </c:pt>
                <c:pt idx="11">
                  <c:v>0.62913681657504783</c:v>
                </c:pt>
                <c:pt idx="12">
                  <c:v>0.94105928862401289</c:v>
                </c:pt>
                <c:pt idx="13">
                  <c:v>0.31503008837250102</c:v>
                </c:pt>
                <c:pt idx="14">
                  <c:v>1.1896988328064888</c:v>
                </c:pt>
                <c:pt idx="15">
                  <c:v>6.6642852356222209</c:v>
                </c:pt>
                <c:pt idx="16">
                  <c:v>2.48844207255449</c:v>
                </c:pt>
                <c:pt idx="17">
                  <c:v>0.65598236097019536</c:v>
                </c:pt>
                <c:pt idx="18">
                  <c:v>5.0282847991181088</c:v>
                </c:pt>
                <c:pt idx="19">
                  <c:v>0.996886922162731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050-41F3-A660-C5C7E76978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240192"/>
        <c:axId val="360240976"/>
      </c:barChart>
      <c:catAx>
        <c:axId val="360240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40976"/>
        <c:crosses val="autoZero"/>
        <c:auto val="1"/>
        <c:lblAlgn val="ctr"/>
        <c:lblOffset val="100"/>
        <c:noMultiLvlLbl val="0"/>
      </c:catAx>
      <c:valAx>
        <c:axId val="3602409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40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E1-48B0-A2B4-64A12F1D143E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86:$X$86</c:f>
                <c:numCache>
                  <c:formatCode>General</c:formatCode>
                  <c:ptCount val="20"/>
                  <c:pt idx="0">
                    <c:v>5.4413210003874363E-2</c:v>
                  </c:pt>
                  <c:pt idx="1">
                    <c:v>3.9226318523254533E-2</c:v>
                  </c:pt>
                  <c:pt idx="2">
                    <c:v>0.47118651169963927</c:v>
                  </c:pt>
                  <c:pt idx="3">
                    <c:v>1.8681185310199216E-2</c:v>
                  </c:pt>
                  <c:pt idx="4">
                    <c:v>0.12090743174231018</c:v>
                  </c:pt>
                  <c:pt idx="5">
                    <c:v>6.9072274377367363E-2</c:v>
                  </c:pt>
                  <c:pt idx="6">
                    <c:v>0.13371104011170692</c:v>
                  </c:pt>
                  <c:pt idx="7">
                    <c:v>0.24854574576943483</c:v>
                  </c:pt>
                  <c:pt idx="8">
                    <c:v>9.7127635739677112E-3</c:v>
                  </c:pt>
                  <c:pt idx="9">
                    <c:v>0.11875105553658574</c:v>
                  </c:pt>
                  <c:pt idx="10">
                    <c:v>6.3272170046679302E-2</c:v>
                  </c:pt>
                  <c:pt idx="11">
                    <c:v>3.8559067371361833E-2</c:v>
                  </c:pt>
                  <c:pt idx="12">
                    <c:v>5.3126223575692716E-2</c:v>
                  </c:pt>
                  <c:pt idx="13">
                    <c:v>4.9470222815765186E-2</c:v>
                  </c:pt>
                  <c:pt idx="14">
                    <c:v>3.8928697422634738E-2</c:v>
                  </c:pt>
                  <c:pt idx="15">
                    <c:v>0.25369307791909984</c:v>
                  </c:pt>
                  <c:pt idx="16">
                    <c:v>0.45476138882611489</c:v>
                  </c:pt>
                  <c:pt idx="17">
                    <c:v>0.11865995844670792</c:v>
                  </c:pt>
                  <c:pt idx="18">
                    <c:v>0.25065934729202943</c:v>
                  </c:pt>
                  <c:pt idx="19">
                    <c:v>8.5283862558227386E-3</c:v>
                  </c:pt>
                </c:numCache>
              </c:numRef>
            </c:plus>
            <c:minus>
              <c:numRef>
                <c:f>Sheet1!$E$86:$X$86</c:f>
                <c:numCache>
                  <c:formatCode>General</c:formatCode>
                  <c:ptCount val="20"/>
                  <c:pt idx="0">
                    <c:v>5.4413210003874363E-2</c:v>
                  </c:pt>
                  <c:pt idx="1">
                    <c:v>3.9226318523254533E-2</c:v>
                  </c:pt>
                  <c:pt idx="2">
                    <c:v>0.47118651169963927</c:v>
                  </c:pt>
                  <c:pt idx="3">
                    <c:v>1.8681185310199216E-2</c:v>
                  </c:pt>
                  <c:pt idx="4">
                    <c:v>0.12090743174231018</c:v>
                  </c:pt>
                  <c:pt idx="5">
                    <c:v>6.9072274377367363E-2</c:v>
                  </c:pt>
                  <c:pt idx="6">
                    <c:v>0.13371104011170692</c:v>
                  </c:pt>
                  <c:pt idx="7">
                    <c:v>0.24854574576943483</c:v>
                  </c:pt>
                  <c:pt idx="8">
                    <c:v>9.7127635739677112E-3</c:v>
                  </c:pt>
                  <c:pt idx="9">
                    <c:v>0.11875105553658574</c:v>
                  </c:pt>
                  <c:pt idx="10">
                    <c:v>6.3272170046679302E-2</c:v>
                  </c:pt>
                  <c:pt idx="11">
                    <c:v>3.8559067371361833E-2</c:v>
                  </c:pt>
                  <c:pt idx="12">
                    <c:v>5.3126223575692716E-2</c:v>
                  </c:pt>
                  <c:pt idx="13">
                    <c:v>4.9470222815765186E-2</c:v>
                  </c:pt>
                  <c:pt idx="14">
                    <c:v>3.8928697422634738E-2</c:v>
                  </c:pt>
                  <c:pt idx="15">
                    <c:v>0.25369307791909984</c:v>
                  </c:pt>
                  <c:pt idx="16">
                    <c:v>0.45476138882611489</c:v>
                  </c:pt>
                  <c:pt idx="17">
                    <c:v>0.11865995844670792</c:v>
                  </c:pt>
                  <c:pt idx="18">
                    <c:v>0.25065934729202943</c:v>
                  </c:pt>
                  <c:pt idx="19">
                    <c:v>8.528386255822738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85:$X$85</c:f>
              <c:numCache>
                <c:formatCode>General</c:formatCode>
                <c:ptCount val="20"/>
                <c:pt idx="0">
                  <c:v>0.70831540797986481</c:v>
                </c:pt>
                <c:pt idx="1">
                  <c:v>0.40474791719921516</c:v>
                </c:pt>
                <c:pt idx="2">
                  <c:v>6.0667521129506587</c:v>
                </c:pt>
                <c:pt idx="3">
                  <c:v>0.66793156792360964</c:v>
                </c:pt>
                <c:pt idx="4">
                  <c:v>1.6855439143812054</c:v>
                </c:pt>
                <c:pt idx="5">
                  <c:v>1.093561157717867</c:v>
                </c:pt>
                <c:pt idx="6">
                  <c:v>0.60873361240499069</c:v>
                </c:pt>
                <c:pt idx="7">
                  <c:v>0.93108178960502841</c:v>
                </c:pt>
                <c:pt idx="8">
                  <c:v>0.44542785306053795</c:v>
                </c:pt>
                <c:pt idx="9">
                  <c:v>3.8925712279749192</c:v>
                </c:pt>
                <c:pt idx="10">
                  <c:v>0.79065795202986944</c:v>
                </c:pt>
                <c:pt idx="11">
                  <c:v>0.72572674027289397</c:v>
                </c:pt>
                <c:pt idx="12">
                  <c:v>1.0659735128389547</c:v>
                </c:pt>
                <c:pt idx="13">
                  <c:v>0.40353536605009666</c:v>
                </c:pt>
                <c:pt idx="14">
                  <c:v>1.1599496431175551</c:v>
                </c:pt>
                <c:pt idx="15">
                  <c:v>6.6313619300935009</c:v>
                </c:pt>
                <c:pt idx="16">
                  <c:v>2.8318759790861283</c:v>
                </c:pt>
                <c:pt idx="17">
                  <c:v>0.85187178055505608</c:v>
                </c:pt>
                <c:pt idx="18">
                  <c:v>5.6844212641278311</c:v>
                </c:pt>
                <c:pt idx="19">
                  <c:v>1.00916419451446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E1-48B0-A2B4-64A12F1D14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238624"/>
        <c:axId val="360241368"/>
      </c:barChart>
      <c:catAx>
        <c:axId val="360238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41368"/>
        <c:crosses val="autoZero"/>
        <c:auto val="1"/>
        <c:lblAlgn val="ctr"/>
        <c:lblOffset val="100"/>
        <c:noMultiLvlLbl val="0"/>
      </c:catAx>
      <c:valAx>
        <c:axId val="3602413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38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CC-46F7-A4CF-2E2DB272F169}"/>
            </c:ext>
          </c:extLst>
        </c:ser>
        <c:ser>
          <c:idx val="1"/>
          <c:order val="1"/>
          <c:tx>
            <c:v>ΔArg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00:$X$100</c:f>
                <c:numCache>
                  <c:formatCode>General</c:formatCode>
                  <c:ptCount val="20"/>
                  <c:pt idx="0">
                    <c:v>4.6089896797254656E-2</c:v>
                  </c:pt>
                  <c:pt idx="1">
                    <c:v>1.0173734846610516E-2</c:v>
                  </c:pt>
                  <c:pt idx="2">
                    <c:v>0.13662243524357209</c:v>
                  </c:pt>
                  <c:pt idx="3">
                    <c:v>7.0074387980032793E-2</c:v>
                  </c:pt>
                  <c:pt idx="4">
                    <c:v>0.19566602828028823</c:v>
                  </c:pt>
                  <c:pt idx="5">
                    <c:v>0.11157259197850006</c:v>
                  </c:pt>
                  <c:pt idx="6">
                    <c:v>0.31729761759052283</c:v>
                  </c:pt>
                  <c:pt idx="7">
                    <c:v>0.54925451044846241</c:v>
                  </c:pt>
                  <c:pt idx="8">
                    <c:v>5.0729250430617191E-2</c:v>
                  </c:pt>
                  <c:pt idx="9">
                    <c:v>0.37998273210259037</c:v>
                  </c:pt>
                  <c:pt idx="10">
                    <c:v>4.5871873789761125E-2</c:v>
                  </c:pt>
                  <c:pt idx="11">
                    <c:v>2.3503504843134092E-2</c:v>
                  </c:pt>
                  <c:pt idx="12">
                    <c:v>0.10808849031122274</c:v>
                  </c:pt>
                  <c:pt idx="13">
                    <c:v>4.2511364692438734E-2</c:v>
                  </c:pt>
                  <c:pt idx="14">
                    <c:v>3.6592866802288619E-2</c:v>
                  </c:pt>
                  <c:pt idx="15">
                    <c:v>0.35445458896413834</c:v>
                  </c:pt>
                  <c:pt idx="16">
                    <c:v>0.23328414685889232</c:v>
                  </c:pt>
                  <c:pt idx="17">
                    <c:v>0.13583526716443314</c:v>
                  </c:pt>
                  <c:pt idx="18">
                    <c:v>0.24435295544977653</c:v>
                  </c:pt>
                  <c:pt idx="19">
                    <c:v>0.1481516235871754</c:v>
                  </c:pt>
                </c:numCache>
              </c:numRef>
            </c:plus>
            <c:minus>
              <c:numRef>
                <c:f>Sheet1!$E$100:$X$100</c:f>
                <c:numCache>
                  <c:formatCode>General</c:formatCode>
                  <c:ptCount val="20"/>
                  <c:pt idx="0">
                    <c:v>4.6089896797254656E-2</c:v>
                  </c:pt>
                  <c:pt idx="1">
                    <c:v>1.0173734846610516E-2</c:v>
                  </c:pt>
                  <c:pt idx="2">
                    <c:v>0.13662243524357209</c:v>
                  </c:pt>
                  <c:pt idx="3">
                    <c:v>7.0074387980032793E-2</c:v>
                  </c:pt>
                  <c:pt idx="4">
                    <c:v>0.19566602828028823</c:v>
                  </c:pt>
                  <c:pt idx="5">
                    <c:v>0.11157259197850006</c:v>
                  </c:pt>
                  <c:pt idx="6">
                    <c:v>0.31729761759052283</c:v>
                  </c:pt>
                  <c:pt idx="7">
                    <c:v>0.54925451044846241</c:v>
                  </c:pt>
                  <c:pt idx="8">
                    <c:v>5.0729250430617191E-2</c:v>
                  </c:pt>
                  <c:pt idx="9">
                    <c:v>0.37998273210259037</c:v>
                  </c:pt>
                  <c:pt idx="10">
                    <c:v>4.5871873789761125E-2</c:v>
                  </c:pt>
                  <c:pt idx="11">
                    <c:v>2.3503504843134092E-2</c:v>
                  </c:pt>
                  <c:pt idx="12">
                    <c:v>0.10808849031122274</c:v>
                  </c:pt>
                  <c:pt idx="13">
                    <c:v>4.2511364692438734E-2</c:v>
                  </c:pt>
                  <c:pt idx="14">
                    <c:v>3.6592866802288619E-2</c:v>
                  </c:pt>
                  <c:pt idx="15">
                    <c:v>0.35445458896413834</c:v>
                  </c:pt>
                  <c:pt idx="16">
                    <c:v>0.23328414685889232</c:v>
                  </c:pt>
                  <c:pt idx="17">
                    <c:v>0.13583526716443314</c:v>
                  </c:pt>
                  <c:pt idx="18">
                    <c:v>0.24435295544977653</c:v>
                  </c:pt>
                  <c:pt idx="19">
                    <c:v>0.14815162358717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99:$X$99</c:f>
              <c:numCache>
                <c:formatCode>General</c:formatCode>
                <c:ptCount val="20"/>
                <c:pt idx="0">
                  <c:v>0.48045321781917144</c:v>
                </c:pt>
                <c:pt idx="1">
                  <c:v>0.25216261108960641</c:v>
                </c:pt>
                <c:pt idx="2">
                  <c:v>3.7587463567371384</c:v>
                </c:pt>
                <c:pt idx="3">
                  <c:v>0.44828217535530285</c:v>
                </c:pt>
                <c:pt idx="4">
                  <c:v>1.2503631596717266</c:v>
                </c:pt>
                <c:pt idx="5">
                  <c:v>0.81181658771010357</c:v>
                </c:pt>
                <c:pt idx="6">
                  <c:v>2.7317295087990665</c:v>
                </c:pt>
                <c:pt idx="7">
                  <c:v>1.6910682688991157</c:v>
                </c:pt>
                <c:pt idx="8">
                  <c:v>0.65813054367411528</c:v>
                </c:pt>
                <c:pt idx="9">
                  <c:v>3.3660640307164247</c:v>
                </c:pt>
                <c:pt idx="10">
                  <c:v>0.5367552890897298</c:v>
                </c:pt>
                <c:pt idx="11">
                  <c:v>0.74930635391997524</c:v>
                </c:pt>
                <c:pt idx="12">
                  <c:v>0.98574322937007819</c:v>
                </c:pt>
                <c:pt idx="13">
                  <c:v>0.33795910841386023</c:v>
                </c:pt>
                <c:pt idx="14">
                  <c:v>1.2734266338434483</c:v>
                </c:pt>
                <c:pt idx="15">
                  <c:v>9.4845099282339049</c:v>
                </c:pt>
                <c:pt idx="16">
                  <c:v>2.0267388901314862</c:v>
                </c:pt>
                <c:pt idx="17">
                  <c:v>0.68543087983030793</c:v>
                </c:pt>
                <c:pt idx="18">
                  <c:v>4.645262739118686</c:v>
                </c:pt>
                <c:pt idx="19">
                  <c:v>0.524916210930671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BCC-46F7-A4CF-2E2DB272F1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239800"/>
        <c:axId val="360240584"/>
      </c:barChart>
      <c:catAx>
        <c:axId val="360239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40584"/>
        <c:crosses val="autoZero"/>
        <c:auto val="1"/>
        <c:lblAlgn val="ctr"/>
        <c:lblOffset val="100"/>
        <c:noMultiLvlLbl val="0"/>
      </c:catAx>
      <c:valAx>
        <c:axId val="360240584"/>
        <c:scaling>
          <c:orientation val="minMax"/>
          <c:max val="1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39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1F-4967-B4EE-6881B2AB550F}"/>
            </c:ext>
          </c:extLst>
        </c:ser>
        <c:ser>
          <c:idx val="1"/>
          <c:order val="1"/>
          <c:tx>
            <c:v>ΔAla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02:$X$102</c:f>
                <c:numCache>
                  <c:formatCode>General</c:formatCode>
                  <c:ptCount val="20"/>
                  <c:pt idx="0">
                    <c:v>4.9725283353544016E-2</c:v>
                  </c:pt>
                  <c:pt idx="1">
                    <c:v>1.2784684297470122E-2</c:v>
                  </c:pt>
                  <c:pt idx="2">
                    <c:v>0.13594240170362368</c:v>
                  </c:pt>
                  <c:pt idx="3">
                    <c:v>4.6346560600374793E-2</c:v>
                  </c:pt>
                  <c:pt idx="4">
                    <c:v>0.12447271002674193</c:v>
                  </c:pt>
                  <c:pt idx="5">
                    <c:v>5.0305156739397894E-2</c:v>
                  </c:pt>
                  <c:pt idx="6">
                    <c:v>0.19518324342578841</c:v>
                  </c:pt>
                  <c:pt idx="7">
                    <c:v>0.13851398939556417</c:v>
                  </c:pt>
                  <c:pt idx="8">
                    <c:v>6.8726585345105493E-2</c:v>
                  </c:pt>
                  <c:pt idx="9">
                    <c:v>0.21526749148452601</c:v>
                  </c:pt>
                  <c:pt idx="10">
                    <c:v>1.3572038885177303E-2</c:v>
                  </c:pt>
                  <c:pt idx="11">
                    <c:v>4.2603361628537418E-3</c:v>
                  </c:pt>
                  <c:pt idx="12">
                    <c:v>7.5862411148164471E-2</c:v>
                  </c:pt>
                  <c:pt idx="13">
                    <c:v>5.1079815156035595E-2</c:v>
                  </c:pt>
                  <c:pt idx="14">
                    <c:v>4.7800130612585763E-2</c:v>
                  </c:pt>
                  <c:pt idx="15">
                    <c:v>0.22715307845522029</c:v>
                  </c:pt>
                  <c:pt idx="16">
                    <c:v>7.8685274045999093E-2</c:v>
                  </c:pt>
                  <c:pt idx="17">
                    <c:v>0.10694777989176923</c:v>
                  </c:pt>
                  <c:pt idx="18">
                    <c:v>0.14050787001641585</c:v>
                  </c:pt>
                  <c:pt idx="19">
                    <c:v>3.8560621236933372E-2</c:v>
                  </c:pt>
                </c:numCache>
              </c:numRef>
            </c:plus>
            <c:minus>
              <c:numRef>
                <c:f>Sheet1!$E$102:$X$102</c:f>
                <c:numCache>
                  <c:formatCode>General</c:formatCode>
                  <c:ptCount val="20"/>
                  <c:pt idx="0">
                    <c:v>4.9725283353544016E-2</c:v>
                  </c:pt>
                  <c:pt idx="1">
                    <c:v>1.2784684297470122E-2</c:v>
                  </c:pt>
                  <c:pt idx="2">
                    <c:v>0.13594240170362368</c:v>
                  </c:pt>
                  <c:pt idx="3">
                    <c:v>4.6346560600374793E-2</c:v>
                  </c:pt>
                  <c:pt idx="4">
                    <c:v>0.12447271002674193</c:v>
                  </c:pt>
                  <c:pt idx="5">
                    <c:v>5.0305156739397894E-2</c:v>
                  </c:pt>
                  <c:pt idx="6">
                    <c:v>0.19518324342578841</c:v>
                  </c:pt>
                  <c:pt idx="7">
                    <c:v>0.13851398939556417</c:v>
                  </c:pt>
                  <c:pt idx="8">
                    <c:v>6.8726585345105493E-2</c:v>
                  </c:pt>
                  <c:pt idx="9">
                    <c:v>0.21526749148452601</c:v>
                  </c:pt>
                  <c:pt idx="10">
                    <c:v>1.3572038885177303E-2</c:v>
                  </c:pt>
                  <c:pt idx="11">
                    <c:v>4.2603361628537418E-3</c:v>
                  </c:pt>
                  <c:pt idx="12">
                    <c:v>7.5862411148164471E-2</c:v>
                  </c:pt>
                  <c:pt idx="13">
                    <c:v>5.1079815156035595E-2</c:v>
                  </c:pt>
                  <c:pt idx="14">
                    <c:v>4.7800130612585763E-2</c:v>
                  </c:pt>
                  <c:pt idx="15">
                    <c:v>0.22715307845522029</c:v>
                  </c:pt>
                  <c:pt idx="16">
                    <c:v>7.8685274045999093E-2</c:v>
                  </c:pt>
                  <c:pt idx="17">
                    <c:v>0.10694777989176923</c:v>
                  </c:pt>
                  <c:pt idx="18">
                    <c:v>0.14050787001641585</c:v>
                  </c:pt>
                  <c:pt idx="19">
                    <c:v>3.856062123693337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101:$X$101</c:f>
              <c:numCache>
                <c:formatCode>General</c:formatCode>
                <c:ptCount val="20"/>
                <c:pt idx="0">
                  <c:v>0.54977017876419376</c:v>
                </c:pt>
                <c:pt idx="1">
                  <c:v>0.35519500349979305</c:v>
                </c:pt>
                <c:pt idx="2">
                  <c:v>4.8934018222746998</c:v>
                </c:pt>
                <c:pt idx="3">
                  <c:v>0.52452275925462122</c:v>
                </c:pt>
                <c:pt idx="4">
                  <c:v>1.1316848097363559</c:v>
                </c:pt>
                <c:pt idx="5">
                  <c:v>0.801871915893697</c:v>
                </c:pt>
                <c:pt idx="6">
                  <c:v>2.5095080864097015</c:v>
                </c:pt>
                <c:pt idx="7">
                  <c:v>0.6032130630059368</c:v>
                </c:pt>
                <c:pt idx="8">
                  <c:v>0.29223462087350055</c:v>
                </c:pt>
                <c:pt idx="9">
                  <c:v>3.0945945295109123</c:v>
                </c:pt>
                <c:pt idx="10">
                  <c:v>0.68425994226647513</c:v>
                </c:pt>
                <c:pt idx="11">
                  <c:v>0.66583361030308719</c:v>
                </c:pt>
                <c:pt idx="12">
                  <c:v>0.9821708546997151</c:v>
                </c:pt>
                <c:pt idx="13">
                  <c:v>0.35414005491992029</c:v>
                </c:pt>
                <c:pt idx="14">
                  <c:v>1.0330648543262579</c:v>
                </c:pt>
                <c:pt idx="15">
                  <c:v>6.1192825856547231</c:v>
                </c:pt>
                <c:pt idx="16">
                  <c:v>2.6060024622578193</c:v>
                </c:pt>
                <c:pt idx="17">
                  <c:v>0.51604702465164976</c:v>
                </c:pt>
                <c:pt idx="18">
                  <c:v>5.0001010576997844</c:v>
                </c:pt>
                <c:pt idx="19">
                  <c:v>0.806199066048860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41F-4967-B4EE-6881B2AB55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239408"/>
        <c:axId val="360238232"/>
      </c:barChart>
      <c:catAx>
        <c:axId val="360239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38232"/>
        <c:crosses val="autoZero"/>
        <c:auto val="1"/>
        <c:lblAlgn val="ctr"/>
        <c:lblOffset val="100"/>
        <c:noMultiLvlLbl val="0"/>
      </c:catAx>
      <c:valAx>
        <c:axId val="360238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394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F5-4396-B36D-99F679BF4E03}"/>
            </c:ext>
          </c:extLst>
        </c:ser>
        <c:ser>
          <c:idx val="1"/>
          <c:order val="1"/>
          <c:tx>
            <c:v>ΔAsp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04:$X$104</c:f>
                <c:numCache>
                  <c:formatCode>General</c:formatCode>
                  <c:ptCount val="20"/>
                  <c:pt idx="0">
                    <c:v>0.24368108947070072</c:v>
                  </c:pt>
                  <c:pt idx="1">
                    <c:v>8.1474290440309519E-3</c:v>
                  </c:pt>
                  <c:pt idx="2">
                    <c:v>0.45472235125209798</c:v>
                  </c:pt>
                  <c:pt idx="3">
                    <c:v>2.2757343630978671E-2</c:v>
                  </c:pt>
                  <c:pt idx="4">
                    <c:v>0.1149572632817624</c:v>
                  </c:pt>
                  <c:pt idx="5">
                    <c:v>5.0853405905718831E-2</c:v>
                  </c:pt>
                  <c:pt idx="6">
                    <c:v>6.6313696771536493E-2</c:v>
                  </c:pt>
                  <c:pt idx="7">
                    <c:v>0.17436674599021243</c:v>
                  </c:pt>
                  <c:pt idx="8">
                    <c:v>4.2268860768845682E-3</c:v>
                  </c:pt>
                  <c:pt idx="9">
                    <c:v>0.28573033871417591</c:v>
                  </c:pt>
                  <c:pt idx="10">
                    <c:v>1.4888956165127505E-2</c:v>
                  </c:pt>
                  <c:pt idx="11">
                    <c:v>1.3459809535011321E-2</c:v>
                  </c:pt>
                  <c:pt idx="12">
                    <c:v>3.6629875651666345E-2</c:v>
                  </c:pt>
                  <c:pt idx="13">
                    <c:v>5.2116452407988796E-2</c:v>
                  </c:pt>
                  <c:pt idx="14">
                    <c:v>4.0233110052170382E-2</c:v>
                  </c:pt>
                  <c:pt idx="15">
                    <c:v>9.5641586926967379E-2</c:v>
                  </c:pt>
                  <c:pt idx="16">
                    <c:v>0.26959728160563345</c:v>
                  </c:pt>
                  <c:pt idx="17">
                    <c:v>0.14886703080478794</c:v>
                  </c:pt>
                  <c:pt idx="18">
                    <c:v>0.22160785945146755</c:v>
                  </c:pt>
                  <c:pt idx="19">
                    <c:v>1.5600665462867543E-2</c:v>
                  </c:pt>
                </c:numCache>
              </c:numRef>
            </c:plus>
            <c:minus>
              <c:numRef>
                <c:f>Sheet1!$E$104:$X$104</c:f>
                <c:numCache>
                  <c:formatCode>General</c:formatCode>
                  <c:ptCount val="20"/>
                  <c:pt idx="0">
                    <c:v>0.24368108947070072</c:v>
                  </c:pt>
                  <c:pt idx="1">
                    <c:v>8.1474290440309519E-3</c:v>
                  </c:pt>
                  <c:pt idx="2">
                    <c:v>0.45472235125209798</c:v>
                  </c:pt>
                  <c:pt idx="3">
                    <c:v>2.2757343630978671E-2</c:v>
                  </c:pt>
                  <c:pt idx="4">
                    <c:v>0.1149572632817624</c:v>
                  </c:pt>
                  <c:pt idx="5">
                    <c:v>5.0853405905718831E-2</c:v>
                  </c:pt>
                  <c:pt idx="6">
                    <c:v>6.6313696771536493E-2</c:v>
                  </c:pt>
                  <c:pt idx="7">
                    <c:v>0.17436674599021243</c:v>
                  </c:pt>
                  <c:pt idx="8">
                    <c:v>4.2268860768845682E-3</c:v>
                  </c:pt>
                  <c:pt idx="9">
                    <c:v>0.28573033871417591</c:v>
                  </c:pt>
                  <c:pt idx="10">
                    <c:v>1.4888956165127505E-2</c:v>
                  </c:pt>
                  <c:pt idx="11">
                    <c:v>1.3459809535011321E-2</c:v>
                  </c:pt>
                  <c:pt idx="12">
                    <c:v>3.6629875651666345E-2</c:v>
                  </c:pt>
                  <c:pt idx="13">
                    <c:v>5.2116452407988796E-2</c:v>
                  </c:pt>
                  <c:pt idx="14">
                    <c:v>4.0233110052170382E-2</c:v>
                  </c:pt>
                  <c:pt idx="15">
                    <c:v>9.5641586926967379E-2</c:v>
                  </c:pt>
                  <c:pt idx="16">
                    <c:v>0.26959728160563345</c:v>
                  </c:pt>
                  <c:pt idx="17">
                    <c:v>0.14886703080478794</c:v>
                  </c:pt>
                  <c:pt idx="18">
                    <c:v>0.22160785945146755</c:v>
                  </c:pt>
                  <c:pt idx="19">
                    <c:v>1.56006654628675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103:$X$103</c:f>
              <c:numCache>
                <c:formatCode>General</c:formatCode>
                <c:ptCount val="20"/>
                <c:pt idx="0">
                  <c:v>0.91494740149722809</c:v>
                </c:pt>
                <c:pt idx="1">
                  <c:v>0.36576299279699698</c:v>
                </c:pt>
                <c:pt idx="2">
                  <c:v>5.0846058362548403</c:v>
                </c:pt>
                <c:pt idx="3">
                  <c:v>0.55424794942245048</c:v>
                </c:pt>
                <c:pt idx="4">
                  <c:v>1.4002781228204313</c:v>
                </c:pt>
                <c:pt idx="5">
                  <c:v>0.95212640045374775</c:v>
                </c:pt>
                <c:pt idx="6">
                  <c:v>2.6279199174245571</c:v>
                </c:pt>
                <c:pt idx="7">
                  <c:v>0.79579209909010828</c:v>
                </c:pt>
                <c:pt idx="8">
                  <c:v>0.44506499656859561</c:v>
                </c:pt>
                <c:pt idx="9">
                  <c:v>3.8164498797495057</c:v>
                </c:pt>
                <c:pt idx="10">
                  <c:v>0.62330613244125466</c:v>
                </c:pt>
                <c:pt idx="11">
                  <c:v>0.75887478609992864</c:v>
                </c:pt>
                <c:pt idx="12">
                  <c:v>1.1332512385360387</c:v>
                </c:pt>
                <c:pt idx="13">
                  <c:v>0.44566482672490787</c:v>
                </c:pt>
                <c:pt idx="14">
                  <c:v>1.1225053649958274</c:v>
                </c:pt>
                <c:pt idx="15">
                  <c:v>6.0954739622367811</c:v>
                </c:pt>
                <c:pt idx="16">
                  <c:v>2.5404736299291861</c:v>
                </c:pt>
                <c:pt idx="17">
                  <c:v>0.66334055903365041</c:v>
                </c:pt>
                <c:pt idx="18">
                  <c:v>4.6932145765471978</c:v>
                </c:pt>
                <c:pt idx="19">
                  <c:v>0.950877152436991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5F5-4396-B36D-99F679BF4E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234704"/>
        <c:axId val="360236272"/>
      </c:barChart>
      <c:catAx>
        <c:axId val="360234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36272"/>
        <c:crosses val="autoZero"/>
        <c:auto val="1"/>
        <c:lblAlgn val="ctr"/>
        <c:lblOffset val="100"/>
        <c:noMultiLvlLbl val="0"/>
      </c:catAx>
      <c:valAx>
        <c:axId val="360236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34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1FD-4BAC-8970-B6513C9661F6}"/>
            </c:ext>
          </c:extLst>
        </c:ser>
        <c:ser>
          <c:idx val="1"/>
          <c:order val="1"/>
          <c:tx>
            <c:v>ΔAsn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06:$X$106</c:f>
                <c:numCache>
                  <c:formatCode>General</c:formatCode>
                  <c:ptCount val="20"/>
                  <c:pt idx="0">
                    <c:v>3.585060444061438E-2</c:v>
                  </c:pt>
                  <c:pt idx="1">
                    <c:v>1.5017770033181001E-2</c:v>
                  </c:pt>
                  <c:pt idx="2">
                    <c:v>0.28296734750451846</c:v>
                  </c:pt>
                  <c:pt idx="3">
                    <c:v>1.4117788884915036E-2</c:v>
                  </c:pt>
                  <c:pt idx="4">
                    <c:v>0.13961764954595246</c:v>
                  </c:pt>
                  <c:pt idx="5">
                    <c:v>7.0206012036641202E-2</c:v>
                  </c:pt>
                  <c:pt idx="6">
                    <c:v>0.14639159545114117</c:v>
                  </c:pt>
                  <c:pt idx="7">
                    <c:v>0.23716916443143865</c:v>
                  </c:pt>
                  <c:pt idx="8">
                    <c:v>2.2847596153281163E-2</c:v>
                  </c:pt>
                  <c:pt idx="9">
                    <c:v>0.29698499287210284</c:v>
                  </c:pt>
                  <c:pt idx="10">
                    <c:v>2.4206017411510412E-2</c:v>
                  </c:pt>
                  <c:pt idx="11">
                    <c:v>2.7709356295239383E-2</c:v>
                  </c:pt>
                  <c:pt idx="12">
                    <c:v>1.4972049804607247E-2</c:v>
                  </c:pt>
                  <c:pt idx="13">
                    <c:v>4.3231979868767346E-2</c:v>
                  </c:pt>
                  <c:pt idx="14">
                    <c:v>5.7995897098147148E-2</c:v>
                  </c:pt>
                  <c:pt idx="15">
                    <c:v>0.45149363593925235</c:v>
                  </c:pt>
                  <c:pt idx="16">
                    <c:v>0.15495941373246086</c:v>
                  </c:pt>
                  <c:pt idx="17">
                    <c:v>0.1476300043630136</c:v>
                  </c:pt>
                  <c:pt idx="18">
                    <c:v>0.25071667826031641</c:v>
                  </c:pt>
                  <c:pt idx="19">
                    <c:v>7.5917507093286971E-2</c:v>
                  </c:pt>
                </c:numCache>
              </c:numRef>
            </c:plus>
            <c:minus>
              <c:numRef>
                <c:f>Sheet1!$E$106:$X$106</c:f>
                <c:numCache>
                  <c:formatCode>General</c:formatCode>
                  <c:ptCount val="20"/>
                  <c:pt idx="0">
                    <c:v>3.585060444061438E-2</c:v>
                  </c:pt>
                  <c:pt idx="1">
                    <c:v>1.5017770033181001E-2</c:v>
                  </c:pt>
                  <c:pt idx="2">
                    <c:v>0.28296734750451846</c:v>
                  </c:pt>
                  <c:pt idx="3">
                    <c:v>1.4117788884915036E-2</c:v>
                  </c:pt>
                  <c:pt idx="4">
                    <c:v>0.13961764954595246</c:v>
                  </c:pt>
                  <c:pt idx="5">
                    <c:v>7.0206012036641202E-2</c:v>
                  </c:pt>
                  <c:pt idx="6">
                    <c:v>0.14639159545114117</c:v>
                  </c:pt>
                  <c:pt idx="7">
                    <c:v>0.23716916443143865</c:v>
                  </c:pt>
                  <c:pt idx="8">
                    <c:v>2.2847596153281163E-2</c:v>
                  </c:pt>
                  <c:pt idx="9">
                    <c:v>0.29698499287210284</c:v>
                  </c:pt>
                  <c:pt idx="10">
                    <c:v>2.4206017411510412E-2</c:v>
                  </c:pt>
                  <c:pt idx="11">
                    <c:v>2.7709356295239383E-2</c:v>
                  </c:pt>
                  <c:pt idx="12">
                    <c:v>1.4972049804607247E-2</c:v>
                  </c:pt>
                  <c:pt idx="13">
                    <c:v>4.3231979868767346E-2</c:v>
                  </c:pt>
                  <c:pt idx="14">
                    <c:v>5.7995897098147148E-2</c:v>
                  </c:pt>
                  <c:pt idx="15">
                    <c:v>0.45149363593925235</c:v>
                  </c:pt>
                  <c:pt idx="16">
                    <c:v>0.15495941373246086</c:v>
                  </c:pt>
                  <c:pt idx="17">
                    <c:v>0.1476300043630136</c:v>
                  </c:pt>
                  <c:pt idx="18">
                    <c:v>0.25071667826031641</c:v>
                  </c:pt>
                  <c:pt idx="19">
                    <c:v>7.591750709328697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105:$X$105</c:f>
              <c:numCache>
                <c:formatCode>General</c:formatCode>
                <c:ptCount val="20"/>
                <c:pt idx="0">
                  <c:v>0.58722472720148333</c:v>
                </c:pt>
                <c:pt idx="1">
                  <c:v>0.36755279838855343</c:v>
                </c:pt>
                <c:pt idx="2">
                  <c:v>6.5088130824734591</c:v>
                </c:pt>
                <c:pt idx="3">
                  <c:v>0.54890497052080889</c:v>
                </c:pt>
                <c:pt idx="4">
                  <c:v>1.347995904025203</c:v>
                </c:pt>
                <c:pt idx="5">
                  <c:v>0.94642449465841982</c:v>
                </c:pt>
                <c:pt idx="6">
                  <c:v>2.8588340471274827</c:v>
                </c:pt>
                <c:pt idx="7">
                  <c:v>0.77215908525420485</c:v>
                </c:pt>
                <c:pt idx="8">
                  <c:v>0.40188559670517793</c:v>
                </c:pt>
                <c:pt idx="9">
                  <c:v>3.5997344635504231</c:v>
                </c:pt>
                <c:pt idx="10">
                  <c:v>0.69980909327752749</c:v>
                </c:pt>
                <c:pt idx="11">
                  <c:v>0.65693145042447298</c:v>
                </c:pt>
                <c:pt idx="12">
                  <c:v>0.85570692563666373</c:v>
                </c:pt>
                <c:pt idx="13">
                  <c:v>0.40226341753808548</c:v>
                </c:pt>
                <c:pt idx="14">
                  <c:v>1.1221586093961591</c:v>
                </c:pt>
                <c:pt idx="15">
                  <c:v>5.9679728785622652</c:v>
                </c:pt>
                <c:pt idx="16">
                  <c:v>3.0649023497648589</c:v>
                </c:pt>
                <c:pt idx="17">
                  <c:v>0.60173580099625079</c:v>
                </c:pt>
                <c:pt idx="18">
                  <c:v>5.9424303591052166</c:v>
                </c:pt>
                <c:pt idx="19">
                  <c:v>1.07538011607842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1FD-4BAC-8970-B6513C9661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235488"/>
        <c:axId val="360235880"/>
      </c:barChart>
      <c:catAx>
        <c:axId val="360235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35880"/>
        <c:crosses val="autoZero"/>
        <c:auto val="1"/>
        <c:lblAlgn val="ctr"/>
        <c:lblOffset val="100"/>
        <c:noMultiLvlLbl val="0"/>
      </c:catAx>
      <c:valAx>
        <c:axId val="3602358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354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C2C-4488-81B0-403AE079065A}"/>
            </c:ext>
          </c:extLst>
        </c:ser>
        <c:ser>
          <c:idx val="1"/>
          <c:order val="1"/>
          <c:tx>
            <c:v>ΔGlu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08:$X$108</c:f>
                <c:numCache>
                  <c:formatCode>General</c:formatCode>
                  <c:ptCount val="20"/>
                  <c:pt idx="0">
                    <c:v>6.2461535641532145E-2</c:v>
                  </c:pt>
                  <c:pt idx="1">
                    <c:v>8.1343594574048942E-3</c:v>
                  </c:pt>
                  <c:pt idx="2">
                    <c:v>0.48809183611323825</c:v>
                  </c:pt>
                  <c:pt idx="3">
                    <c:v>5.53439423835798E-2</c:v>
                  </c:pt>
                  <c:pt idx="4">
                    <c:v>0.17056191799175305</c:v>
                  </c:pt>
                  <c:pt idx="5">
                    <c:v>0.10003318482838004</c:v>
                  </c:pt>
                  <c:pt idx="6">
                    <c:v>0.25600744152543703</c:v>
                  </c:pt>
                  <c:pt idx="7">
                    <c:v>0.26299608224912052</c:v>
                  </c:pt>
                  <c:pt idx="8">
                    <c:v>2.7552348282935624E-2</c:v>
                  </c:pt>
                  <c:pt idx="9">
                    <c:v>0.38876710467925879</c:v>
                  </c:pt>
                  <c:pt idx="10">
                    <c:v>3.0057064062945504E-2</c:v>
                  </c:pt>
                  <c:pt idx="11">
                    <c:v>8.5538280343813288E-3</c:v>
                  </c:pt>
                  <c:pt idx="12">
                    <c:v>5.2722770720159462E-2</c:v>
                  </c:pt>
                  <c:pt idx="13">
                    <c:v>3.4713911141765641E-2</c:v>
                  </c:pt>
                  <c:pt idx="14">
                    <c:v>3.2357745534881584E-2</c:v>
                  </c:pt>
                  <c:pt idx="15">
                    <c:v>0.41967803479843208</c:v>
                  </c:pt>
                  <c:pt idx="16">
                    <c:v>0.2183275063720693</c:v>
                  </c:pt>
                  <c:pt idx="17">
                    <c:v>0.19375604247406361</c:v>
                  </c:pt>
                  <c:pt idx="18">
                    <c:v>0.21720104823349329</c:v>
                  </c:pt>
                  <c:pt idx="19">
                    <c:v>5.4947054618555737E-2</c:v>
                  </c:pt>
                </c:numCache>
              </c:numRef>
            </c:plus>
            <c:minus>
              <c:numRef>
                <c:f>Sheet1!$E$108:$X$108</c:f>
                <c:numCache>
                  <c:formatCode>General</c:formatCode>
                  <c:ptCount val="20"/>
                  <c:pt idx="0">
                    <c:v>6.2461535641532145E-2</c:v>
                  </c:pt>
                  <c:pt idx="1">
                    <c:v>8.1343594574048942E-3</c:v>
                  </c:pt>
                  <c:pt idx="2">
                    <c:v>0.48809183611323825</c:v>
                  </c:pt>
                  <c:pt idx="3">
                    <c:v>5.53439423835798E-2</c:v>
                  </c:pt>
                  <c:pt idx="4">
                    <c:v>0.17056191799175305</c:v>
                  </c:pt>
                  <c:pt idx="5">
                    <c:v>0.10003318482838004</c:v>
                  </c:pt>
                  <c:pt idx="6">
                    <c:v>0.25600744152543703</c:v>
                  </c:pt>
                  <c:pt idx="7">
                    <c:v>0.26299608224912052</c:v>
                  </c:pt>
                  <c:pt idx="8">
                    <c:v>2.7552348282935624E-2</c:v>
                  </c:pt>
                  <c:pt idx="9">
                    <c:v>0.38876710467925879</c:v>
                  </c:pt>
                  <c:pt idx="10">
                    <c:v>3.0057064062945504E-2</c:v>
                  </c:pt>
                  <c:pt idx="11">
                    <c:v>8.5538280343813288E-3</c:v>
                  </c:pt>
                  <c:pt idx="12">
                    <c:v>5.2722770720159462E-2</c:v>
                  </c:pt>
                  <c:pt idx="13">
                    <c:v>3.4713911141765641E-2</c:v>
                  </c:pt>
                  <c:pt idx="14">
                    <c:v>3.2357745534881584E-2</c:v>
                  </c:pt>
                  <c:pt idx="15">
                    <c:v>0.41967803479843208</c:v>
                  </c:pt>
                  <c:pt idx="16">
                    <c:v>0.2183275063720693</c:v>
                  </c:pt>
                  <c:pt idx="17">
                    <c:v>0.19375604247406361</c:v>
                  </c:pt>
                  <c:pt idx="18">
                    <c:v>0.21720104823349329</c:v>
                  </c:pt>
                  <c:pt idx="19">
                    <c:v>5.494705461855573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107:$X$107</c:f>
              <c:numCache>
                <c:formatCode>General</c:formatCode>
                <c:ptCount val="20"/>
                <c:pt idx="0">
                  <c:v>0.59799973747110635</c:v>
                </c:pt>
                <c:pt idx="1">
                  <c:v>0.39990657306399235</c:v>
                </c:pt>
                <c:pt idx="2">
                  <c:v>5.0174942430554248</c:v>
                </c:pt>
                <c:pt idx="3">
                  <c:v>0.53394575918769005</c:v>
                </c:pt>
                <c:pt idx="4">
                  <c:v>1.2515978457656083</c:v>
                </c:pt>
                <c:pt idx="5">
                  <c:v>0.94065004240102157</c:v>
                </c:pt>
                <c:pt idx="6">
                  <c:v>2.5714697373941715</c:v>
                </c:pt>
                <c:pt idx="7">
                  <c:v>0.85348323734798548</c:v>
                </c:pt>
                <c:pt idx="8">
                  <c:v>0.43881751363798371</c:v>
                </c:pt>
                <c:pt idx="9">
                  <c:v>3.4211479076995648</c:v>
                </c:pt>
                <c:pt idx="10">
                  <c:v>0.70382774183210062</c:v>
                </c:pt>
                <c:pt idx="11">
                  <c:v>0.71560323139060511</c:v>
                </c:pt>
                <c:pt idx="12">
                  <c:v>1.1258411256995928</c:v>
                </c:pt>
                <c:pt idx="13">
                  <c:v>0.36786357721311697</c:v>
                </c:pt>
                <c:pt idx="14">
                  <c:v>1.2177930688392038</c:v>
                </c:pt>
                <c:pt idx="15">
                  <c:v>6.7452356106398135</c:v>
                </c:pt>
                <c:pt idx="16">
                  <c:v>2.4493730182996405</c:v>
                </c:pt>
                <c:pt idx="17">
                  <c:v>0.58182238105801465</c:v>
                </c:pt>
                <c:pt idx="18">
                  <c:v>4.824708780364916</c:v>
                </c:pt>
                <c:pt idx="19">
                  <c:v>1.02654604484173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C2C-4488-81B0-403AE07906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237448"/>
        <c:axId val="360237840"/>
      </c:barChart>
      <c:catAx>
        <c:axId val="360237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37840"/>
        <c:crosses val="autoZero"/>
        <c:auto val="1"/>
        <c:lblAlgn val="ctr"/>
        <c:lblOffset val="100"/>
        <c:noMultiLvlLbl val="0"/>
      </c:catAx>
      <c:valAx>
        <c:axId val="3602378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237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87-4477-B71F-D6D7BBB227D4}"/>
            </c:ext>
          </c:extLst>
        </c:ser>
        <c:ser>
          <c:idx val="1"/>
          <c:order val="1"/>
          <c:tx>
            <c:v>ΔGly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10:$X$110</c:f>
                <c:numCache>
                  <c:formatCode>General</c:formatCode>
                  <c:ptCount val="20"/>
                  <c:pt idx="0">
                    <c:v>3.307140249622581E-2</c:v>
                  </c:pt>
                  <c:pt idx="1">
                    <c:v>1.2144027174738422E-2</c:v>
                  </c:pt>
                  <c:pt idx="2">
                    <c:v>0.48008768798703538</c:v>
                  </c:pt>
                  <c:pt idx="3">
                    <c:v>4.3339964708939062E-2</c:v>
                  </c:pt>
                  <c:pt idx="4">
                    <c:v>0.13722061427015372</c:v>
                  </c:pt>
                  <c:pt idx="5">
                    <c:v>5.6837178937830961E-2</c:v>
                  </c:pt>
                  <c:pt idx="6">
                    <c:v>0.21615268475925356</c:v>
                  </c:pt>
                  <c:pt idx="7">
                    <c:v>0.18536106610562644</c:v>
                  </c:pt>
                  <c:pt idx="8">
                    <c:v>1.4346354521194088E-2</c:v>
                  </c:pt>
                  <c:pt idx="9">
                    <c:v>0.33412040824017913</c:v>
                  </c:pt>
                  <c:pt idx="10">
                    <c:v>1.7680999006274529E-2</c:v>
                  </c:pt>
                  <c:pt idx="11">
                    <c:v>5.3218132834807273E-2</c:v>
                  </c:pt>
                  <c:pt idx="12">
                    <c:v>2.6685916259061731E-2</c:v>
                  </c:pt>
                  <c:pt idx="13">
                    <c:v>2.7247468806143999E-2</c:v>
                  </c:pt>
                  <c:pt idx="14">
                    <c:v>0.13904842538492057</c:v>
                  </c:pt>
                  <c:pt idx="15">
                    <c:v>0.17295273292960309</c:v>
                  </c:pt>
                  <c:pt idx="16">
                    <c:v>0.31979530764542247</c:v>
                  </c:pt>
                  <c:pt idx="17">
                    <c:v>0.14421884719983319</c:v>
                  </c:pt>
                  <c:pt idx="18">
                    <c:v>0.16489708879053122</c:v>
                  </c:pt>
                  <c:pt idx="19">
                    <c:v>4.9724208547695686E-2</c:v>
                  </c:pt>
                </c:numCache>
              </c:numRef>
            </c:plus>
            <c:minus>
              <c:numRef>
                <c:f>Sheet1!$E$110:$X$110</c:f>
                <c:numCache>
                  <c:formatCode>General</c:formatCode>
                  <c:ptCount val="20"/>
                  <c:pt idx="0">
                    <c:v>3.307140249622581E-2</c:v>
                  </c:pt>
                  <c:pt idx="1">
                    <c:v>1.2144027174738422E-2</c:v>
                  </c:pt>
                  <c:pt idx="2">
                    <c:v>0.48008768798703538</c:v>
                  </c:pt>
                  <c:pt idx="3">
                    <c:v>4.3339964708939062E-2</c:v>
                  </c:pt>
                  <c:pt idx="4">
                    <c:v>0.13722061427015372</c:v>
                  </c:pt>
                  <c:pt idx="5">
                    <c:v>5.6837178937830961E-2</c:v>
                  </c:pt>
                  <c:pt idx="6">
                    <c:v>0.21615268475925356</c:v>
                  </c:pt>
                  <c:pt idx="7">
                    <c:v>0.18536106610562644</c:v>
                  </c:pt>
                  <c:pt idx="8">
                    <c:v>1.4346354521194088E-2</c:v>
                  </c:pt>
                  <c:pt idx="9">
                    <c:v>0.33412040824017913</c:v>
                  </c:pt>
                  <c:pt idx="10">
                    <c:v>1.7680999006274529E-2</c:v>
                  </c:pt>
                  <c:pt idx="11">
                    <c:v>5.3218132834807273E-2</c:v>
                  </c:pt>
                  <c:pt idx="12">
                    <c:v>2.6685916259061731E-2</c:v>
                  </c:pt>
                  <c:pt idx="13">
                    <c:v>2.7247468806143999E-2</c:v>
                  </c:pt>
                  <c:pt idx="14">
                    <c:v>0.13904842538492057</c:v>
                  </c:pt>
                  <c:pt idx="15">
                    <c:v>0.17295273292960309</c:v>
                  </c:pt>
                  <c:pt idx="16">
                    <c:v>0.31979530764542247</c:v>
                  </c:pt>
                  <c:pt idx="17">
                    <c:v>0.14421884719983319</c:v>
                  </c:pt>
                  <c:pt idx="18">
                    <c:v>0.16489708879053122</c:v>
                  </c:pt>
                  <c:pt idx="19">
                    <c:v>4.972420854769568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109:$X$109</c:f>
              <c:numCache>
                <c:formatCode>General</c:formatCode>
                <c:ptCount val="20"/>
                <c:pt idx="0">
                  <c:v>0.55200606808840258</c:v>
                </c:pt>
                <c:pt idx="1">
                  <c:v>0.36658409833803168</c:v>
                </c:pt>
                <c:pt idx="2">
                  <c:v>4.848671338032025</c:v>
                </c:pt>
                <c:pt idx="3">
                  <c:v>0.59179489920535711</c:v>
                </c:pt>
                <c:pt idx="4">
                  <c:v>1.1837083428808017</c:v>
                </c:pt>
                <c:pt idx="5">
                  <c:v>0.8664396981307112</c:v>
                </c:pt>
                <c:pt idx="6">
                  <c:v>2.3602231086009851</c:v>
                </c:pt>
                <c:pt idx="7">
                  <c:v>0.62384262560565973</c:v>
                </c:pt>
                <c:pt idx="8">
                  <c:v>0.3328271786388311</c:v>
                </c:pt>
                <c:pt idx="9">
                  <c:v>3.4859452534220718</c:v>
                </c:pt>
                <c:pt idx="10">
                  <c:v>0.72665577268949944</c:v>
                </c:pt>
                <c:pt idx="11">
                  <c:v>0.72046301043248084</c:v>
                </c:pt>
                <c:pt idx="12">
                  <c:v>0.96963556454497146</c:v>
                </c:pt>
                <c:pt idx="13">
                  <c:v>0.38724393659642858</c:v>
                </c:pt>
                <c:pt idx="14">
                  <c:v>1.0967470168112801</c:v>
                </c:pt>
                <c:pt idx="15">
                  <c:v>5.7018764678914691</c:v>
                </c:pt>
                <c:pt idx="16">
                  <c:v>2.2010461944388933</c:v>
                </c:pt>
                <c:pt idx="17">
                  <c:v>0.54452644365816272</c:v>
                </c:pt>
                <c:pt idx="18">
                  <c:v>4.1405220506247558</c:v>
                </c:pt>
                <c:pt idx="19">
                  <c:v>0.894199092979378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B87-4477-B71F-D6D7BBB227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979128"/>
        <c:axId val="360976384"/>
      </c:barChart>
      <c:catAx>
        <c:axId val="360979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6384"/>
        <c:crosses val="autoZero"/>
        <c:auto val="1"/>
        <c:lblAlgn val="ctr"/>
        <c:lblOffset val="100"/>
        <c:noMultiLvlLbl val="0"/>
      </c:catAx>
      <c:valAx>
        <c:axId val="3609763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9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78E-4E37-9EEF-4CBA3C1EACD5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78E-4E37-9EEF-4CBA3C1EACD5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bg1">
                    <a:lumMod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78E-4E37-9EEF-4CBA3C1EACD5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bg1">
                    <a:lumMod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78E-4E37-9EEF-4CBA3C1EACD5}"/>
              </c:ext>
            </c:extLst>
          </c:dPt>
          <c:errBars>
            <c:errBarType val="plus"/>
            <c:errValType val="cust"/>
            <c:noEndCap val="0"/>
            <c:plus>
              <c:numRef>
                <c:f>'191123'!$S$12:$V$12</c:f>
                <c:numCache>
                  <c:formatCode>General</c:formatCode>
                  <c:ptCount val="4"/>
                  <c:pt idx="0">
                    <c:v>0.19977268042881738</c:v>
                  </c:pt>
                  <c:pt idx="1">
                    <c:v>0.73560320940810886</c:v>
                  </c:pt>
                  <c:pt idx="2">
                    <c:v>0.4840617471723086</c:v>
                  </c:pt>
                  <c:pt idx="3">
                    <c:v>0.382057986527433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multiLvlStrRef>
              <c:f>'191123'!$S$3:$V$4</c:f>
              <c:multiLvlStrCache>
                <c:ptCount val="4"/>
                <c:lvl>
                  <c:pt idx="0">
                    <c:v>Veh</c:v>
                  </c:pt>
                  <c:pt idx="1">
                    <c:v>IGF-I</c:v>
                  </c:pt>
                  <c:pt idx="2">
                    <c:v>Veh</c:v>
                  </c:pt>
                  <c:pt idx="3">
                    <c:v>IGF-I</c:v>
                  </c:pt>
                </c:lvl>
                <c:lvl>
                  <c:pt idx="0">
                    <c:v>CON</c:v>
                  </c:pt>
                  <c:pt idx="2">
                    <c:v>LP</c:v>
                  </c:pt>
                </c:lvl>
              </c:multiLvlStrCache>
            </c:multiLvlStrRef>
          </c:cat>
          <c:val>
            <c:numRef>
              <c:f>'191123'!$S$11:$V$11</c:f>
              <c:numCache>
                <c:formatCode>General</c:formatCode>
                <c:ptCount val="4"/>
                <c:pt idx="0">
                  <c:v>6.4706771827810412</c:v>
                </c:pt>
                <c:pt idx="1">
                  <c:v>5.6274285166720155</c:v>
                </c:pt>
                <c:pt idx="2">
                  <c:v>5.8478031638560388</c:v>
                </c:pt>
                <c:pt idx="3">
                  <c:v>5.82174145337807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78E-4E37-9EEF-4CBA3C1EAC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-1882442512"/>
        <c:axId val="-1882438704"/>
      </c:barChart>
      <c:catAx>
        <c:axId val="-1882442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882438704"/>
        <c:crosses val="autoZero"/>
        <c:auto val="1"/>
        <c:lblAlgn val="ctr"/>
        <c:lblOffset val="100"/>
        <c:noMultiLvlLbl val="0"/>
      </c:catAx>
      <c:valAx>
        <c:axId val="-188243870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88244251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180-42D1-B933-A28BC77CB873}"/>
            </c:ext>
          </c:extLst>
        </c:ser>
        <c:ser>
          <c:idx val="1"/>
          <c:order val="1"/>
          <c:tx>
            <c:v>ΔPro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12:$X$112</c:f>
                <c:numCache>
                  <c:formatCode>General</c:formatCode>
                  <c:ptCount val="20"/>
                  <c:pt idx="0">
                    <c:v>7.2262177702968167E-2</c:v>
                  </c:pt>
                  <c:pt idx="1">
                    <c:v>3.6372080251606521E-2</c:v>
                  </c:pt>
                  <c:pt idx="2">
                    <c:v>0.35020688886455892</c:v>
                  </c:pt>
                  <c:pt idx="3">
                    <c:v>5.5094722111700418E-2</c:v>
                  </c:pt>
                  <c:pt idx="4">
                    <c:v>0.11039874699574237</c:v>
                  </c:pt>
                  <c:pt idx="5">
                    <c:v>0.10509879804771224</c:v>
                  </c:pt>
                  <c:pt idx="6">
                    <c:v>9.5877594519273961E-3</c:v>
                  </c:pt>
                  <c:pt idx="7">
                    <c:v>6.0308640857361574E-2</c:v>
                  </c:pt>
                  <c:pt idx="8">
                    <c:v>2.0891941216476181E-2</c:v>
                  </c:pt>
                  <c:pt idx="9">
                    <c:v>0.12124246560011469</c:v>
                  </c:pt>
                  <c:pt idx="10">
                    <c:v>0.10666190665389354</c:v>
                  </c:pt>
                  <c:pt idx="11">
                    <c:v>4.705929322876188E-2</c:v>
                  </c:pt>
                  <c:pt idx="12">
                    <c:v>7.6757229282712114E-2</c:v>
                  </c:pt>
                  <c:pt idx="13">
                    <c:v>1.1952328875535614E-2</c:v>
                  </c:pt>
                  <c:pt idx="14">
                    <c:v>1.3346330509957195E-2</c:v>
                  </c:pt>
                  <c:pt idx="15">
                    <c:v>0.41499107136380564</c:v>
                  </c:pt>
                  <c:pt idx="16">
                    <c:v>0.21106911580332968</c:v>
                  </c:pt>
                  <c:pt idx="17">
                    <c:v>1.8632034716478771E-2</c:v>
                  </c:pt>
                  <c:pt idx="18">
                    <c:v>0.28667542390577527</c:v>
                  </c:pt>
                  <c:pt idx="19">
                    <c:v>4.4789289663924113E-2</c:v>
                  </c:pt>
                </c:numCache>
              </c:numRef>
            </c:plus>
            <c:minus>
              <c:numRef>
                <c:f>Sheet1!$E$112:$X$112</c:f>
                <c:numCache>
                  <c:formatCode>General</c:formatCode>
                  <c:ptCount val="20"/>
                  <c:pt idx="0">
                    <c:v>7.2262177702968167E-2</c:v>
                  </c:pt>
                  <c:pt idx="1">
                    <c:v>3.6372080251606521E-2</c:v>
                  </c:pt>
                  <c:pt idx="2">
                    <c:v>0.35020688886455892</c:v>
                  </c:pt>
                  <c:pt idx="3">
                    <c:v>5.5094722111700418E-2</c:v>
                  </c:pt>
                  <c:pt idx="4">
                    <c:v>0.11039874699574237</c:v>
                  </c:pt>
                  <c:pt idx="5">
                    <c:v>0.10509879804771224</c:v>
                  </c:pt>
                  <c:pt idx="6">
                    <c:v>9.5877594519273961E-3</c:v>
                  </c:pt>
                  <c:pt idx="7">
                    <c:v>6.0308640857361574E-2</c:v>
                  </c:pt>
                  <c:pt idx="8">
                    <c:v>2.0891941216476181E-2</c:v>
                  </c:pt>
                  <c:pt idx="9">
                    <c:v>0.12124246560011469</c:v>
                  </c:pt>
                  <c:pt idx="10">
                    <c:v>0.10666190665389354</c:v>
                  </c:pt>
                  <c:pt idx="11">
                    <c:v>4.705929322876188E-2</c:v>
                  </c:pt>
                  <c:pt idx="12">
                    <c:v>7.6757229282712114E-2</c:v>
                  </c:pt>
                  <c:pt idx="13">
                    <c:v>1.1952328875535614E-2</c:v>
                  </c:pt>
                  <c:pt idx="14">
                    <c:v>1.3346330509957195E-2</c:v>
                  </c:pt>
                  <c:pt idx="15">
                    <c:v>0.41499107136380564</c:v>
                  </c:pt>
                  <c:pt idx="16">
                    <c:v>0.21106911580332968</c:v>
                  </c:pt>
                  <c:pt idx="17">
                    <c:v>1.8632034716478771E-2</c:v>
                  </c:pt>
                  <c:pt idx="18">
                    <c:v>0.28667542390577527</c:v>
                  </c:pt>
                  <c:pt idx="19">
                    <c:v>4.478928966392411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111:$X$111</c:f>
              <c:numCache>
                <c:formatCode>General</c:formatCode>
                <c:ptCount val="20"/>
                <c:pt idx="0">
                  <c:v>0.61572834508322116</c:v>
                </c:pt>
                <c:pt idx="1">
                  <c:v>0.41205476957078419</c:v>
                </c:pt>
                <c:pt idx="2">
                  <c:v>5.0094381821633194</c:v>
                </c:pt>
                <c:pt idx="3">
                  <c:v>0.56275557875014193</c:v>
                </c:pt>
                <c:pt idx="4">
                  <c:v>1.2200646515937341</c:v>
                </c:pt>
                <c:pt idx="5">
                  <c:v>0.97121030297617417</c:v>
                </c:pt>
                <c:pt idx="6">
                  <c:v>2.4634692616786524</c:v>
                </c:pt>
                <c:pt idx="7">
                  <c:v>0.55506637976583184</c:v>
                </c:pt>
                <c:pt idx="8">
                  <c:v>0.37622039060740597</c:v>
                </c:pt>
                <c:pt idx="9">
                  <c:v>3.4622261186427026</c:v>
                </c:pt>
                <c:pt idx="10">
                  <c:v>0.66337476350374824</c:v>
                </c:pt>
                <c:pt idx="11">
                  <c:v>0.62564868500881898</c:v>
                </c:pt>
                <c:pt idx="12">
                  <c:v>1.0948095376534852</c:v>
                </c:pt>
                <c:pt idx="13">
                  <c:v>0.42094185343067486</c:v>
                </c:pt>
                <c:pt idx="14">
                  <c:v>1.0689515882609053</c:v>
                </c:pt>
                <c:pt idx="15">
                  <c:v>5.7036903209032817</c:v>
                </c:pt>
                <c:pt idx="16">
                  <c:v>2.6662274976456666</c:v>
                </c:pt>
                <c:pt idx="17">
                  <c:v>0.39248363569339423</c:v>
                </c:pt>
                <c:pt idx="18">
                  <c:v>4.6296450349474805</c:v>
                </c:pt>
                <c:pt idx="19">
                  <c:v>0.917190578712896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180-42D1-B933-A28BC77CB8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977560"/>
        <c:axId val="360976776"/>
      </c:barChart>
      <c:catAx>
        <c:axId val="360977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6776"/>
        <c:crosses val="autoZero"/>
        <c:auto val="1"/>
        <c:lblAlgn val="ctr"/>
        <c:lblOffset val="100"/>
        <c:noMultiLvlLbl val="0"/>
      </c:catAx>
      <c:valAx>
        <c:axId val="3609767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75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5B-44EE-8705-8393DFCA3EF5}"/>
            </c:ext>
          </c:extLst>
        </c:ser>
        <c:ser>
          <c:idx val="1"/>
          <c:order val="1"/>
          <c:tx>
            <c:v>ΔSer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14:$X$114</c:f>
                <c:numCache>
                  <c:formatCode>General</c:formatCode>
                  <c:ptCount val="20"/>
                  <c:pt idx="0">
                    <c:v>5.3276038945038483E-2</c:v>
                  </c:pt>
                  <c:pt idx="1">
                    <c:v>6.7612221363503849E-3</c:v>
                  </c:pt>
                  <c:pt idx="2">
                    <c:v>0.12635532393688823</c:v>
                  </c:pt>
                  <c:pt idx="3">
                    <c:v>1.9299637792386668E-2</c:v>
                  </c:pt>
                  <c:pt idx="4">
                    <c:v>0.10296857609225191</c:v>
                  </c:pt>
                  <c:pt idx="5">
                    <c:v>8.0902708501415482E-2</c:v>
                  </c:pt>
                  <c:pt idx="6">
                    <c:v>9.6229949734093462E-2</c:v>
                  </c:pt>
                  <c:pt idx="7">
                    <c:v>0.11790960438834092</c:v>
                  </c:pt>
                  <c:pt idx="8">
                    <c:v>2.7071832792996273E-2</c:v>
                  </c:pt>
                  <c:pt idx="9">
                    <c:v>6.1464200058844551E-2</c:v>
                  </c:pt>
                  <c:pt idx="10">
                    <c:v>1.929866235266435E-2</c:v>
                  </c:pt>
                  <c:pt idx="11">
                    <c:v>1.7485891260802553E-2</c:v>
                  </c:pt>
                  <c:pt idx="12">
                    <c:v>3.7410243475557534E-2</c:v>
                  </c:pt>
                  <c:pt idx="13">
                    <c:v>2.3281697330230076E-2</c:v>
                  </c:pt>
                  <c:pt idx="14">
                    <c:v>3.3494525267025871E-2</c:v>
                  </c:pt>
                  <c:pt idx="15">
                    <c:v>0.15027522486348488</c:v>
                  </c:pt>
                  <c:pt idx="16">
                    <c:v>0.13140724879476728</c:v>
                  </c:pt>
                  <c:pt idx="17">
                    <c:v>9.7886813074086226E-2</c:v>
                  </c:pt>
                  <c:pt idx="18">
                    <c:v>0.16987557153988467</c:v>
                  </c:pt>
                  <c:pt idx="19">
                    <c:v>7.4085878812677856E-3</c:v>
                  </c:pt>
                </c:numCache>
              </c:numRef>
            </c:plus>
            <c:minus>
              <c:numRef>
                <c:f>Sheet1!$E$114:$X$114</c:f>
                <c:numCache>
                  <c:formatCode>General</c:formatCode>
                  <c:ptCount val="20"/>
                  <c:pt idx="0">
                    <c:v>5.3276038945038483E-2</c:v>
                  </c:pt>
                  <c:pt idx="1">
                    <c:v>6.7612221363503849E-3</c:v>
                  </c:pt>
                  <c:pt idx="2">
                    <c:v>0.12635532393688823</c:v>
                  </c:pt>
                  <c:pt idx="3">
                    <c:v>1.9299637792386668E-2</c:v>
                  </c:pt>
                  <c:pt idx="4">
                    <c:v>0.10296857609225191</c:v>
                  </c:pt>
                  <c:pt idx="5">
                    <c:v>8.0902708501415482E-2</c:v>
                  </c:pt>
                  <c:pt idx="6">
                    <c:v>9.6229949734093462E-2</c:v>
                  </c:pt>
                  <c:pt idx="7">
                    <c:v>0.11790960438834092</c:v>
                  </c:pt>
                  <c:pt idx="8">
                    <c:v>2.7071832792996273E-2</c:v>
                  </c:pt>
                  <c:pt idx="9">
                    <c:v>6.1464200058844551E-2</c:v>
                  </c:pt>
                  <c:pt idx="10">
                    <c:v>1.929866235266435E-2</c:v>
                  </c:pt>
                  <c:pt idx="11">
                    <c:v>1.7485891260802553E-2</c:v>
                  </c:pt>
                  <c:pt idx="12">
                    <c:v>3.7410243475557534E-2</c:v>
                  </c:pt>
                  <c:pt idx="13">
                    <c:v>2.3281697330230076E-2</c:v>
                  </c:pt>
                  <c:pt idx="14">
                    <c:v>3.3494525267025871E-2</c:v>
                  </c:pt>
                  <c:pt idx="15">
                    <c:v>0.15027522486348488</c:v>
                  </c:pt>
                  <c:pt idx="16">
                    <c:v>0.13140724879476728</c:v>
                  </c:pt>
                  <c:pt idx="17">
                    <c:v>9.7886813074086226E-2</c:v>
                  </c:pt>
                  <c:pt idx="18">
                    <c:v>0.16987557153988467</c:v>
                  </c:pt>
                  <c:pt idx="19">
                    <c:v>7.408587881267785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113:$X$113</c:f>
              <c:numCache>
                <c:formatCode>General</c:formatCode>
                <c:ptCount val="20"/>
                <c:pt idx="0">
                  <c:v>0.5600234505750562</c:v>
                </c:pt>
                <c:pt idx="1">
                  <c:v>0.38630296510405288</c:v>
                </c:pt>
                <c:pt idx="2">
                  <c:v>4.5232838197313026</c:v>
                </c:pt>
                <c:pt idx="3">
                  <c:v>0.57147174872933137</c:v>
                </c:pt>
                <c:pt idx="4">
                  <c:v>1.2222720236227824</c:v>
                </c:pt>
                <c:pt idx="5">
                  <c:v>0.90728378182311176</c:v>
                </c:pt>
                <c:pt idx="6">
                  <c:v>2.6536271497425883</c:v>
                </c:pt>
                <c:pt idx="7">
                  <c:v>0.7005704300430754</c:v>
                </c:pt>
                <c:pt idx="8">
                  <c:v>0.39867080334962629</c:v>
                </c:pt>
                <c:pt idx="9">
                  <c:v>3.5621292988173416</c:v>
                </c:pt>
                <c:pt idx="10">
                  <c:v>0.70999006702092249</c:v>
                </c:pt>
                <c:pt idx="11">
                  <c:v>0.69813065510296834</c:v>
                </c:pt>
                <c:pt idx="12">
                  <c:v>1.083288496094468</c:v>
                </c:pt>
                <c:pt idx="13">
                  <c:v>0.36763786322271058</c:v>
                </c:pt>
                <c:pt idx="14">
                  <c:v>1.0174859199310957</c:v>
                </c:pt>
                <c:pt idx="15">
                  <c:v>5.5908383815330227</c:v>
                </c:pt>
                <c:pt idx="16">
                  <c:v>2.0442592524919672</c:v>
                </c:pt>
                <c:pt idx="17">
                  <c:v>0.65486575648469769</c:v>
                </c:pt>
                <c:pt idx="18">
                  <c:v>3.2308477549207057</c:v>
                </c:pt>
                <c:pt idx="19">
                  <c:v>1.05721034033891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D5B-44EE-8705-8393DFCA3E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975600"/>
        <c:axId val="360977168"/>
      </c:barChart>
      <c:catAx>
        <c:axId val="360975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7168"/>
        <c:crosses val="autoZero"/>
        <c:auto val="1"/>
        <c:lblAlgn val="ctr"/>
        <c:lblOffset val="100"/>
        <c:noMultiLvlLbl val="0"/>
      </c:catAx>
      <c:valAx>
        <c:axId val="3609771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56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60-4BCF-8DCA-6EC8762BF147}"/>
            </c:ext>
          </c:extLst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16:$X$116</c:f>
                <c:numCache>
                  <c:formatCode>General</c:formatCode>
                  <c:ptCount val="20"/>
                  <c:pt idx="0">
                    <c:v>5.026109151959543E-2</c:v>
                  </c:pt>
                  <c:pt idx="1">
                    <c:v>2.0148777378437083E-2</c:v>
                  </c:pt>
                  <c:pt idx="2">
                    <c:v>0.34229672139827155</c:v>
                  </c:pt>
                  <c:pt idx="3">
                    <c:v>3.9490443322398525E-2</c:v>
                  </c:pt>
                  <c:pt idx="4">
                    <c:v>9.6769735299667078E-2</c:v>
                  </c:pt>
                  <c:pt idx="5">
                    <c:v>7.8863220061550179E-2</c:v>
                  </c:pt>
                  <c:pt idx="6">
                    <c:v>0.1744617060574094</c:v>
                  </c:pt>
                  <c:pt idx="7">
                    <c:v>9.4359336307777777E-2</c:v>
                  </c:pt>
                  <c:pt idx="8">
                    <c:v>2.5867319120195215E-2</c:v>
                  </c:pt>
                  <c:pt idx="9">
                    <c:v>7.9610802681173667E-2</c:v>
                  </c:pt>
                  <c:pt idx="10">
                    <c:v>2.1621926203860876E-2</c:v>
                  </c:pt>
                  <c:pt idx="11">
                    <c:v>3.2817691470349394E-2</c:v>
                  </c:pt>
                  <c:pt idx="12">
                    <c:v>5.6085015561644594E-2</c:v>
                  </c:pt>
                  <c:pt idx="13">
                    <c:v>1.511462424065149E-2</c:v>
                  </c:pt>
                  <c:pt idx="14">
                    <c:v>1.9787731775283916E-2</c:v>
                  </c:pt>
                  <c:pt idx="15">
                    <c:v>7.5116122217805045E-2</c:v>
                  </c:pt>
                  <c:pt idx="16">
                    <c:v>0.23677648798219417</c:v>
                  </c:pt>
                  <c:pt idx="17">
                    <c:v>4.0212681561392467E-2</c:v>
                  </c:pt>
                  <c:pt idx="18">
                    <c:v>0.22519423021667853</c:v>
                  </c:pt>
                  <c:pt idx="19">
                    <c:v>9.3765203303044928E-2</c:v>
                  </c:pt>
                </c:numCache>
              </c:numRef>
            </c:plus>
            <c:minus>
              <c:numRef>
                <c:f>Sheet1!$E$116:$X$116</c:f>
                <c:numCache>
                  <c:formatCode>General</c:formatCode>
                  <c:ptCount val="20"/>
                  <c:pt idx="0">
                    <c:v>5.026109151959543E-2</c:v>
                  </c:pt>
                  <c:pt idx="1">
                    <c:v>2.0148777378437083E-2</c:v>
                  </c:pt>
                  <c:pt idx="2">
                    <c:v>0.34229672139827155</c:v>
                  </c:pt>
                  <c:pt idx="3">
                    <c:v>3.9490443322398525E-2</c:v>
                  </c:pt>
                  <c:pt idx="4">
                    <c:v>9.6769735299667078E-2</c:v>
                  </c:pt>
                  <c:pt idx="5">
                    <c:v>7.8863220061550179E-2</c:v>
                  </c:pt>
                  <c:pt idx="6">
                    <c:v>0.1744617060574094</c:v>
                  </c:pt>
                  <c:pt idx="7">
                    <c:v>9.4359336307777777E-2</c:v>
                  </c:pt>
                  <c:pt idx="8">
                    <c:v>2.5867319120195215E-2</c:v>
                  </c:pt>
                  <c:pt idx="9">
                    <c:v>7.9610802681173667E-2</c:v>
                  </c:pt>
                  <c:pt idx="10">
                    <c:v>2.1621926203860876E-2</c:v>
                  </c:pt>
                  <c:pt idx="11">
                    <c:v>3.2817691470349394E-2</c:v>
                  </c:pt>
                  <c:pt idx="12">
                    <c:v>5.6085015561644594E-2</c:v>
                  </c:pt>
                  <c:pt idx="13">
                    <c:v>1.511462424065149E-2</c:v>
                  </c:pt>
                  <c:pt idx="14">
                    <c:v>1.9787731775283916E-2</c:v>
                  </c:pt>
                  <c:pt idx="15">
                    <c:v>7.5116122217805045E-2</c:v>
                  </c:pt>
                  <c:pt idx="16">
                    <c:v>0.23677648798219417</c:v>
                  </c:pt>
                  <c:pt idx="17">
                    <c:v>4.0212681561392467E-2</c:v>
                  </c:pt>
                  <c:pt idx="18">
                    <c:v>0.22519423021667853</c:v>
                  </c:pt>
                  <c:pt idx="19">
                    <c:v>9.376520330304492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115:$X$115</c:f>
              <c:numCache>
                <c:formatCode>General</c:formatCode>
                <c:ptCount val="20"/>
                <c:pt idx="0">
                  <c:v>0.52114747189325095</c:v>
                </c:pt>
                <c:pt idx="1">
                  <c:v>0.36366160475036519</c:v>
                </c:pt>
                <c:pt idx="2">
                  <c:v>4.5568770735688355</c:v>
                </c:pt>
                <c:pt idx="3">
                  <c:v>0.48436721903114366</c:v>
                </c:pt>
                <c:pt idx="4">
                  <c:v>1.1113675236524569</c:v>
                </c:pt>
                <c:pt idx="5">
                  <c:v>0.87798992184422098</c:v>
                </c:pt>
                <c:pt idx="6">
                  <c:v>2.4802051735427799</c:v>
                </c:pt>
                <c:pt idx="7">
                  <c:v>0.62537120029232751</c:v>
                </c:pt>
                <c:pt idx="8">
                  <c:v>0.3760484906878605</c:v>
                </c:pt>
                <c:pt idx="9">
                  <c:v>3.3773026612110661</c:v>
                </c:pt>
                <c:pt idx="10">
                  <c:v>0.6036243340108699</c:v>
                </c:pt>
                <c:pt idx="11">
                  <c:v>0.65144831191232944</c:v>
                </c:pt>
                <c:pt idx="12">
                  <c:v>0.9212826185700127</c:v>
                </c:pt>
                <c:pt idx="13">
                  <c:v>0.42623607713732464</c:v>
                </c:pt>
                <c:pt idx="14">
                  <c:v>1.0483890287004349</c:v>
                </c:pt>
                <c:pt idx="15">
                  <c:v>6.0525347737528721</c:v>
                </c:pt>
                <c:pt idx="16">
                  <c:v>2.5471489915462504</c:v>
                </c:pt>
                <c:pt idx="17">
                  <c:v>0.429343705730245</c:v>
                </c:pt>
                <c:pt idx="18">
                  <c:v>4.1616522068667825</c:v>
                </c:pt>
                <c:pt idx="19">
                  <c:v>0.806425999745233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F60-4BCF-8DCA-6EC8762BF1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977952"/>
        <c:axId val="360972856"/>
      </c:barChart>
      <c:catAx>
        <c:axId val="360977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2856"/>
        <c:crosses val="autoZero"/>
        <c:auto val="1"/>
        <c:lblAlgn val="ctr"/>
        <c:lblOffset val="100"/>
        <c:noMultiLvlLbl val="0"/>
      </c:catAx>
      <c:valAx>
        <c:axId val="3609728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79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DB-44C5-AC97-9C53ADC239B9}"/>
            </c:ext>
          </c:extLst>
        </c:ser>
        <c:ser>
          <c:idx val="1"/>
          <c:order val="1"/>
          <c:tx>
            <c:v>ΔTyr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90:$X$90</c:f>
                <c:numCache>
                  <c:formatCode>General</c:formatCode>
                  <c:ptCount val="20"/>
                  <c:pt idx="0">
                    <c:v>7.5762798136020632E-2</c:v>
                  </c:pt>
                  <c:pt idx="1">
                    <c:v>1.6649219105483427E-2</c:v>
                  </c:pt>
                  <c:pt idx="2">
                    <c:v>0.23759361267722018</c:v>
                  </c:pt>
                  <c:pt idx="3">
                    <c:v>2.9059564285001848E-2</c:v>
                  </c:pt>
                  <c:pt idx="4">
                    <c:v>0.14873559363111649</c:v>
                  </c:pt>
                  <c:pt idx="5">
                    <c:v>0.10320319274668399</c:v>
                  </c:pt>
                  <c:pt idx="6">
                    <c:v>3.1046730301668452E-2</c:v>
                  </c:pt>
                  <c:pt idx="7">
                    <c:v>0.25249910064476261</c:v>
                  </c:pt>
                  <c:pt idx="8">
                    <c:v>1.5877402224070074E-2</c:v>
                  </c:pt>
                  <c:pt idx="9">
                    <c:v>0.16838050324132448</c:v>
                  </c:pt>
                  <c:pt idx="10">
                    <c:v>3.965546305536069E-2</c:v>
                  </c:pt>
                  <c:pt idx="11">
                    <c:v>7.4282852115999222E-3</c:v>
                  </c:pt>
                  <c:pt idx="12">
                    <c:v>2.3283083150969521E-2</c:v>
                  </c:pt>
                  <c:pt idx="13">
                    <c:v>3.0046277576707584E-2</c:v>
                  </c:pt>
                  <c:pt idx="14">
                    <c:v>4.5846290072959608E-2</c:v>
                  </c:pt>
                  <c:pt idx="15">
                    <c:v>0.54206249444510757</c:v>
                  </c:pt>
                  <c:pt idx="16">
                    <c:v>0.35393759851536971</c:v>
                  </c:pt>
                  <c:pt idx="17">
                    <c:v>0.12695791066833115</c:v>
                  </c:pt>
                  <c:pt idx="18">
                    <c:v>0.24413144428935754</c:v>
                  </c:pt>
                  <c:pt idx="19">
                    <c:v>0.1175825109816542</c:v>
                  </c:pt>
                </c:numCache>
              </c:numRef>
            </c:plus>
            <c:minus>
              <c:numRef>
                <c:f>Sheet1!$E$90:$X$90</c:f>
                <c:numCache>
                  <c:formatCode>General</c:formatCode>
                  <c:ptCount val="20"/>
                  <c:pt idx="0">
                    <c:v>7.5762798136020632E-2</c:v>
                  </c:pt>
                  <c:pt idx="1">
                    <c:v>1.6649219105483427E-2</c:v>
                  </c:pt>
                  <c:pt idx="2">
                    <c:v>0.23759361267722018</c:v>
                  </c:pt>
                  <c:pt idx="3">
                    <c:v>2.9059564285001848E-2</c:v>
                  </c:pt>
                  <c:pt idx="4">
                    <c:v>0.14873559363111649</c:v>
                  </c:pt>
                  <c:pt idx="5">
                    <c:v>0.10320319274668399</c:v>
                  </c:pt>
                  <c:pt idx="6">
                    <c:v>3.1046730301668452E-2</c:v>
                  </c:pt>
                  <c:pt idx="7">
                    <c:v>0.25249910064476261</c:v>
                  </c:pt>
                  <c:pt idx="8">
                    <c:v>1.5877402224070074E-2</c:v>
                  </c:pt>
                  <c:pt idx="9">
                    <c:v>0.16838050324132448</c:v>
                  </c:pt>
                  <c:pt idx="10">
                    <c:v>3.965546305536069E-2</c:v>
                  </c:pt>
                  <c:pt idx="11">
                    <c:v>7.4282852115999222E-3</c:v>
                  </c:pt>
                  <c:pt idx="12">
                    <c:v>2.3283083150969521E-2</c:v>
                  </c:pt>
                  <c:pt idx="13">
                    <c:v>3.0046277576707584E-2</c:v>
                  </c:pt>
                  <c:pt idx="14">
                    <c:v>4.5846290072959608E-2</c:v>
                  </c:pt>
                  <c:pt idx="15">
                    <c:v>0.54206249444510757</c:v>
                  </c:pt>
                  <c:pt idx="16">
                    <c:v>0.35393759851536971</c:v>
                  </c:pt>
                  <c:pt idx="17">
                    <c:v>0.12695791066833115</c:v>
                  </c:pt>
                  <c:pt idx="18">
                    <c:v>0.24413144428935754</c:v>
                  </c:pt>
                  <c:pt idx="19">
                    <c:v>0.11758251098165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89:$X$89</c:f>
              <c:numCache>
                <c:formatCode>General</c:formatCode>
                <c:ptCount val="20"/>
                <c:pt idx="0">
                  <c:v>0.56712341357365725</c:v>
                </c:pt>
                <c:pt idx="1">
                  <c:v>0.36971403269472303</c:v>
                </c:pt>
                <c:pt idx="2">
                  <c:v>5.7139839965195423</c:v>
                </c:pt>
                <c:pt idx="3">
                  <c:v>0.5984314155471786</c:v>
                </c:pt>
                <c:pt idx="4">
                  <c:v>1.3507740373101729</c:v>
                </c:pt>
                <c:pt idx="5">
                  <c:v>0.93589366696089815</c:v>
                </c:pt>
                <c:pt idx="6">
                  <c:v>2.496401802172985</c:v>
                </c:pt>
                <c:pt idx="7">
                  <c:v>0.98445573602162029</c:v>
                </c:pt>
                <c:pt idx="8">
                  <c:v>0.42836476302212051</c:v>
                </c:pt>
                <c:pt idx="9">
                  <c:v>3.5081407140477814</c:v>
                </c:pt>
                <c:pt idx="10">
                  <c:v>0.71330596715944117</c:v>
                </c:pt>
                <c:pt idx="11">
                  <c:v>0.70051147764808641</c:v>
                </c:pt>
                <c:pt idx="12">
                  <c:v>1.0929287261732974</c:v>
                </c:pt>
                <c:pt idx="13">
                  <c:v>0.45156239060730413</c:v>
                </c:pt>
                <c:pt idx="14">
                  <c:v>1.0744408942602448</c:v>
                </c:pt>
                <c:pt idx="15">
                  <c:v>7.4071840701935576</c:v>
                </c:pt>
                <c:pt idx="16">
                  <c:v>2.4021451008577674</c:v>
                </c:pt>
                <c:pt idx="17">
                  <c:v>0.63931281942435481</c:v>
                </c:pt>
                <c:pt idx="18">
                  <c:v>4.7079338544060354</c:v>
                </c:pt>
                <c:pt idx="19">
                  <c:v>0.651837223767897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6DB-44C5-AC97-9C53ADC239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978736"/>
        <c:axId val="360972464"/>
      </c:barChart>
      <c:catAx>
        <c:axId val="360978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2464"/>
        <c:crosses val="autoZero"/>
        <c:auto val="1"/>
        <c:lblAlgn val="ctr"/>
        <c:lblOffset val="100"/>
        <c:noMultiLvlLbl val="0"/>
      </c:catAx>
      <c:valAx>
        <c:axId val="3609724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87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D7-4E61-81E2-824E64D9552D}"/>
            </c:ext>
          </c:extLst>
        </c:ser>
        <c:ser>
          <c:idx val="1"/>
          <c:order val="1"/>
          <c:tx>
            <c:v>5AA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6:$X$76</c:f>
                <c:numCache>
                  <c:formatCode>General</c:formatCode>
                  <c:ptCount val="20"/>
                  <c:pt idx="0">
                    <c:v>6.4565550739482128E-2</c:v>
                  </c:pt>
                  <c:pt idx="1">
                    <c:v>3.1111131337078213E-2</c:v>
                  </c:pt>
                  <c:pt idx="2">
                    <c:v>0.27957663780785114</c:v>
                  </c:pt>
                  <c:pt idx="3">
                    <c:v>2.4229755399623652E-2</c:v>
                  </c:pt>
                  <c:pt idx="4">
                    <c:v>7.7883198265403561E-2</c:v>
                  </c:pt>
                  <c:pt idx="5">
                    <c:v>0.10756861347763454</c:v>
                  </c:pt>
                  <c:pt idx="6">
                    <c:v>0.21804105796183484</c:v>
                  </c:pt>
                  <c:pt idx="7">
                    <c:v>6.351277623936899E-2</c:v>
                  </c:pt>
                  <c:pt idx="8">
                    <c:v>1.5926755775387821E-2</c:v>
                  </c:pt>
                  <c:pt idx="9">
                    <c:v>0.37728561641329861</c:v>
                  </c:pt>
                  <c:pt idx="10">
                    <c:v>0.11233644719388723</c:v>
                  </c:pt>
                  <c:pt idx="11">
                    <c:v>3.8894968656147527E-2</c:v>
                  </c:pt>
                  <c:pt idx="12">
                    <c:v>0.10743461786007368</c:v>
                  </c:pt>
                  <c:pt idx="13">
                    <c:v>5.7351069496516964E-2</c:v>
                  </c:pt>
                  <c:pt idx="14">
                    <c:v>7.3505097251342813E-2</c:v>
                  </c:pt>
                  <c:pt idx="15">
                    <c:v>0.49507191420101665</c:v>
                  </c:pt>
                  <c:pt idx="16">
                    <c:v>0.46211127298024651</c:v>
                  </c:pt>
                  <c:pt idx="17">
                    <c:v>4.2258660631435685E-2</c:v>
                  </c:pt>
                  <c:pt idx="18">
                    <c:v>0.61865268309269494</c:v>
                  </c:pt>
                  <c:pt idx="19">
                    <c:v>5.5521214523947558E-2</c:v>
                  </c:pt>
                </c:numCache>
              </c:numRef>
            </c:plus>
            <c:minus>
              <c:numRef>
                <c:f>Sheet1!$E$76:$X$76</c:f>
                <c:numCache>
                  <c:formatCode>General</c:formatCode>
                  <c:ptCount val="20"/>
                  <c:pt idx="0">
                    <c:v>6.4565550739482128E-2</c:v>
                  </c:pt>
                  <c:pt idx="1">
                    <c:v>3.1111131337078213E-2</c:v>
                  </c:pt>
                  <c:pt idx="2">
                    <c:v>0.27957663780785114</c:v>
                  </c:pt>
                  <c:pt idx="3">
                    <c:v>2.4229755399623652E-2</c:v>
                  </c:pt>
                  <c:pt idx="4">
                    <c:v>7.7883198265403561E-2</c:v>
                  </c:pt>
                  <c:pt idx="5">
                    <c:v>0.10756861347763454</c:v>
                  </c:pt>
                  <c:pt idx="6">
                    <c:v>0.21804105796183484</c:v>
                  </c:pt>
                  <c:pt idx="7">
                    <c:v>6.351277623936899E-2</c:v>
                  </c:pt>
                  <c:pt idx="8">
                    <c:v>1.5926755775387821E-2</c:v>
                  </c:pt>
                  <c:pt idx="9">
                    <c:v>0.37728561641329861</c:v>
                  </c:pt>
                  <c:pt idx="10">
                    <c:v>0.11233644719388723</c:v>
                  </c:pt>
                  <c:pt idx="11">
                    <c:v>3.8894968656147527E-2</c:v>
                  </c:pt>
                  <c:pt idx="12">
                    <c:v>0.10743461786007368</c:v>
                  </c:pt>
                  <c:pt idx="13">
                    <c:v>5.7351069496516964E-2</c:v>
                  </c:pt>
                  <c:pt idx="14">
                    <c:v>7.3505097251342813E-2</c:v>
                  </c:pt>
                  <c:pt idx="15">
                    <c:v>0.49507191420101665</c:v>
                  </c:pt>
                  <c:pt idx="16">
                    <c:v>0.46211127298024651</c:v>
                  </c:pt>
                  <c:pt idx="17">
                    <c:v>4.2258660631435685E-2</c:v>
                  </c:pt>
                  <c:pt idx="18">
                    <c:v>0.61865268309269494</c:v>
                  </c:pt>
                  <c:pt idx="19">
                    <c:v>5.552121452394755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75:$X$75</c:f>
              <c:numCache>
                <c:formatCode>General</c:formatCode>
                <c:ptCount val="20"/>
                <c:pt idx="0">
                  <c:v>0.53836106710595566</c:v>
                </c:pt>
                <c:pt idx="1">
                  <c:v>0.43596664192063411</c:v>
                </c:pt>
                <c:pt idx="2">
                  <c:v>1.6429310570833708</c:v>
                </c:pt>
                <c:pt idx="3">
                  <c:v>0.56684193715499565</c:v>
                </c:pt>
                <c:pt idx="4">
                  <c:v>1.1709168792279154</c:v>
                </c:pt>
                <c:pt idx="5">
                  <c:v>0.90134022035449635</c:v>
                </c:pt>
                <c:pt idx="6">
                  <c:v>1.8647118460693746</c:v>
                </c:pt>
                <c:pt idx="7">
                  <c:v>0.57567249386175934</c:v>
                </c:pt>
                <c:pt idx="8">
                  <c:v>0.53416018933204257</c:v>
                </c:pt>
                <c:pt idx="9">
                  <c:v>4.2891306687768243</c:v>
                </c:pt>
                <c:pt idx="10">
                  <c:v>0.57662141646382015</c:v>
                </c:pt>
                <c:pt idx="11">
                  <c:v>0.97712788240039083</c:v>
                </c:pt>
                <c:pt idx="12">
                  <c:v>1.108505252294075</c:v>
                </c:pt>
                <c:pt idx="13">
                  <c:v>0.39796496706613649</c:v>
                </c:pt>
                <c:pt idx="14">
                  <c:v>1.3716253743092706</c:v>
                </c:pt>
                <c:pt idx="15">
                  <c:v>7.059221144697176</c:v>
                </c:pt>
                <c:pt idx="16">
                  <c:v>4.2869786727425927</c:v>
                </c:pt>
                <c:pt idx="17">
                  <c:v>0.5846844644744672</c:v>
                </c:pt>
                <c:pt idx="18">
                  <c:v>11.233445396249541</c:v>
                </c:pt>
                <c:pt idx="19">
                  <c:v>0.577563858108906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4D7-4E61-81E2-824E64D955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0974032"/>
        <c:axId val="360974816"/>
      </c:barChart>
      <c:catAx>
        <c:axId val="360974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4816"/>
        <c:crosses val="autoZero"/>
        <c:auto val="1"/>
        <c:lblAlgn val="ctr"/>
        <c:lblOffset val="100"/>
        <c:noMultiLvlLbl val="0"/>
      </c:catAx>
      <c:valAx>
        <c:axId val="360974816"/>
        <c:scaling>
          <c:orientation val="minMax"/>
          <c:max val="1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0974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9A55-4D7B-A6ED-655D2231CDF8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9A55-4D7B-A6ED-655D2231CDF8}"/>
              </c:ext>
            </c:extLst>
          </c:dPt>
          <c:errBars>
            <c:errBarType val="both"/>
            <c:errValType val="cust"/>
            <c:noEndCap val="0"/>
            <c:plus>
              <c:numRef>
                <c:f>total!$C$24:$D$24</c:f>
                <c:numCache>
                  <c:formatCode>General</c:formatCode>
                  <c:ptCount val="2"/>
                  <c:pt idx="0">
                    <c:v>0.48548676507357935</c:v>
                  </c:pt>
                  <c:pt idx="1">
                    <c:v>4.6779346701070007E-2</c:v>
                  </c:pt>
                </c:numCache>
              </c:numRef>
            </c:plus>
            <c:minus>
              <c:numRef>
                <c:f>total!$C$24:$D$24</c:f>
                <c:numCache>
                  <c:formatCode>General</c:formatCode>
                  <c:ptCount val="2"/>
                  <c:pt idx="0">
                    <c:v>0.48548676507357935</c:v>
                  </c:pt>
                  <c:pt idx="1">
                    <c:v>4.6779346701070007E-2</c:v>
                  </c:pt>
                </c:numCache>
              </c:numRef>
            </c:minus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total!$C$17:$D$17</c:f>
              <c:strCache>
                <c:ptCount val="2"/>
                <c:pt idx="0">
                  <c:v>Full</c:v>
                </c:pt>
                <c:pt idx="1">
                  <c:v>Zero</c:v>
                </c:pt>
              </c:strCache>
            </c:strRef>
          </c:cat>
          <c:val>
            <c:numRef>
              <c:f>total!$C$23:$D$23</c:f>
              <c:numCache>
                <c:formatCode>General</c:formatCode>
                <c:ptCount val="2"/>
                <c:pt idx="0">
                  <c:v>1</c:v>
                </c:pt>
                <c:pt idx="1">
                  <c:v>0.142251073001162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A55-4D7B-A6ED-655D2231CD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5"/>
        <c:overlap val="-27"/>
        <c:axId val="360975992"/>
        <c:axId val="361421408"/>
      </c:barChart>
      <c:catAx>
        <c:axId val="360975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lang="ja-JP" sz="1100"/>
            </a:pPr>
            <a:endParaRPr lang="en-US"/>
          </a:p>
        </c:txPr>
        <c:crossAx val="361421408"/>
        <c:crosses val="autoZero"/>
        <c:auto val="1"/>
        <c:lblAlgn val="ctr"/>
        <c:lblOffset val="100"/>
        <c:noMultiLvlLbl val="0"/>
      </c:catAx>
      <c:valAx>
        <c:axId val="36142140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8575">
            <a:solidFill>
              <a:schemeClr val="tx1"/>
            </a:solidFill>
          </a:ln>
        </c:spPr>
        <c:txPr>
          <a:bodyPr rot="-60000000" vert="horz"/>
          <a:lstStyle/>
          <a:p>
            <a:pPr>
              <a:defRPr lang="ja-JP"/>
            </a:pPr>
            <a:endParaRPr lang="en-US"/>
          </a:p>
        </c:txPr>
        <c:crossAx val="3609759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900" b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65A-492F-B5B8-5018D12AB9A9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65A-492F-B5B8-5018D12AB9A9}"/>
              </c:ext>
            </c:extLst>
          </c:dPt>
          <c:errBars>
            <c:errBarType val="both"/>
            <c:errValType val="cust"/>
            <c:noEndCap val="0"/>
            <c:plus>
              <c:numRef>
                <c:f>'181123'!$X$12:$Y$12</c:f>
                <c:numCache>
                  <c:formatCode>General</c:formatCode>
                  <c:ptCount val="2"/>
                  <c:pt idx="0">
                    <c:v>6.082342815115007E-2</c:v>
                  </c:pt>
                  <c:pt idx="1">
                    <c:v>3.6777316306329425E-2</c:v>
                  </c:pt>
                </c:numCache>
              </c:numRef>
            </c:plus>
            <c:minus>
              <c:numRef>
                <c:f>'181123'!$X$12:$Y$12</c:f>
                <c:numCache>
                  <c:formatCode>General</c:formatCode>
                  <c:ptCount val="2"/>
                  <c:pt idx="0">
                    <c:v>6.082342815115007E-2</c:v>
                  </c:pt>
                  <c:pt idx="1">
                    <c:v>3.6777316306329425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181123'!$U$11:$V$11</c:f>
              <c:strCache>
                <c:ptCount val="2"/>
                <c:pt idx="0">
                  <c:v>Full</c:v>
                </c:pt>
                <c:pt idx="1">
                  <c:v>Zero</c:v>
                </c:pt>
              </c:strCache>
            </c:strRef>
          </c:cat>
          <c:val>
            <c:numRef>
              <c:f>'181123'!$U$12:$V$12</c:f>
              <c:numCache>
                <c:formatCode>General</c:formatCode>
                <c:ptCount val="2"/>
                <c:pt idx="0">
                  <c:v>1</c:v>
                </c:pt>
                <c:pt idx="1">
                  <c:v>0.41074212451015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65A-492F-B5B8-5018D12AB9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5"/>
        <c:overlap val="-27"/>
        <c:axId val="361421800"/>
        <c:axId val="361418664"/>
      </c:barChart>
      <c:catAx>
        <c:axId val="361421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1418664"/>
        <c:crosses val="autoZero"/>
        <c:auto val="1"/>
        <c:lblAlgn val="ctr"/>
        <c:lblOffset val="100"/>
        <c:noMultiLvlLbl val="0"/>
      </c:catAx>
      <c:valAx>
        <c:axId val="3614186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1421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 b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11A-417D-847F-4F913F22D12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11A-417D-847F-4F913F22D127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 w="19050">
                <a:solidFill>
                  <a:schemeClr val="bg1">
                    <a:lumMod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11A-417D-847F-4F913F22D127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bg1">
                    <a:lumMod val="50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11A-417D-847F-4F913F22D127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O$11:$R$11</c:f>
                <c:numCache>
                  <c:formatCode>General</c:formatCode>
                  <c:ptCount val="4"/>
                  <c:pt idx="0">
                    <c:v>0.51507437990420679</c:v>
                  </c:pt>
                  <c:pt idx="1">
                    <c:v>0.57330853433989171</c:v>
                  </c:pt>
                  <c:pt idx="2">
                    <c:v>0.36793688416314024</c:v>
                  </c:pt>
                  <c:pt idx="3">
                    <c:v>0.714683679006882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multiLvlStrRef>
              <c:f>Sheet1!$O$2:$R$3</c:f>
              <c:multiLvlStrCache>
                <c:ptCount val="4"/>
                <c:lvl>
                  <c:pt idx="0">
                    <c:v>Veh</c:v>
                  </c:pt>
                  <c:pt idx="1">
                    <c:v>IGF-I</c:v>
                  </c:pt>
                  <c:pt idx="2">
                    <c:v>Veh</c:v>
                  </c:pt>
                  <c:pt idx="3">
                    <c:v>IGF-I</c:v>
                  </c:pt>
                </c:lvl>
                <c:lvl>
                  <c:pt idx="0">
                    <c:v>CON</c:v>
                  </c:pt>
                  <c:pt idx="2">
                    <c:v>LP</c:v>
                  </c:pt>
                </c:lvl>
              </c:multiLvlStrCache>
            </c:multiLvlStrRef>
          </c:cat>
          <c:val>
            <c:numRef>
              <c:f>Sheet1!$O$10:$R$10</c:f>
              <c:numCache>
                <c:formatCode>0.0</c:formatCode>
                <c:ptCount val="4"/>
                <c:pt idx="0">
                  <c:v>3.9802467054153725</c:v>
                </c:pt>
                <c:pt idx="1">
                  <c:v>4.2422366921172818</c:v>
                </c:pt>
                <c:pt idx="2">
                  <c:v>4.7595319768369748</c:v>
                </c:pt>
                <c:pt idx="3">
                  <c:v>5.89496954189740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11A-417D-847F-4F913F22D1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607564592"/>
        <c:axId val="607571120"/>
      </c:barChart>
      <c:catAx>
        <c:axId val="607564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571120"/>
        <c:crosses val="autoZero"/>
        <c:auto val="1"/>
        <c:lblAlgn val="ctr"/>
        <c:lblOffset val="100"/>
        <c:noMultiLvlLbl val="0"/>
      </c:catAx>
      <c:valAx>
        <c:axId val="607571120"/>
        <c:scaling>
          <c:orientation val="minMax"/>
          <c:min val="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07564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84-401C-82D2-C1A58A9870BF}"/>
            </c:ext>
          </c:extLst>
        </c:ser>
        <c:ser>
          <c:idx val="1"/>
          <c:order val="1"/>
          <c:tx>
            <c:v>ΔIle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8:$X$78</c:f>
                <c:numCache>
                  <c:formatCode>General</c:formatCode>
                  <c:ptCount val="20"/>
                  <c:pt idx="0">
                    <c:v>0.10273712562431586</c:v>
                  </c:pt>
                  <c:pt idx="1">
                    <c:v>5.7195454216161623E-2</c:v>
                  </c:pt>
                  <c:pt idx="2">
                    <c:v>5.8794407547442008E-2</c:v>
                  </c:pt>
                  <c:pt idx="3">
                    <c:v>5.7029192454533077E-2</c:v>
                  </c:pt>
                  <c:pt idx="4">
                    <c:v>0.16792158397795073</c:v>
                  </c:pt>
                  <c:pt idx="5">
                    <c:v>0.14402459311765822</c:v>
                  </c:pt>
                  <c:pt idx="6">
                    <c:v>6.7621591917092078E-2</c:v>
                  </c:pt>
                  <c:pt idx="7">
                    <c:v>0.31219206717248432</c:v>
                  </c:pt>
                  <c:pt idx="8">
                    <c:v>2.0982942782252677E-2</c:v>
                  </c:pt>
                  <c:pt idx="9">
                    <c:v>0.11434282589021404</c:v>
                  </c:pt>
                  <c:pt idx="10">
                    <c:v>2.9415085243714844E-2</c:v>
                  </c:pt>
                  <c:pt idx="11">
                    <c:v>4.7914775963843357E-3</c:v>
                  </c:pt>
                  <c:pt idx="12">
                    <c:v>3.6364974160217986E-2</c:v>
                  </c:pt>
                  <c:pt idx="13">
                    <c:v>2.1057635634117874E-2</c:v>
                  </c:pt>
                  <c:pt idx="14">
                    <c:v>2.6796469388783294E-2</c:v>
                  </c:pt>
                  <c:pt idx="15">
                    <c:v>0.25734132948823124</c:v>
                  </c:pt>
                  <c:pt idx="16">
                    <c:v>0.29676751477233071</c:v>
                  </c:pt>
                  <c:pt idx="17">
                    <c:v>0.24966516967088551</c:v>
                  </c:pt>
                  <c:pt idx="18">
                    <c:v>0.33248418523197909</c:v>
                  </c:pt>
                  <c:pt idx="19">
                    <c:v>1.070217370073142E-2</c:v>
                  </c:pt>
                </c:numCache>
              </c:numRef>
            </c:plus>
            <c:minus>
              <c:numRef>
                <c:f>Sheet1!$E$78:$X$78</c:f>
                <c:numCache>
                  <c:formatCode>General</c:formatCode>
                  <c:ptCount val="20"/>
                  <c:pt idx="0">
                    <c:v>0.10273712562431586</c:v>
                  </c:pt>
                  <c:pt idx="1">
                    <c:v>5.7195454216161623E-2</c:v>
                  </c:pt>
                  <c:pt idx="2">
                    <c:v>5.8794407547442008E-2</c:v>
                  </c:pt>
                  <c:pt idx="3">
                    <c:v>5.7029192454533077E-2</c:v>
                  </c:pt>
                  <c:pt idx="4">
                    <c:v>0.16792158397795073</c:v>
                  </c:pt>
                  <c:pt idx="5">
                    <c:v>0.14402459311765822</c:v>
                  </c:pt>
                  <c:pt idx="6">
                    <c:v>6.7621591917092078E-2</c:v>
                  </c:pt>
                  <c:pt idx="7">
                    <c:v>0.31219206717248432</c:v>
                  </c:pt>
                  <c:pt idx="8">
                    <c:v>2.0982942782252677E-2</c:v>
                  </c:pt>
                  <c:pt idx="9">
                    <c:v>0.11434282589021404</c:v>
                  </c:pt>
                  <c:pt idx="10">
                    <c:v>2.9415085243714844E-2</c:v>
                  </c:pt>
                  <c:pt idx="11">
                    <c:v>4.7914775963843357E-3</c:v>
                  </c:pt>
                  <c:pt idx="12">
                    <c:v>3.6364974160217986E-2</c:v>
                  </c:pt>
                  <c:pt idx="13">
                    <c:v>2.1057635634117874E-2</c:v>
                  </c:pt>
                  <c:pt idx="14">
                    <c:v>2.6796469388783294E-2</c:v>
                  </c:pt>
                  <c:pt idx="15">
                    <c:v>0.25734132948823124</c:v>
                  </c:pt>
                  <c:pt idx="16">
                    <c:v>0.29676751477233071</c:v>
                  </c:pt>
                  <c:pt idx="17">
                    <c:v>0.24966516967088551</c:v>
                  </c:pt>
                  <c:pt idx="18">
                    <c:v>0.33248418523197909</c:v>
                  </c:pt>
                  <c:pt idx="19">
                    <c:v>1.07021737007314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77:$X$77</c:f>
              <c:numCache>
                <c:formatCode>General</c:formatCode>
                <c:ptCount val="20"/>
                <c:pt idx="0">
                  <c:v>0.22207596532922422</c:v>
                </c:pt>
                <c:pt idx="1">
                  <c:v>0.5134616627371178</c:v>
                </c:pt>
                <c:pt idx="2">
                  <c:v>5.6764640366484924</c:v>
                </c:pt>
                <c:pt idx="3">
                  <c:v>0.95319614876157743</c:v>
                </c:pt>
                <c:pt idx="4">
                  <c:v>1.6926784430359942</c:v>
                </c:pt>
                <c:pt idx="5">
                  <c:v>1.100194912111105</c:v>
                </c:pt>
                <c:pt idx="6">
                  <c:v>2.929408987978896</c:v>
                </c:pt>
                <c:pt idx="7">
                  <c:v>1.3093086308278987</c:v>
                </c:pt>
                <c:pt idx="8">
                  <c:v>0.48209953256535215</c:v>
                </c:pt>
                <c:pt idx="9">
                  <c:v>4.2392154873114665</c:v>
                </c:pt>
                <c:pt idx="10">
                  <c:v>0.76863460519004045</c:v>
                </c:pt>
                <c:pt idx="11">
                  <c:v>0.67848510829083741</c:v>
                </c:pt>
                <c:pt idx="12">
                  <c:v>1.2075264670475101</c:v>
                </c:pt>
                <c:pt idx="13">
                  <c:v>0.31857819965097217</c:v>
                </c:pt>
                <c:pt idx="14">
                  <c:v>0.91728926675489453</c:v>
                </c:pt>
                <c:pt idx="15">
                  <c:v>6.3886191596556792</c:v>
                </c:pt>
                <c:pt idx="16">
                  <c:v>2.4417850503475513</c:v>
                </c:pt>
                <c:pt idx="17">
                  <c:v>1.188208721813937</c:v>
                </c:pt>
                <c:pt idx="18">
                  <c:v>5.8377466220786642</c:v>
                </c:pt>
                <c:pt idx="19">
                  <c:v>1.02577062111021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984-401C-82D2-C1A58A9870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8307224"/>
        <c:axId val="358303304"/>
      </c:barChart>
      <c:catAx>
        <c:axId val="358307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303304"/>
        <c:crosses val="autoZero"/>
        <c:auto val="1"/>
        <c:lblAlgn val="ctr"/>
        <c:lblOffset val="100"/>
        <c:noMultiLvlLbl val="0"/>
      </c:catAx>
      <c:valAx>
        <c:axId val="3583033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307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9DF-469F-91F0-853EA74713BD}"/>
            </c:ext>
          </c:extLst>
        </c:ser>
        <c:ser>
          <c:idx val="1"/>
          <c:order val="1"/>
          <c:tx>
            <c:v>ΔLeu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80:$X$80</c:f>
                <c:numCache>
                  <c:formatCode>General</c:formatCode>
                  <c:ptCount val="20"/>
                  <c:pt idx="0">
                    <c:v>0.39538507335642065</c:v>
                  </c:pt>
                  <c:pt idx="1">
                    <c:v>2.3917718293702688E-2</c:v>
                  </c:pt>
                  <c:pt idx="2">
                    <c:v>1.0593374289489215</c:v>
                  </c:pt>
                  <c:pt idx="3">
                    <c:v>6.7953635413339944E-2</c:v>
                  </c:pt>
                  <c:pt idx="4">
                    <c:v>0.811843382561797</c:v>
                  </c:pt>
                  <c:pt idx="5">
                    <c:v>0.18313409350528814</c:v>
                  </c:pt>
                  <c:pt idx="6">
                    <c:v>0.21245684485709998</c:v>
                  </c:pt>
                  <c:pt idx="7">
                    <c:v>0.28009132521025459</c:v>
                  </c:pt>
                  <c:pt idx="8">
                    <c:v>4.2811130417183943E-2</c:v>
                  </c:pt>
                  <c:pt idx="9">
                    <c:v>0.44602499433522225</c:v>
                  </c:pt>
                  <c:pt idx="10">
                    <c:v>3.3341124337942139E-2</c:v>
                  </c:pt>
                  <c:pt idx="11">
                    <c:v>1.3967944208678347E-2</c:v>
                  </c:pt>
                  <c:pt idx="12">
                    <c:v>5.0806716354332059E-2</c:v>
                  </c:pt>
                  <c:pt idx="13">
                    <c:v>1.433795368528145E-2</c:v>
                  </c:pt>
                  <c:pt idx="14">
                    <c:v>9.8482283845112081E-2</c:v>
                  </c:pt>
                  <c:pt idx="15">
                    <c:v>0.2403155424651732</c:v>
                  </c:pt>
                  <c:pt idx="16">
                    <c:v>0.52156609516461983</c:v>
                  </c:pt>
                  <c:pt idx="17">
                    <c:v>0.222900054647139</c:v>
                  </c:pt>
                  <c:pt idx="18">
                    <c:v>0.16360135706279363</c:v>
                  </c:pt>
                  <c:pt idx="19">
                    <c:v>0.10532350012273345</c:v>
                  </c:pt>
                </c:numCache>
              </c:numRef>
            </c:plus>
            <c:minus>
              <c:numRef>
                <c:f>Sheet1!$E$80:$X$80</c:f>
                <c:numCache>
                  <c:formatCode>General</c:formatCode>
                  <c:ptCount val="20"/>
                  <c:pt idx="0">
                    <c:v>0.39538507335642065</c:v>
                  </c:pt>
                  <c:pt idx="1">
                    <c:v>2.3917718293702688E-2</c:v>
                  </c:pt>
                  <c:pt idx="2">
                    <c:v>1.0593374289489215</c:v>
                  </c:pt>
                  <c:pt idx="3">
                    <c:v>6.7953635413339944E-2</c:v>
                  </c:pt>
                  <c:pt idx="4">
                    <c:v>0.811843382561797</c:v>
                  </c:pt>
                  <c:pt idx="5">
                    <c:v>0.18313409350528814</c:v>
                  </c:pt>
                  <c:pt idx="6">
                    <c:v>0.21245684485709998</c:v>
                  </c:pt>
                  <c:pt idx="7">
                    <c:v>0.28009132521025459</c:v>
                  </c:pt>
                  <c:pt idx="8">
                    <c:v>4.2811130417183943E-2</c:v>
                  </c:pt>
                  <c:pt idx="9">
                    <c:v>0.44602499433522225</c:v>
                  </c:pt>
                  <c:pt idx="10">
                    <c:v>3.3341124337942139E-2</c:v>
                  </c:pt>
                  <c:pt idx="11">
                    <c:v>1.3967944208678347E-2</c:v>
                  </c:pt>
                  <c:pt idx="12">
                    <c:v>5.0806716354332059E-2</c:v>
                  </c:pt>
                  <c:pt idx="13">
                    <c:v>1.433795368528145E-2</c:v>
                  </c:pt>
                  <c:pt idx="14">
                    <c:v>9.8482283845112081E-2</c:v>
                  </c:pt>
                  <c:pt idx="15">
                    <c:v>0.2403155424651732</c:v>
                  </c:pt>
                  <c:pt idx="16">
                    <c:v>0.52156609516461983</c:v>
                  </c:pt>
                  <c:pt idx="17">
                    <c:v>0.222900054647139</c:v>
                  </c:pt>
                  <c:pt idx="18">
                    <c:v>0.16360135706279363</c:v>
                  </c:pt>
                  <c:pt idx="19">
                    <c:v>0.105323500122733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79:$X$79</c:f>
              <c:numCache>
                <c:formatCode>General</c:formatCode>
                <c:ptCount val="20"/>
                <c:pt idx="0">
                  <c:v>1.5932388290025814</c:v>
                </c:pt>
                <c:pt idx="1">
                  <c:v>0.38707091332018484</c:v>
                </c:pt>
                <c:pt idx="2">
                  <c:v>6.8705130086584694</c:v>
                </c:pt>
                <c:pt idx="3">
                  <c:v>0.68512888063732758</c:v>
                </c:pt>
                <c:pt idx="4">
                  <c:v>3.0918199994725355</c:v>
                </c:pt>
                <c:pt idx="5">
                  <c:v>0.40569484981960663</c:v>
                </c:pt>
                <c:pt idx="6">
                  <c:v>2.7547485401787903</c:v>
                </c:pt>
                <c:pt idx="7">
                  <c:v>0.99318921359508439</c:v>
                </c:pt>
                <c:pt idx="8">
                  <c:v>0.46653984665175674</c:v>
                </c:pt>
                <c:pt idx="9">
                  <c:v>4.3067584379350334</c:v>
                </c:pt>
                <c:pt idx="10">
                  <c:v>0.88436410252337705</c:v>
                </c:pt>
                <c:pt idx="11">
                  <c:v>0.69441437882723456</c:v>
                </c:pt>
                <c:pt idx="12">
                  <c:v>1.166836585665264</c:v>
                </c:pt>
                <c:pt idx="13">
                  <c:v>0.35083896164860379</c:v>
                </c:pt>
                <c:pt idx="14">
                  <c:v>1.1545621390306238</c:v>
                </c:pt>
                <c:pt idx="15">
                  <c:v>8.2741369483264737</c:v>
                </c:pt>
                <c:pt idx="16">
                  <c:v>2.6449184755074584</c:v>
                </c:pt>
                <c:pt idx="17">
                  <c:v>0.90332102800096514</c:v>
                </c:pt>
                <c:pt idx="18">
                  <c:v>6.5770671604424278</c:v>
                </c:pt>
                <c:pt idx="19">
                  <c:v>0.930848444825737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9DF-469F-91F0-853EA74713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8304480"/>
        <c:axId val="358807336"/>
      </c:barChart>
      <c:catAx>
        <c:axId val="358304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07336"/>
        <c:crosses val="autoZero"/>
        <c:auto val="1"/>
        <c:lblAlgn val="ctr"/>
        <c:lblOffset val="100"/>
        <c:noMultiLvlLbl val="0"/>
      </c:catAx>
      <c:valAx>
        <c:axId val="358807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304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3B-4A51-B614-B1BD58770338}"/>
            </c:ext>
          </c:extLst>
        </c:ser>
        <c:ser>
          <c:idx val="1"/>
          <c:order val="1"/>
          <c:tx>
            <c:v>ΔLys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82:$X$82</c:f>
                <c:numCache>
                  <c:formatCode>General</c:formatCode>
                  <c:ptCount val="20"/>
                  <c:pt idx="0">
                    <c:v>0.11332232481706793</c:v>
                  </c:pt>
                  <c:pt idx="1">
                    <c:v>6.281760909505707E-2</c:v>
                  </c:pt>
                  <c:pt idx="2">
                    <c:v>0.56357257977524311</c:v>
                  </c:pt>
                  <c:pt idx="3">
                    <c:v>7.1229643369225298E-2</c:v>
                  </c:pt>
                  <c:pt idx="4">
                    <c:v>0.2155005339869937</c:v>
                  </c:pt>
                  <c:pt idx="5">
                    <c:v>0.20086399676719699</c:v>
                  </c:pt>
                  <c:pt idx="6">
                    <c:v>5.5155815589214653E-2</c:v>
                  </c:pt>
                  <c:pt idx="7">
                    <c:v>0.32943421196609968</c:v>
                  </c:pt>
                  <c:pt idx="8">
                    <c:v>2.2415392565781726E-2</c:v>
                  </c:pt>
                  <c:pt idx="9">
                    <c:v>0.12705762366350409</c:v>
                  </c:pt>
                  <c:pt idx="10">
                    <c:v>0.1001343225253154</c:v>
                  </c:pt>
                  <c:pt idx="11">
                    <c:v>6.196228918980172E-2</c:v>
                  </c:pt>
                  <c:pt idx="12">
                    <c:v>7.237174880917592E-2</c:v>
                  </c:pt>
                  <c:pt idx="13">
                    <c:v>2.0521230418915674E-2</c:v>
                  </c:pt>
                  <c:pt idx="14">
                    <c:v>6.6159404316374792E-2</c:v>
                  </c:pt>
                  <c:pt idx="15">
                    <c:v>0.23439781765731021</c:v>
                  </c:pt>
                  <c:pt idx="16">
                    <c:v>0.24278707981724179</c:v>
                  </c:pt>
                  <c:pt idx="17">
                    <c:v>0.20783452641831929</c:v>
                  </c:pt>
                  <c:pt idx="18">
                    <c:v>0.19924919876612729</c:v>
                  </c:pt>
                  <c:pt idx="19">
                    <c:v>5.8186450763151543E-2</c:v>
                  </c:pt>
                </c:numCache>
              </c:numRef>
            </c:plus>
            <c:minus>
              <c:numRef>
                <c:f>Sheet1!$E$82:$X$82</c:f>
                <c:numCache>
                  <c:formatCode>General</c:formatCode>
                  <c:ptCount val="20"/>
                  <c:pt idx="0">
                    <c:v>0.11332232481706793</c:v>
                  </c:pt>
                  <c:pt idx="1">
                    <c:v>6.281760909505707E-2</c:v>
                  </c:pt>
                  <c:pt idx="2">
                    <c:v>0.56357257977524311</c:v>
                  </c:pt>
                  <c:pt idx="3">
                    <c:v>7.1229643369225298E-2</c:v>
                  </c:pt>
                  <c:pt idx="4">
                    <c:v>0.2155005339869937</c:v>
                  </c:pt>
                  <c:pt idx="5">
                    <c:v>0.20086399676719699</c:v>
                  </c:pt>
                  <c:pt idx="6">
                    <c:v>5.5155815589214653E-2</c:v>
                  </c:pt>
                  <c:pt idx="7">
                    <c:v>0.32943421196609968</c:v>
                  </c:pt>
                  <c:pt idx="8">
                    <c:v>2.2415392565781726E-2</c:v>
                  </c:pt>
                  <c:pt idx="9">
                    <c:v>0.12705762366350409</c:v>
                  </c:pt>
                  <c:pt idx="10">
                    <c:v>0.1001343225253154</c:v>
                  </c:pt>
                  <c:pt idx="11">
                    <c:v>6.196228918980172E-2</c:v>
                  </c:pt>
                  <c:pt idx="12">
                    <c:v>7.237174880917592E-2</c:v>
                  </c:pt>
                  <c:pt idx="13">
                    <c:v>2.0521230418915674E-2</c:v>
                  </c:pt>
                  <c:pt idx="14">
                    <c:v>6.6159404316374792E-2</c:v>
                  </c:pt>
                  <c:pt idx="15">
                    <c:v>0.23439781765731021</c:v>
                  </c:pt>
                  <c:pt idx="16">
                    <c:v>0.24278707981724179</c:v>
                  </c:pt>
                  <c:pt idx="17">
                    <c:v>0.20783452641831929</c:v>
                  </c:pt>
                  <c:pt idx="18">
                    <c:v>0.19924919876612729</c:v>
                  </c:pt>
                  <c:pt idx="19">
                    <c:v>5.81864507631515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81:$X$81</c:f>
              <c:numCache>
                <c:formatCode>General</c:formatCode>
                <c:ptCount val="20"/>
                <c:pt idx="0">
                  <c:v>0.7349754268387757</c:v>
                </c:pt>
                <c:pt idx="1">
                  <c:v>0.40890767502525338</c:v>
                </c:pt>
                <c:pt idx="2">
                  <c:v>5.4294360069061192</c:v>
                </c:pt>
                <c:pt idx="3">
                  <c:v>0.74811730974661839</c:v>
                </c:pt>
                <c:pt idx="4">
                  <c:v>1.7314966027244656</c:v>
                </c:pt>
                <c:pt idx="5">
                  <c:v>1.2028511837510258</c:v>
                </c:pt>
                <c:pt idx="6">
                  <c:v>0.47101581390137798</c:v>
                </c:pt>
                <c:pt idx="7">
                  <c:v>1.1381866833869509</c:v>
                </c:pt>
                <c:pt idx="8">
                  <c:v>0.43756411755624763</c:v>
                </c:pt>
                <c:pt idx="9">
                  <c:v>4.3090790380065105</c:v>
                </c:pt>
                <c:pt idx="10">
                  <c:v>0.65225447949672744</c:v>
                </c:pt>
                <c:pt idx="11">
                  <c:v>0.74039920948789018</c:v>
                </c:pt>
                <c:pt idx="12">
                  <c:v>1.0628192506613896</c:v>
                </c:pt>
                <c:pt idx="13">
                  <c:v>0.33315503138844771</c:v>
                </c:pt>
                <c:pt idx="14">
                  <c:v>1.2169132045226878</c:v>
                </c:pt>
                <c:pt idx="15">
                  <c:v>6.7086710105849905</c:v>
                </c:pt>
                <c:pt idx="16">
                  <c:v>2.3320673521011948</c:v>
                </c:pt>
                <c:pt idx="17">
                  <c:v>1.0675602256022634</c:v>
                </c:pt>
                <c:pt idx="18">
                  <c:v>5.1489101387682261</c:v>
                </c:pt>
                <c:pt idx="19">
                  <c:v>0.930548181147955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F3B-4A51-B614-B1BD587703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8804200"/>
        <c:axId val="358805376"/>
      </c:barChart>
      <c:catAx>
        <c:axId val="358804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05376"/>
        <c:crosses val="autoZero"/>
        <c:auto val="1"/>
        <c:lblAlgn val="ctr"/>
        <c:lblOffset val="100"/>
        <c:noMultiLvlLbl val="0"/>
      </c:catAx>
      <c:valAx>
        <c:axId val="358805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042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CA-4021-BCBB-4583503D612A}"/>
            </c:ext>
          </c:extLst>
        </c:ser>
        <c:ser>
          <c:idx val="1"/>
          <c:order val="1"/>
          <c:tx>
            <c:v>ΔMet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84:$X$84</c:f>
                <c:numCache>
                  <c:formatCode>General</c:formatCode>
                  <c:ptCount val="20"/>
                  <c:pt idx="0">
                    <c:v>8.4679939457073E-2</c:v>
                  </c:pt>
                  <c:pt idx="1">
                    <c:v>4.0241803259719232E-2</c:v>
                  </c:pt>
                  <c:pt idx="2">
                    <c:v>0.38412329914888127</c:v>
                  </c:pt>
                  <c:pt idx="3">
                    <c:v>4.5166757058715583E-2</c:v>
                  </c:pt>
                  <c:pt idx="4">
                    <c:v>0.20407086398043622</c:v>
                  </c:pt>
                  <c:pt idx="5">
                    <c:v>0.19580690183024099</c:v>
                  </c:pt>
                  <c:pt idx="6">
                    <c:v>0.1645328761028913</c:v>
                  </c:pt>
                  <c:pt idx="7">
                    <c:v>5.5707652137859609E-2</c:v>
                  </c:pt>
                  <c:pt idx="8">
                    <c:v>3.2229726272414029E-2</c:v>
                  </c:pt>
                  <c:pt idx="9">
                    <c:v>0.10431455049334783</c:v>
                  </c:pt>
                  <c:pt idx="10">
                    <c:v>8.8951232247681707E-3</c:v>
                  </c:pt>
                  <c:pt idx="11">
                    <c:v>4.147253434469516E-2</c:v>
                  </c:pt>
                  <c:pt idx="12">
                    <c:v>6.072326645364097E-2</c:v>
                  </c:pt>
                  <c:pt idx="13">
                    <c:v>4.5884007928091761E-2</c:v>
                  </c:pt>
                  <c:pt idx="14">
                    <c:v>8.4630777112208386E-2</c:v>
                  </c:pt>
                  <c:pt idx="15">
                    <c:v>0.1827825181803891</c:v>
                  </c:pt>
                  <c:pt idx="16">
                    <c:v>0.24235489476233324</c:v>
                  </c:pt>
                  <c:pt idx="17">
                    <c:v>0.15322383051432131</c:v>
                  </c:pt>
                  <c:pt idx="18">
                    <c:v>0.20346665031281028</c:v>
                  </c:pt>
                  <c:pt idx="19">
                    <c:v>4.5826049485972957E-2</c:v>
                  </c:pt>
                </c:numCache>
              </c:numRef>
            </c:plus>
            <c:minus>
              <c:numRef>
                <c:f>Sheet1!$E$84:$X$84</c:f>
                <c:numCache>
                  <c:formatCode>General</c:formatCode>
                  <c:ptCount val="20"/>
                  <c:pt idx="0">
                    <c:v>8.4679939457073E-2</c:v>
                  </c:pt>
                  <c:pt idx="1">
                    <c:v>4.0241803259719232E-2</c:v>
                  </c:pt>
                  <c:pt idx="2">
                    <c:v>0.38412329914888127</c:v>
                  </c:pt>
                  <c:pt idx="3">
                    <c:v>4.5166757058715583E-2</c:v>
                  </c:pt>
                  <c:pt idx="4">
                    <c:v>0.20407086398043622</c:v>
                  </c:pt>
                  <c:pt idx="5">
                    <c:v>0.19580690183024099</c:v>
                  </c:pt>
                  <c:pt idx="6">
                    <c:v>0.1645328761028913</c:v>
                  </c:pt>
                  <c:pt idx="7">
                    <c:v>5.5707652137859609E-2</c:v>
                  </c:pt>
                  <c:pt idx="8">
                    <c:v>3.2229726272414029E-2</c:v>
                  </c:pt>
                  <c:pt idx="9">
                    <c:v>0.10431455049334783</c:v>
                  </c:pt>
                  <c:pt idx="10">
                    <c:v>8.8951232247681707E-3</c:v>
                  </c:pt>
                  <c:pt idx="11">
                    <c:v>4.147253434469516E-2</c:v>
                  </c:pt>
                  <c:pt idx="12">
                    <c:v>6.072326645364097E-2</c:v>
                  </c:pt>
                  <c:pt idx="13">
                    <c:v>4.5884007928091761E-2</c:v>
                  </c:pt>
                  <c:pt idx="14">
                    <c:v>8.4630777112208386E-2</c:v>
                  </c:pt>
                  <c:pt idx="15">
                    <c:v>0.1827825181803891</c:v>
                  </c:pt>
                  <c:pt idx="16">
                    <c:v>0.24235489476233324</c:v>
                  </c:pt>
                  <c:pt idx="17">
                    <c:v>0.15322383051432131</c:v>
                  </c:pt>
                  <c:pt idx="18">
                    <c:v>0.20346665031281028</c:v>
                  </c:pt>
                  <c:pt idx="19">
                    <c:v>4.582604948597295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83:$X$83</c:f>
              <c:numCache>
                <c:formatCode>General</c:formatCode>
                <c:ptCount val="20"/>
                <c:pt idx="0">
                  <c:v>0.77105051533865732</c:v>
                </c:pt>
                <c:pt idx="1">
                  <c:v>0.35877531377979671</c:v>
                </c:pt>
                <c:pt idx="2">
                  <c:v>6.667150855229572</c:v>
                </c:pt>
                <c:pt idx="3">
                  <c:v>0.58361181639237936</c:v>
                </c:pt>
                <c:pt idx="4">
                  <c:v>1.7871916900794513</c:v>
                </c:pt>
                <c:pt idx="5">
                  <c:v>1.2324133103708539</c:v>
                </c:pt>
                <c:pt idx="6">
                  <c:v>3.083019802351989</c:v>
                </c:pt>
                <c:pt idx="7">
                  <c:v>0.53981983743023854</c:v>
                </c:pt>
                <c:pt idx="8">
                  <c:v>0.4606550884550677</c:v>
                </c:pt>
                <c:pt idx="9">
                  <c:v>3.6615708577925989</c:v>
                </c:pt>
                <c:pt idx="10">
                  <c:v>0.80315097879981867</c:v>
                </c:pt>
                <c:pt idx="11">
                  <c:v>0.62381111635051145</c:v>
                </c:pt>
                <c:pt idx="12">
                  <c:v>0.94548938215528866</c:v>
                </c:pt>
                <c:pt idx="13">
                  <c:v>0.20440013589418771</c:v>
                </c:pt>
                <c:pt idx="14">
                  <c:v>0.96732474597096285</c:v>
                </c:pt>
                <c:pt idx="15">
                  <c:v>6.0330128698060674</c:v>
                </c:pt>
                <c:pt idx="16">
                  <c:v>2.4068568747788333</c:v>
                </c:pt>
                <c:pt idx="17">
                  <c:v>1.1206749540570575</c:v>
                </c:pt>
                <c:pt idx="18">
                  <c:v>7.2419862824069385</c:v>
                </c:pt>
                <c:pt idx="19">
                  <c:v>1.37480518318549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ECA-4021-BCBB-4583503D61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8807728"/>
        <c:axId val="358809688"/>
      </c:barChart>
      <c:catAx>
        <c:axId val="358807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09688"/>
        <c:crosses val="autoZero"/>
        <c:auto val="1"/>
        <c:lblAlgn val="ctr"/>
        <c:lblOffset val="100"/>
        <c:noMultiLvlLbl val="0"/>
      </c:catAx>
      <c:valAx>
        <c:axId val="3588096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07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71-4BCB-8BD6-8765C128FF2E}"/>
            </c:ext>
          </c:extLst>
        </c:ser>
        <c:ser>
          <c:idx val="1"/>
          <c:order val="1"/>
          <c:tx>
            <c:v>ΔPhe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88:$X$88</c:f>
                <c:numCache>
                  <c:formatCode>General</c:formatCode>
                  <c:ptCount val="20"/>
                  <c:pt idx="0">
                    <c:v>0.12237297145313453</c:v>
                  </c:pt>
                  <c:pt idx="1">
                    <c:v>7.8248267369374014E-2</c:v>
                  </c:pt>
                  <c:pt idx="2">
                    <c:v>0.44016718513393466</c:v>
                  </c:pt>
                  <c:pt idx="3">
                    <c:v>7.0042965076772656E-2</c:v>
                  </c:pt>
                  <c:pt idx="4">
                    <c:v>0.31416240870771572</c:v>
                  </c:pt>
                  <c:pt idx="5">
                    <c:v>0.19237756550199328</c:v>
                  </c:pt>
                  <c:pt idx="6">
                    <c:v>0.27110844197337602</c:v>
                  </c:pt>
                  <c:pt idx="7">
                    <c:v>0.37221061891696428</c:v>
                  </c:pt>
                  <c:pt idx="8">
                    <c:v>5.1979148735054263E-2</c:v>
                  </c:pt>
                  <c:pt idx="9">
                    <c:v>0.25191672237147461</c:v>
                  </c:pt>
                  <c:pt idx="10">
                    <c:v>2.8829436477344934E-2</c:v>
                  </c:pt>
                  <c:pt idx="11">
                    <c:v>1.7217331643755194E-2</c:v>
                  </c:pt>
                  <c:pt idx="12">
                    <c:v>0.19779504877632148</c:v>
                  </c:pt>
                  <c:pt idx="13">
                    <c:v>4.3548613933175009E-2</c:v>
                  </c:pt>
                  <c:pt idx="14">
                    <c:v>6.1401024267314329E-2</c:v>
                  </c:pt>
                  <c:pt idx="15">
                    <c:v>0.29804343358742025</c:v>
                  </c:pt>
                  <c:pt idx="16">
                    <c:v>0.40662730046707302</c:v>
                  </c:pt>
                  <c:pt idx="17">
                    <c:v>0.27702439863969947</c:v>
                  </c:pt>
                  <c:pt idx="18">
                    <c:v>0.17966289639124339</c:v>
                  </c:pt>
                  <c:pt idx="19">
                    <c:v>5.0871396975793619E-2</c:v>
                  </c:pt>
                </c:numCache>
              </c:numRef>
            </c:plus>
            <c:minus>
              <c:numRef>
                <c:f>Sheet1!$E$88:$X$88</c:f>
                <c:numCache>
                  <c:formatCode>General</c:formatCode>
                  <c:ptCount val="20"/>
                  <c:pt idx="0">
                    <c:v>0.12237297145313453</c:v>
                  </c:pt>
                  <c:pt idx="1">
                    <c:v>7.8248267369374014E-2</c:v>
                  </c:pt>
                  <c:pt idx="2">
                    <c:v>0.44016718513393466</c:v>
                  </c:pt>
                  <c:pt idx="3">
                    <c:v>7.0042965076772656E-2</c:v>
                  </c:pt>
                  <c:pt idx="4">
                    <c:v>0.31416240870771572</c:v>
                  </c:pt>
                  <c:pt idx="5">
                    <c:v>0.19237756550199328</c:v>
                  </c:pt>
                  <c:pt idx="6">
                    <c:v>0.27110844197337602</c:v>
                  </c:pt>
                  <c:pt idx="7">
                    <c:v>0.37221061891696428</c:v>
                  </c:pt>
                  <c:pt idx="8">
                    <c:v>5.1979148735054263E-2</c:v>
                  </c:pt>
                  <c:pt idx="9">
                    <c:v>0.25191672237147461</c:v>
                  </c:pt>
                  <c:pt idx="10">
                    <c:v>2.8829436477344934E-2</c:v>
                  </c:pt>
                  <c:pt idx="11">
                    <c:v>1.7217331643755194E-2</c:v>
                  </c:pt>
                  <c:pt idx="12">
                    <c:v>0.19779504877632148</c:v>
                  </c:pt>
                  <c:pt idx="13">
                    <c:v>4.3548613933175009E-2</c:v>
                  </c:pt>
                  <c:pt idx="14">
                    <c:v>6.1401024267314329E-2</c:v>
                  </c:pt>
                  <c:pt idx="15">
                    <c:v>0.29804343358742025</c:v>
                  </c:pt>
                  <c:pt idx="16">
                    <c:v>0.40662730046707302</c:v>
                  </c:pt>
                  <c:pt idx="17">
                    <c:v>0.27702439863969947</c:v>
                  </c:pt>
                  <c:pt idx="18">
                    <c:v>0.17966289639124339</c:v>
                  </c:pt>
                  <c:pt idx="19">
                    <c:v>5.087139697579361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87:$X$87</c:f>
              <c:numCache>
                <c:formatCode>General</c:formatCode>
                <c:ptCount val="20"/>
                <c:pt idx="0">
                  <c:v>0.62554655819792193</c:v>
                </c:pt>
                <c:pt idx="1">
                  <c:v>0.18332668891948178</c:v>
                </c:pt>
                <c:pt idx="2">
                  <c:v>5.7839251390389075</c:v>
                </c:pt>
                <c:pt idx="3">
                  <c:v>0.65795441039766922</c:v>
                </c:pt>
                <c:pt idx="4">
                  <c:v>1.5360380901501969</c:v>
                </c:pt>
                <c:pt idx="5">
                  <c:v>0.98741965340651028</c:v>
                </c:pt>
                <c:pt idx="6">
                  <c:v>2.4396472640164055</c:v>
                </c:pt>
                <c:pt idx="7">
                  <c:v>1.1043828166132437</c:v>
                </c:pt>
                <c:pt idx="8">
                  <c:v>0.45734006323628335</c:v>
                </c:pt>
                <c:pt idx="9">
                  <c:v>4.0359501045197748</c:v>
                </c:pt>
                <c:pt idx="10">
                  <c:v>0.74750602005947941</c:v>
                </c:pt>
                <c:pt idx="11">
                  <c:v>0.68945316219360808</c:v>
                </c:pt>
                <c:pt idx="12">
                  <c:v>1.2252987970621967</c:v>
                </c:pt>
                <c:pt idx="13">
                  <c:v>0.38409215489507265</c:v>
                </c:pt>
                <c:pt idx="14">
                  <c:v>0.99728605314874186</c:v>
                </c:pt>
                <c:pt idx="15">
                  <c:v>6.2861052512107962</c:v>
                </c:pt>
                <c:pt idx="16">
                  <c:v>2.3561479333973261</c:v>
                </c:pt>
                <c:pt idx="17">
                  <c:v>0.89647006471906343</c:v>
                </c:pt>
                <c:pt idx="18">
                  <c:v>5.3945531011098637</c:v>
                </c:pt>
                <c:pt idx="19">
                  <c:v>0.620920760874841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71-4BCB-8BD6-8765C128FF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8811256"/>
        <c:axId val="358810080"/>
      </c:barChart>
      <c:catAx>
        <c:axId val="358811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10080"/>
        <c:crosses val="autoZero"/>
        <c:auto val="1"/>
        <c:lblAlgn val="ctr"/>
        <c:lblOffset val="100"/>
        <c:noMultiLvlLbl val="0"/>
      </c:catAx>
      <c:valAx>
        <c:axId val="358810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11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N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plus>
            <c:minus>
              <c:numRef>
                <c:f>Sheet1!$E$74:$X$74</c:f>
                <c:numCache>
                  <c:formatCode>General</c:formatCode>
                  <c:ptCount val="20"/>
                  <c:pt idx="0">
                    <c:v>1.9021882422027878E-2</c:v>
                  </c:pt>
                  <c:pt idx="1">
                    <c:v>1.9478218962518178E-2</c:v>
                  </c:pt>
                  <c:pt idx="2">
                    <c:v>0.38246406975957259</c:v>
                  </c:pt>
                  <c:pt idx="3">
                    <c:v>0.11191435981822957</c:v>
                  </c:pt>
                  <c:pt idx="4">
                    <c:v>9.4892303435812106E-2</c:v>
                  </c:pt>
                  <c:pt idx="5">
                    <c:v>4.483539650943253E-2</c:v>
                  </c:pt>
                  <c:pt idx="6">
                    <c:v>0.11942451125508297</c:v>
                  </c:pt>
                  <c:pt idx="7">
                    <c:v>0.31834068740153632</c:v>
                  </c:pt>
                  <c:pt idx="8">
                    <c:v>2.1245884897198763E-2</c:v>
                  </c:pt>
                  <c:pt idx="9">
                    <c:v>0.25450551353092088</c:v>
                  </c:pt>
                  <c:pt idx="10">
                    <c:v>4.2143280143429024E-2</c:v>
                  </c:pt>
                  <c:pt idx="11">
                    <c:v>2.6014745135807451E-2</c:v>
                  </c:pt>
                  <c:pt idx="12">
                    <c:v>4.9709816149745754E-2</c:v>
                  </c:pt>
                  <c:pt idx="13">
                    <c:v>3.5890246255911556E-2</c:v>
                  </c:pt>
                  <c:pt idx="14">
                    <c:v>0.10101254865338881</c:v>
                  </c:pt>
                  <c:pt idx="15">
                    <c:v>0.27448519643077296</c:v>
                  </c:pt>
                  <c:pt idx="16">
                    <c:v>0.25389767845118899</c:v>
                  </c:pt>
                  <c:pt idx="17">
                    <c:v>0.24837539494797015</c:v>
                  </c:pt>
                  <c:pt idx="18">
                    <c:v>0.10837042721853773</c:v>
                  </c:pt>
                  <c:pt idx="19">
                    <c:v>0.14155121287829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72:$X$72</c:f>
              <c:strCache>
                <c:ptCount val="20"/>
                <c:pt idx="0">
                  <c:v>Ile</c:v>
                </c:pt>
                <c:pt idx="1">
                  <c:v>Phe</c:v>
                </c:pt>
                <c:pt idx="2">
                  <c:v>Thr</c:v>
                </c:pt>
                <c:pt idx="3">
                  <c:v>Trp</c:v>
                </c:pt>
                <c:pt idx="4">
                  <c:v>Val</c:v>
                </c:pt>
                <c:pt idx="5">
                  <c:v>Leu</c:v>
                </c:pt>
                <c:pt idx="6">
                  <c:v>Lys</c:v>
                </c:pt>
                <c:pt idx="7">
                  <c:v>Met</c:v>
                </c:pt>
                <c:pt idx="8">
                  <c:v>His</c:v>
                </c:pt>
                <c:pt idx="9">
                  <c:v>Ala</c:v>
                </c:pt>
                <c:pt idx="10">
                  <c:v>Arg</c:v>
                </c:pt>
                <c:pt idx="11">
                  <c:v>Asp</c:v>
                </c:pt>
                <c:pt idx="12">
                  <c:v>Asn</c:v>
                </c:pt>
                <c:pt idx="13">
                  <c:v>Cys</c:v>
                </c:pt>
                <c:pt idx="14">
                  <c:v>Glu</c:v>
                </c:pt>
                <c:pt idx="15">
                  <c:v>Gln</c:v>
                </c:pt>
                <c:pt idx="16">
                  <c:v>Gly</c:v>
                </c:pt>
                <c:pt idx="17">
                  <c:v>Pro</c:v>
                </c:pt>
                <c:pt idx="18">
                  <c:v>Ser</c:v>
                </c:pt>
                <c:pt idx="19">
                  <c:v>Tyr</c:v>
                </c:pt>
              </c:strCache>
            </c:strRef>
          </c:cat>
          <c:val>
            <c:numRef>
              <c:f>Sheet1!$E$73:$X$73</c:f>
              <c:numCache>
                <c:formatCode>General</c:formatCode>
                <c:ptCount val="20"/>
                <c:pt idx="0">
                  <c:v>0.66299478119835964</c:v>
                </c:pt>
                <c:pt idx="1">
                  <c:v>0.51274246726437811</c:v>
                </c:pt>
                <c:pt idx="2">
                  <c:v>5.7403362547122994</c:v>
                </c:pt>
                <c:pt idx="3">
                  <c:v>0.80580572823650309</c:v>
                </c:pt>
                <c:pt idx="4">
                  <c:v>1.516330666114073</c:v>
                </c:pt>
                <c:pt idx="5">
                  <c:v>1.1274763637164218</c:v>
                </c:pt>
                <c:pt idx="6">
                  <c:v>3.0300543499872048</c:v>
                </c:pt>
                <c:pt idx="7">
                  <c:v>1.0717299640812552</c:v>
                </c:pt>
                <c:pt idx="8">
                  <c:v>0.42909038293339835</c:v>
                </c:pt>
                <c:pt idx="9">
                  <c:v>3.86070659483901</c:v>
                </c:pt>
                <c:pt idx="10">
                  <c:v>0.74572334801993545</c:v>
                </c:pt>
                <c:pt idx="11">
                  <c:v>0.80853837923486072</c:v>
                </c:pt>
                <c:pt idx="12">
                  <c:v>1.208845890511536</c:v>
                </c:pt>
                <c:pt idx="13">
                  <c:v>0.40998024346180045</c:v>
                </c:pt>
                <c:pt idx="14">
                  <c:v>1.3633755770996656</c:v>
                </c:pt>
                <c:pt idx="15">
                  <c:v>7.9374491586874001</c:v>
                </c:pt>
                <c:pt idx="16">
                  <c:v>2.3588125465986791</c:v>
                </c:pt>
                <c:pt idx="17">
                  <c:v>0.95488251236623478</c:v>
                </c:pt>
                <c:pt idx="18">
                  <c:v>4.3891295530422116</c:v>
                </c:pt>
                <c:pt idx="19">
                  <c:v>1.17813321742829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0A-4D2B-8E50-63045CE61BAD}"/>
            </c:ext>
          </c:extLst>
        </c:ser>
        <c:ser>
          <c:idx val="1"/>
          <c:order val="1"/>
          <c:tx>
            <c:v>ΔThr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92:$X$92</c:f>
                <c:numCache>
                  <c:formatCode>General</c:formatCode>
                  <c:ptCount val="20"/>
                  <c:pt idx="0">
                    <c:v>0.1066380476180446</c:v>
                  </c:pt>
                  <c:pt idx="1">
                    <c:v>4.2248733305617556E-2</c:v>
                  </c:pt>
                  <c:pt idx="2">
                    <c:v>4.0396201105749097E-2</c:v>
                  </c:pt>
                  <c:pt idx="3">
                    <c:v>0.10113954887058751</c:v>
                  </c:pt>
                  <c:pt idx="4">
                    <c:v>0.24700080513703135</c:v>
                  </c:pt>
                  <c:pt idx="5">
                    <c:v>0.17090925654594721</c:v>
                  </c:pt>
                  <c:pt idx="6">
                    <c:v>0.32339764606328658</c:v>
                  </c:pt>
                  <c:pt idx="7">
                    <c:v>0.22207257073627254</c:v>
                  </c:pt>
                  <c:pt idx="8">
                    <c:v>4.1525372357856215E-2</c:v>
                  </c:pt>
                  <c:pt idx="9">
                    <c:v>0.52814518481306016</c:v>
                  </c:pt>
                  <c:pt idx="10">
                    <c:v>8.4076838709683993E-2</c:v>
                  </c:pt>
                  <c:pt idx="11">
                    <c:v>4.0265989697315097E-2</c:v>
                  </c:pt>
                  <c:pt idx="12">
                    <c:v>4.0118138708177438E-2</c:v>
                  </c:pt>
                  <c:pt idx="13">
                    <c:v>3.0294207087612199E-2</c:v>
                  </c:pt>
                  <c:pt idx="14">
                    <c:v>0.12916173597912314</c:v>
                  </c:pt>
                  <c:pt idx="15">
                    <c:v>0.83237377843825078</c:v>
                  </c:pt>
                  <c:pt idx="16">
                    <c:v>0.14715685138493764</c:v>
                  </c:pt>
                  <c:pt idx="17">
                    <c:v>0.17781077677643678</c:v>
                  </c:pt>
                  <c:pt idx="18">
                    <c:v>0.45846157588221942</c:v>
                  </c:pt>
                  <c:pt idx="19">
                    <c:v>8.5262644232618298E-2</c:v>
                  </c:pt>
                </c:numCache>
              </c:numRef>
            </c:plus>
            <c:minus>
              <c:numRef>
                <c:f>Sheet1!$E$92:$X$92</c:f>
                <c:numCache>
                  <c:formatCode>General</c:formatCode>
                  <c:ptCount val="20"/>
                  <c:pt idx="0">
                    <c:v>0.1066380476180446</c:v>
                  </c:pt>
                  <c:pt idx="1">
                    <c:v>4.2248733305617556E-2</c:v>
                  </c:pt>
                  <c:pt idx="2">
                    <c:v>4.0396201105749097E-2</c:v>
                  </c:pt>
                  <c:pt idx="3">
                    <c:v>0.10113954887058751</c:v>
                  </c:pt>
                  <c:pt idx="4">
                    <c:v>0.24700080513703135</c:v>
                  </c:pt>
                  <c:pt idx="5">
                    <c:v>0.17090925654594721</c:v>
                  </c:pt>
                  <c:pt idx="6">
                    <c:v>0.32339764606328658</c:v>
                  </c:pt>
                  <c:pt idx="7">
                    <c:v>0.22207257073627254</c:v>
                  </c:pt>
                  <c:pt idx="8">
                    <c:v>4.1525372357856215E-2</c:v>
                  </c:pt>
                  <c:pt idx="9">
                    <c:v>0.52814518481306016</c:v>
                  </c:pt>
                  <c:pt idx="10">
                    <c:v>8.4076838709683993E-2</c:v>
                  </c:pt>
                  <c:pt idx="11">
                    <c:v>4.0265989697315097E-2</c:v>
                  </c:pt>
                  <c:pt idx="12">
                    <c:v>4.0118138708177438E-2</c:v>
                  </c:pt>
                  <c:pt idx="13">
                    <c:v>3.0294207087612199E-2</c:v>
                  </c:pt>
                  <c:pt idx="14">
                    <c:v>0.12916173597912314</c:v>
                  </c:pt>
                  <c:pt idx="15">
                    <c:v>0.83237377843825078</c:v>
                  </c:pt>
                  <c:pt idx="16">
                    <c:v>0.14715685138493764</c:v>
                  </c:pt>
                  <c:pt idx="17">
                    <c:v>0.17781077677643678</c:v>
                  </c:pt>
                  <c:pt idx="18">
                    <c:v>0.45846157588221942</c:v>
                  </c:pt>
                  <c:pt idx="19">
                    <c:v>8.52626442326182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91:$X$91</c:f>
              <c:numCache>
                <c:formatCode>General</c:formatCode>
                <c:ptCount val="20"/>
                <c:pt idx="0">
                  <c:v>0.52667747839586598</c:v>
                </c:pt>
                <c:pt idx="1">
                  <c:v>0.38888092385614675</c:v>
                </c:pt>
                <c:pt idx="2">
                  <c:v>0.5421185622004433</c:v>
                </c:pt>
                <c:pt idx="3">
                  <c:v>0.54446579866203793</c:v>
                </c:pt>
                <c:pt idx="4">
                  <c:v>1.1716918271022168</c:v>
                </c:pt>
                <c:pt idx="5">
                  <c:v>0.84877786810693623</c:v>
                </c:pt>
                <c:pt idx="6">
                  <c:v>3.2238408071742328</c:v>
                </c:pt>
                <c:pt idx="7">
                  <c:v>0.75177875096302127</c:v>
                </c:pt>
                <c:pt idx="8">
                  <c:v>0.41793185411461892</c:v>
                </c:pt>
                <c:pt idx="9">
                  <c:v>4.0495951736294149</c:v>
                </c:pt>
                <c:pt idx="10">
                  <c:v>0.84510973436729231</c:v>
                </c:pt>
                <c:pt idx="11">
                  <c:v>0.7679942932282855</c:v>
                </c:pt>
                <c:pt idx="12">
                  <c:v>0.77032196917906004</c:v>
                </c:pt>
                <c:pt idx="13">
                  <c:v>0.36999357577630637</c:v>
                </c:pt>
                <c:pt idx="14">
                  <c:v>1.0555679784531682</c:v>
                </c:pt>
                <c:pt idx="15">
                  <c:v>6.5387468060131715</c:v>
                </c:pt>
                <c:pt idx="16">
                  <c:v>3.0523697392784821</c:v>
                </c:pt>
                <c:pt idx="17">
                  <c:v>0.82500492507160883</c:v>
                </c:pt>
                <c:pt idx="18">
                  <c:v>6.7932155041731663</c:v>
                </c:pt>
                <c:pt idx="19">
                  <c:v>0.63623490696368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80A-4D2B-8E50-63045CE61B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8806160"/>
        <c:axId val="358810472"/>
      </c:barChart>
      <c:catAx>
        <c:axId val="358806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10472"/>
        <c:crosses val="autoZero"/>
        <c:auto val="1"/>
        <c:lblAlgn val="ctr"/>
        <c:lblOffset val="100"/>
        <c:noMultiLvlLbl val="0"/>
      </c:catAx>
      <c:valAx>
        <c:axId val="3588104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806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8435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988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9929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8493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575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3150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3554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6214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2629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コンテンツ (キャプション付き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215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図 (キャプション付き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036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3E66B-FA75-064F-AE36-532DA46450CF}" type="datetimeFigureOut">
              <a:rPr kumimoji="1" lang="ja-JP" altLang="en-US" smtClean="0"/>
              <a:t>2022/5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237FC-724A-FA41-8725-A650A94540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1702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0.xml"/><Relationship Id="rId3" Type="http://schemas.openxmlformats.org/officeDocument/2006/relationships/chart" Target="../charts/chart5.xml"/><Relationship Id="rId7" Type="http://schemas.openxmlformats.org/officeDocument/2006/relationships/chart" Target="../charts/chart9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10" Type="http://schemas.openxmlformats.org/officeDocument/2006/relationships/chart" Target="../charts/chart12.xml"/><Relationship Id="rId4" Type="http://schemas.openxmlformats.org/officeDocument/2006/relationships/chart" Target="../charts/chart6.xml"/><Relationship Id="rId9" Type="http://schemas.openxmlformats.org/officeDocument/2006/relationships/chart" Target="../charts/chart1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9.xml"/><Relationship Id="rId3" Type="http://schemas.openxmlformats.org/officeDocument/2006/relationships/chart" Target="../charts/chart14.xml"/><Relationship Id="rId7" Type="http://schemas.openxmlformats.org/officeDocument/2006/relationships/chart" Target="../charts/chart18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7.xml"/><Relationship Id="rId11" Type="http://schemas.openxmlformats.org/officeDocument/2006/relationships/chart" Target="../charts/chart22.xml"/><Relationship Id="rId5" Type="http://schemas.openxmlformats.org/officeDocument/2006/relationships/chart" Target="../charts/chart16.xml"/><Relationship Id="rId10" Type="http://schemas.openxmlformats.org/officeDocument/2006/relationships/chart" Target="../charts/chart21.xml"/><Relationship Id="rId4" Type="http://schemas.openxmlformats.org/officeDocument/2006/relationships/chart" Target="../charts/chart15.xml"/><Relationship Id="rId9" Type="http://schemas.openxmlformats.org/officeDocument/2006/relationships/chart" Target="../charts/chart20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4.xml"/><Relationship Id="rId2" Type="http://schemas.openxmlformats.org/officeDocument/2006/relationships/chart" Target="../charts/chart23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5972937-EBDF-4C34-A278-93405751A64F}"/>
              </a:ext>
            </a:extLst>
          </p:cNvPr>
          <p:cNvSpPr txBox="1"/>
          <p:nvPr/>
        </p:nvSpPr>
        <p:spPr>
          <a:xfrm>
            <a:off x="425450" y="4954149"/>
            <a:ext cx="6083300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Igfbp3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mRNA levels of the rat liver, related to Figure 1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ix-week-old male Wistar rats were reared on the control diet containing 15 % amino acid mixture as the sole nitrogen source (CN), low-amino acid diet containing 5 % amino acids (5AA), and diets where only a single amino acid was reduced to the same level as that of the 5AA diet (Δ---) for 7 d.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iver Igfbp3 mRNA levels were measured using real-time qPCR. The values were normalized against 18S rRNA.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[bar graph: means ±</a:t>
            </a:r>
            <a:r>
              <a:rPr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EM, n=3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83779FC-E55B-4559-B963-009EA3A04700}"/>
              </a:ext>
            </a:extLst>
          </p:cNvPr>
          <p:cNvSpPr txBox="1"/>
          <p:nvPr/>
        </p:nvSpPr>
        <p:spPr>
          <a:xfrm>
            <a:off x="532855" y="1356881"/>
            <a:ext cx="6322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1A60FA2E-60BC-4F5A-BD84-F4E83B48C0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5543061"/>
              </p:ext>
            </p:extLst>
          </p:nvPr>
        </p:nvGraphicFramePr>
        <p:xfrm>
          <a:off x="1048418" y="1631833"/>
          <a:ext cx="4959630" cy="23490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E3195BE-C3DB-41AA-97A8-6205A1DA2699}"/>
              </a:ext>
            </a:extLst>
          </p:cNvPr>
          <p:cNvSpPr txBox="1"/>
          <p:nvPr/>
        </p:nvSpPr>
        <p:spPr>
          <a:xfrm rot="16200000">
            <a:off x="176217" y="2440370"/>
            <a:ext cx="15246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Liver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Igfbp3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mRNA</a:t>
            </a:r>
          </a:p>
          <a:p>
            <a:pPr algn="ctr">
              <a:lnSpc>
                <a:spcPts val="1200"/>
              </a:lnSpc>
            </a:pP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[fold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725786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A85EF1C5-7763-4E99-BCFB-E44B7B78FA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1535592"/>
              </p:ext>
            </p:extLst>
          </p:nvPr>
        </p:nvGraphicFramePr>
        <p:xfrm>
          <a:off x="1073148" y="2151062"/>
          <a:ext cx="4711698" cy="5603875"/>
        </p:xfrm>
        <a:graphic>
          <a:graphicData uri="http://schemas.openxmlformats.org/drawingml/2006/table">
            <a:tbl>
              <a:tblPr/>
              <a:tblGrid>
                <a:gridCol w="1253295">
                  <a:extLst>
                    <a:ext uri="{9D8B030D-6E8A-4147-A177-3AD203B41FA5}">
                      <a16:colId xmlns:a16="http://schemas.microsoft.com/office/drawing/2014/main" val="3897157385"/>
                    </a:ext>
                  </a:extLst>
                </a:gridCol>
                <a:gridCol w="576772">
                  <a:extLst>
                    <a:ext uri="{9D8B030D-6E8A-4147-A177-3AD203B41FA5}">
                      <a16:colId xmlns:a16="http://schemas.microsoft.com/office/drawing/2014/main" val="2291760180"/>
                    </a:ext>
                  </a:extLst>
                </a:gridCol>
                <a:gridCol w="576215">
                  <a:extLst>
                    <a:ext uri="{9D8B030D-6E8A-4147-A177-3AD203B41FA5}">
                      <a16:colId xmlns:a16="http://schemas.microsoft.com/office/drawing/2014/main" val="1693240782"/>
                    </a:ext>
                  </a:extLst>
                </a:gridCol>
                <a:gridCol w="576772">
                  <a:extLst>
                    <a:ext uri="{9D8B030D-6E8A-4147-A177-3AD203B41FA5}">
                      <a16:colId xmlns:a16="http://schemas.microsoft.com/office/drawing/2014/main" val="2038024932"/>
                    </a:ext>
                  </a:extLst>
                </a:gridCol>
                <a:gridCol w="576772">
                  <a:extLst>
                    <a:ext uri="{9D8B030D-6E8A-4147-A177-3AD203B41FA5}">
                      <a16:colId xmlns:a16="http://schemas.microsoft.com/office/drawing/2014/main" val="4081424299"/>
                    </a:ext>
                  </a:extLst>
                </a:gridCol>
                <a:gridCol w="576772">
                  <a:extLst>
                    <a:ext uri="{9D8B030D-6E8A-4147-A177-3AD203B41FA5}">
                      <a16:colId xmlns:a16="http://schemas.microsoft.com/office/drawing/2014/main" val="1098853124"/>
                    </a:ext>
                  </a:extLst>
                </a:gridCol>
                <a:gridCol w="575100">
                  <a:extLst>
                    <a:ext uri="{9D8B030D-6E8A-4147-A177-3AD203B41FA5}">
                      <a16:colId xmlns:a16="http://schemas.microsoft.com/office/drawing/2014/main" val="3421925731"/>
                    </a:ext>
                  </a:extLst>
                </a:gridCol>
              </a:tblGrid>
              <a:tr h="224155"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Full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Zero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ΔGly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ΔAla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ΔSer</a:t>
                      </a:r>
                      <a:endParaRPr lang="ja-JP" altLang="ja-JP" sz="11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…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9820279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lycine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0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0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0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866313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Alan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5.6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5.6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5.6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9029325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Ser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2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2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2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4845685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Threon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5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5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5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5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8867440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Cyst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8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8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8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8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9073859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Methion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0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0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0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0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4178317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Glutam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4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4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4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4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7733761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Asparagine</a:t>
                      </a:r>
                      <a:r>
                        <a:rPr lang="ja-JP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・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H</a:t>
                      </a:r>
                      <a:r>
                        <a:rPr lang="ja-JP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₂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O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0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0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0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0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125476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Glutamic acid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.8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.8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.8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8.8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6359333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Aspartic acid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3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3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3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3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6556704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Val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4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4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4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4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5894521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Leuc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5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5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5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5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0966315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Isoleuc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5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5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5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5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2581096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Phenylalan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6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6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6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6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7114824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Tyros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2.4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2.4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2.4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2.4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9632784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Tryptophan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6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6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6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6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2544389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Lysine</a:t>
                      </a:r>
                      <a:r>
                        <a:rPr lang="ja-JP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・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HCl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6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6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6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6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0936405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Arginine</a:t>
                      </a:r>
                      <a:r>
                        <a:rPr lang="ja-JP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・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HCl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4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4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4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4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9637701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Histid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1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1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1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1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2402386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Prol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6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6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6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6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5834433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EBSS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%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%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%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%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%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8132337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vitamin solution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%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%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%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%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%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9843360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NaHCO</a:t>
                      </a:r>
                      <a:r>
                        <a:rPr lang="ja-JP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₃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9113127"/>
                  </a:ext>
                </a:extLst>
              </a:tr>
              <a:tr h="22415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D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glucos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5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5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5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5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5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ja-JP" sz="1050" kern="1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1469981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655E95E-D0BD-406C-B8B1-25C0667F959F}"/>
              </a:ext>
            </a:extLst>
          </p:cNvPr>
          <p:cNvSpPr txBox="1"/>
          <p:nvPr/>
        </p:nvSpPr>
        <p:spPr>
          <a:xfrm>
            <a:off x="629978" y="976092"/>
            <a:ext cx="55980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4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 Amino acid composition of the experimental media, related to Figure 3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70083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24A4534-91B7-4A47-90B6-FC53CF3FA056}"/>
              </a:ext>
            </a:extLst>
          </p:cNvPr>
          <p:cNvSpPr txBox="1"/>
          <p:nvPr/>
        </p:nvSpPr>
        <p:spPr>
          <a:xfrm>
            <a:off x="1405281" y="976092"/>
            <a:ext cx="40474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5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 Primer list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EDF8D51F-A5C1-4C4D-A5B2-D84D1DC80E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2861200"/>
              </p:ext>
            </p:extLst>
          </p:nvPr>
        </p:nvGraphicFramePr>
        <p:xfrm>
          <a:off x="1405281" y="1490830"/>
          <a:ext cx="4047434" cy="301582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43259">
                  <a:extLst>
                    <a:ext uri="{9D8B030D-6E8A-4147-A177-3AD203B41FA5}">
                      <a16:colId xmlns:a16="http://schemas.microsoft.com/office/drawing/2014/main" val="4210052036"/>
                    </a:ext>
                  </a:extLst>
                </a:gridCol>
                <a:gridCol w="462499">
                  <a:extLst>
                    <a:ext uri="{9D8B030D-6E8A-4147-A177-3AD203B41FA5}">
                      <a16:colId xmlns:a16="http://schemas.microsoft.com/office/drawing/2014/main" val="3574767457"/>
                    </a:ext>
                  </a:extLst>
                </a:gridCol>
                <a:gridCol w="2941676">
                  <a:extLst>
                    <a:ext uri="{9D8B030D-6E8A-4147-A177-3AD203B41FA5}">
                      <a16:colId xmlns:a16="http://schemas.microsoft.com/office/drawing/2014/main" val="1472123857"/>
                    </a:ext>
                  </a:extLst>
                </a:gridCol>
              </a:tblGrid>
              <a:tr h="430830">
                <a:tc gridSpan="2">
                  <a:txBody>
                    <a:bodyPr/>
                    <a:lstStyle/>
                    <a:p>
                      <a:pPr algn="ctr">
                        <a:lnSpc>
                          <a:spcPts val="1200"/>
                        </a:lnSpc>
                      </a:pPr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Set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’→3’)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4603135"/>
                  </a:ext>
                </a:extLst>
              </a:tr>
              <a:tr h="215416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Igf1</a:t>
                      </a: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w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TGGTGGACGCTCTTCAGTTC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1527291"/>
                  </a:ext>
                </a:extLst>
              </a:tr>
              <a:tr h="215416">
                <a:tc vMerge="1"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1 </a:t>
                      </a: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v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Rv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ACATCTCCAGCCTCCTCAGATC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5918114"/>
                  </a:ext>
                </a:extLst>
              </a:tr>
              <a:tr h="215416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 Igfbp1</a:t>
                      </a: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w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CTGCCAACGGGAACTCTAT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8248880"/>
                  </a:ext>
                </a:extLst>
              </a:tr>
              <a:tr h="215416">
                <a:tc vMerge="1"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2 </a:t>
                      </a: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v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Rv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GGGATCTTCTTCCCACTCCA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7627868"/>
                  </a:ext>
                </a:extLst>
              </a:tr>
              <a:tr h="215416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ja-JP" sz="100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r Igfbp3</a:t>
                      </a:r>
                      <a:endParaRPr lang="ja-JP" altLang="en-US" sz="105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w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GGCCCAGCAGAAATATCAAA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8748467"/>
                  </a:ext>
                </a:extLst>
              </a:tr>
              <a:tr h="215416">
                <a:tc vMerge="1">
                  <a:txBody>
                    <a:bodyPr/>
                    <a:lstStyle/>
                    <a:p>
                      <a:pPr algn="ctr"/>
                      <a:endParaRPr lang="ja-JP" altLang="en-US" sz="105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Rv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TACCAGGGTCTCCAACAAGG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8729706"/>
                  </a:ext>
                </a:extLst>
              </a:tr>
              <a:tr h="215416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ja-JP" sz="105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r </a:t>
                      </a:r>
                      <a:r>
                        <a:rPr lang="en-US" altLang="ja-JP" sz="1050" b="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Actb</a:t>
                      </a:r>
                      <a:endParaRPr lang="ja-JP" altLang="en-US" sz="105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w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TAAGGCCAACCGTGAAAAGAT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56946203"/>
                  </a:ext>
                </a:extLst>
              </a:tr>
              <a:tr h="215416">
                <a:tc vMerge="1"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3 </a:t>
                      </a: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v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Rv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TCCAGGCTGTGTTGTCCCT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5463143"/>
                  </a:ext>
                </a:extLst>
              </a:tr>
              <a:tr h="215416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ja-JP" sz="105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h Igf1</a:t>
                      </a:r>
                      <a:endParaRPr lang="ja-JP" altLang="en-US" sz="105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w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GGGGCTTTTATTTCACAAGCCC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4427615"/>
                  </a:ext>
                </a:extLst>
              </a:tr>
              <a:tr h="215416">
                <a:tc vMerge="1"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4 </a:t>
                      </a: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v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Rv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CTTCTGGGTCTTGGGCATGT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7108731"/>
                  </a:ext>
                </a:extLst>
              </a:tr>
              <a:tr h="215416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ja-JP" sz="1050" b="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h </a:t>
                      </a:r>
                      <a:r>
                        <a:rPr lang="en-US" altLang="ja-JP" sz="1050" b="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Actb</a:t>
                      </a:r>
                      <a:endParaRPr lang="ja-JP" altLang="en-US" sz="1050" b="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Fw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TTCCTTCCTGGGCATGGAG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9031675"/>
                  </a:ext>
                </a:extLst>
              </a:tr>
              <a:tr h="215416">
                <a:tc vMerge="1"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5 </a:t>
                      </a:r>
                      <a:r>
                        <a:rPr lang="en-US" sz="10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v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Rv</a:t>
                      </a:r>
                      <a:endParaRPr lang="ja-JP" sz="10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altLang="ja-JP" sz="105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GCAGTGATCTCCTTCTGCATC</a:t>
                      </a:r>
                      <a:endParaRPr lang="ja-JP" sz="105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明朝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83373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022887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5972937-EBDF-4C34-A278-93405751A64F}"/>
              </a:ext>
            </a:extLst>
          </p:cNvPr>
          <p:cNvSpPr txBox="1"/>
          <p:nvPr/>
        </p:nvSpPr>
        <p:spPr>
          <a:xfrm>
            <a:off x="425450" y="4954149"/>
            <a:ext cx="6083300" cy="12695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Indicators of the skeletal muscle protein breakdown, related to Figure 2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lasma and gastrocnemius muscle of mice used in Figure 2 were collected. (A) Plasma 3-methyl-L-histidine concentration was measured by HPLC. (B) Muscle lysates were subjected to SDS-PAGE and LC3I and LC3II levels were assessed. Each band was quantified and indicated as the bar graph.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[bar graph: means ±</a:t>
            </a:r>
            <a:r>
              <a:rPr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EM, n=6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83779FC-E55B-4559-B963-009EA3A04700}"/>
              </a:ext>
            </a:extLst>
          </p:cNvPr>
          <p:cNvSpPr txBox="1"/>
          <p:nvPr/>
        </p:nvSpPr>
        <p:spPr>
          <a:xfrm>
            <a:off x="532855" y="1356881"/>
            <a:ext cx="6322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5EFD827-4D79-4EA5-992B-DF666F9270FB}"/>
              </a:ext>
            </a:extLst>
          </p:cNvPr>
          <p:cNvSpPr txBox="1"/>
          <p:nvPr/>
        </p:nvSpPr>
        <p:spPr>
          <a:xfrm>
            <a:off x="3400846" y="1356881"/>
            <a:ext cx="6322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/>
        </p:nvGraphicFramePr>
        <p:xfrm>
          <a:off x="1188910" y="1848247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GraphicFramePr>
            <a:graphicFrameLocks/>
          </p:cNvGraphicFramePr>
          <p:nvPr/>
        </p:nvGraphicFramePr>
        <p:xfrm>
          <a:off x="4032813" y="2489603"/>
          <a:ext cx="216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1" name="図 10">
            <a:extLst>
              <a:ext uri="{FF2B5EF4-FFF2-40B4-BE49-F238E27FC236}">
                <a16:creationId xmlns:a16="http://schemas.microsoft.com/office/drawing/2014/main" id="{00000000-0008-0000-0000-00000700000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1766" t="65615" r="44070" b="29100"/>
          <a:stretch/>
        </p:blipFill>
        <p:spPr>
          <a:xfrm>
            <a:off x="4135251" y="1942061"/>
            <a:ext cx="2012994" cy="471617"/>
          </a:xfrm>
          <a:prstGeom prst="rect">
            <a:avLst/>
          </a:prstGeom>
        </p:spPr>
      </p:pic>
      <p:sp>
        <p:nvSpPr>
          <p:cNvPr id="12" name="テキスト ボックス 8">
            <a:extLst>
              <a:ext uri="{FF2B5EF4-FFF2-40B4-BE49-F238E27FC236}">
                <a16:creationId xmlns:a16="http://schemas.microsoft.com/office/drawing/2014/main" id="{00000000-0008-0000-0000-000009000000}"/>
              </a:ext>
            </a:extLst>
          </p:cNvPr>
          <p:cNvSpPr txBox="1"/>
          <p:nvPr/>
        </p:nvSpPr>
        <p:spPr>
          <a:xfrm>
            <a:off x="3690139" y="2169777"/>
            <a:ext cx="436816" cy="25472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100"/>
              <a:t>LC3-II</a:t>
            </a:r>
            <a:endParaRPr kumimoji="1" lang="ja-JP" altLang="en-US" sz="1100"/>
          </a:p>
        </p:txBody>
      </p:sp>
      <p:sp>
        <p:nvSpPr>
          <p:cNvPr id="15" name="テキスト ボックス 9">
            <a:extLst>
              <a:ext uri="{FF2B5EF4-FFF2-40B4-BE49-F238E27FC236}">
                <a16:creationId xmlns:a16="http://schemas.microsoft.com/office/drawing/2014/main" id="{00000000-0008-0000-0000-00000A000000}"/>
              </a:ext>
            </a:extLst>
          </p:cNvPr>
          <p:cNvSpPr txBox="1"/>
          <p:nvPr/>
        </p:nvSpPr>
        <p:spPr>
          <a:xfrm>
            <a:off x="3690139" y="1992168"/>
            <a:ext cx="406087" cy="25472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100"/>
              <a:t>LC3-I</a:t>
            </a:r>
            <a:endParaRPr kumimoji="1" lang="ja-JP" altLang="en-US" sz="1100"/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00000000-0008-0000-0000-000012000000}"/>
              </a:ext>
            </a:extLst>
          </p:cNvPr>
          <p:cNvCxnSpPr/>
          <p:nvPr/>
        </p:nvCxnSpPr>
        <p:spPr>
          <a:xfrm flipV="1">
            <a:off x="4186133" y="1697923"/>
            <a:ext cx="906309" cy="181"/>
          </a:xfrm>
          <a:prstGeom prst="line">
            <a:avLst/>
          </a:prstGeom>
          <a:ln w="12700"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00000000-0008-0000-0000-000013000000}"/>
              </a:ext>
            </a:extLst>
          </p:cNvPr>
          <p:cNvCxnSpPr/>
          <p:nvPr/>
        </p:nvCxnSpPr>
        <p:spPr>
          <a:xfrm flipV="1">
            <a:off x="5169199" y="1697923"/>
            <a:ext cx="904911" cy="181"/>
          </a:xfrm>
          <a:prstGeom prst="line">
            <a:avLst/>
          </a:prstGeom>
          <a:ln w="12700"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19">
            <a:extLst>
              <a:ext uri="{FF2B5EF4-FFF2-40B4-BE49-F238E27FC236}">
                <a16:creationId xmlns:a16="http://schemas.microsoft.com/office/drawing/2014/main" id="{00000000-0008-0000-0000-000014000000}"/>
              </a:ext>
            </a:extLst>
          </p:cNvPr>
          <p:cNvSpPr txBox="1"/>
          <p:nvPr/>
        </p:nvSpPr>
        <p:spPr>
          <a:xfrm>
            <a:off x="4648169" y="1679031"/>
            <a:ext cx="452368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/>
              <a:t>IGF-I</a:t>
            </a:r>
            <a:endParaRPr kumimoji="1" lang="ja-JP" altLang="en-US" sz="1100" dirty="0"/>
          </a:p>
        </p:txBody>
      </p:sp>
      <p:sp>
        <p:nvSpPr>
          <p:cNvPr id="23" name="テキスト ボックス 20">
            <a:extLst>
              <a:ext uri="{FF2B5EF4-FFF2-40B4-BE49-F238E27FC236}">
                <a16:creationId xmlns:a16="http://schemas.microsoft.com/office/drawing/2014/main" id="{00000000-0008-0000-0000-000015000000}"/>
              </a:ext>
            </a:extLst>
          </p:cNvPr>
          <p:cNvSpPr txBox="1"/>
          <p:nvPr/>
        </p:nvSpPr>
        <p:spPr>
          <a:xfrm>
            <a:off x="5652157" y="1679031"/>
            <a:ext cx="452368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/>
              <a:t>IGF-I</a:t>
            </a:r>
            <a:endParaRPr kumimoji="1" lang="ja-JP" altLang="en-US" sz="1100" dirty="0"/>
          </a:p>
        </p:txBody>
      </p:sp>
      <p:sp>
        <p:nvSpPr>
          <p:cNvPr id="24" name="テキスト ボックス 21">
            <a:extLst>
              <a:ext uri="{FF2B5EF4-FFF2-40B4-BE49-F238E27FC236}">
                <a16:creationId xmlns:a16="http://schemas.microsoft.com/office/drawing/2014/main" id="{00000000-0008-0000-0000-000016000000}"/>
              </a:ext>
            </a:extLst>
          </p:cNvPr>
          <p:cNvSpPr txBox="1"/>
          <p:nvPr/>
        </p:nvSpPr>
        <p:spPr>
          <a:xfrm>
            <a:off x="5183739" y="1679031"/>
            <a:ext cx="409086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/>
              <a:t>Veh</a:t>
            </a:r>
            <a:endParaRPr kumimoji="1" lang="ja-JP" altLang="en-US" sz="1100"/>
          </a:p>
        </p:txBody>
      </p:sp>
      <p:sp>
        <p:nvSpPr>
          <p:cNvPr id="25" name="テキスト ボックス 22">
            <a:extLst>
              <a:ext uri="{FF2B5EF4-FFF2-40B4-BE49-F238E27FC236}">
                <a16:creationId xmlns:a16="http://schemas.microsoft.com/office/drawing/2014/main" id="{00000000-0008-0000-0000-000017000000}"/>
              </a:ext>
            </a:extLst>
          </p:cNvPr>
          <p:cNvSpPr txBox="1"/>
          <p:nvPr/>
        </p:nvSpPr>
        <p:spPr>
          <a:xfrm>
            <a:off x="4187433" y="1679031"/>
            <a:ext cx="409086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kumimoji="1" lang="en-US" altLang="ja-JP" sz="1100" dirty="0" err="1"/>
              <a:t>Veh</a:t>
            </a:r>
            <a:endParaRPr kumimoji="1" lang="ja-JP" altLang="en-US" sz="1100" dirty="0"/>
          </a:p>
        </p:txBody>
      </p:sp>
      <p:sp>
        <p:nvSpPr>
          <p:cNvPr id="27" name="テキスト ボックス 23">
            <a:extLst>
              <a:ext uri="{FF2B5EF4-FFF2-40B4-BE49-F238E27FC236}">
                <a16:creationId xmlns:a16="http://schemas.microsoft.com/office/drawing/2014/main" id="{00000000-0008-0000-0000-000018000000}"/>
              </a:ext>
            </a:extLst>
          </p:cNvPr>
          <p:cNvSpPr txBox="1"/>
          <p:nvPr/>
        </p:nvSpPr>
        <p:spPr>
          <a:xfrm>
            <a:off x="4464457" y="1421448"/>
            <a:ext cx="444352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/>
              <a:t>CON</a:t>
            </a:r>
            <a:endParaRPr kumimoji="1" lang="ja-JP" altLang="en-US" sz="1100" dirty="0"/>
          </a:p>
        </p:txBody>
      </p:sp>
      <p:sp>
        <p:nvSpPr>
          <p:cNvPr id="28" name="テキスト ボックス 24">
            <a:extLst>
              <a:ext uri="{FF2B5EF4-FFF2-40B4-BE49-F238E27FC236}">
                <a16:creationId xmlns:a16="http://schemas.microsoft.com/office/drawing/2014/main" id="{00000000-0008-0000-0000-000019000000}"/>
              </a:ext>
            </a:extLst>
          </p:cNvPr>
          <p:cNvSpPr txBox="1"/>
          <p:nvPr/>
        </p:nvSpPr>
        <p:spPr>
          <a:xfrm>
            <a:off x="5469401" y="1421448"/>
            <a:ext cx="316112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/>
              <a:t>LP</a:t>
            </a:r>
            <a:endParaRPr kumimoji="1" lang="ja-JP" altLang="en-US" sz="1100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03D5AC6-132B-414E-A7E4-DB688BA30593}"/>
              </a:ext>
            </a:extLst>
          </p:cNvPr>
          <p:cNvSpPr txBox="1"/>
          <p:nvPr/>
        </p:nvSpPr>
        <p:spPr>
          <a:xfrm rot="16200000">
            <a:off x="71206" y="2721140"/>
            <a:ext cx="190944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lasma 3-methyl-L-histidine</a:t>
            </a:r>
          </a:p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[nmol/mL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4E569F4-12FF-483A-9CC4-A82ED1456A31}"/>
              </a:ext>
            </a:extLst>
          </p:cNvPr>
          <p:cNvSpPr txBox="1"/>
          <p:nvPr/>
        </p:nvSpPr>
        <p:spPr>
          <a:xfrm rot="16200000">
            <a:off x="3173977" y="3258797"/>
            <a:ext cx="15239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Muscle LC3II / I [AU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98921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59F23A7-7BFF-407E-A46C-D316754CA910}"/>
              </a:ext>
            </a:extLst>
          </p:cNvPr>
          <p:cNvSpPr txBox="1"/>
          <p:nvPr/>
        </p:nvSpPr>
        <p:spPr>
          <a:xfrm>
            <a:off x="1160228" y="180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Il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17E8865-33AE-4955-BA08-6B11E7F73E3B}"/>
              </a:ext>
            </a:extLst>
          </p:cNvPr>
          <p:cNvSpPr txBox="1"/>
          <p:nvPr/>
        </p:nvSpPr>
        <p:spPr>
          <a:xfrm>
            <a:off x="4364229" y="180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Phe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20FEE98-CE94-4935-913E-D1C24F8A5EF3}"/>
              </a:ext>
            </a:extLst>
          </p:cNvPr>
          <p:cNvSpPr txBox="1"/>
          <p:nvPr/>
        </p:nvSpPr>
        <p:spPr>
          <a:xfrm>
            <a:off x="1159200" y="1872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Thr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424B0C8-DF96-4B2D-9208-0154A17781FF}"/>
              </a:ext>
            </a:extLst>
          </p:cNvPr>
          <p:cNvSpPr txBox="1"/>
          <p:nvPr/>
        </p:nvSpPr>
        <p:spPr>
          <a:xfrm>
            <a:off x="4363200" y="1872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Trp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E4DB806-A19C-41C4-92F4-C62444D6C005}"/>
              </a:ext>
            </a:extLst>
          </p:cNvPr>
          <p:cNvSpPr txBox="1"/>
          <p:nvPr/>
        </p:nvSpPr>
        <p:spPr>
          <a:xfrm>
            <a:off x="1159200" y="3564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Val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0480ED9-E6A4-41BE-A24D-735489C060A2}"/>
              </a:ext>
            </a:extLst>
          </p:cNvPr>
          <p:cNvSpPr txBox="1"/>
          <p:nvPr/>
        </p:nvSpPr>
        <p:spPr>
          <a:xfrm>
            <a:off x="4363200" y="3564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Leu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E579D9B-B41B-40A7-91E8-10DC86B89F06}"/>
              </a:ext>
            </a:extLst>
          </p:cNvPr>
          <p:cNvSpPr txBox="1"/>
          <p:nvPr/>
        </p:nvSpPr>
        <p:spPr>
          <a:xfrm>
            <a:off x="1159200" y="5436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Ly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A323A24-7B5B-4F9C-B2F1-0B25588482CA}"/>
              </a:ext>
            </a:extLst>
          </p:cNvPr>
          <p:cNvSpPr txBox="1"/>
          <p:nvPr/>
        </p:nvSpPr>
        <p:spPr>
          <a:xfrm>
            <a:off x="4363200" y="5436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Met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568E687-AF77-45BB-980A-D3E6487BD561}"/>
              </a:ext>
            </a:extLst>
          </p:cNvPr>
          <p:cNvSpPr txBox="1"/>
          <p:nvPr/>
        </p:nvSpPr>
        <p:spPr>
          <a:xfrm>
            <a:off x="1159200" y="7308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Hi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AA8CAA0A-3C40-4F3B-853B-1958887746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7916518"/>
              </p:ext>
            </p:extLst>
          </p:nvPr>
        </p:nvGraphicFramePr>
        <p:xfrm>
          <a:off x="288000" y="180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884BB884-0E31-4188-ABAC-F597066135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7414123"/>
              </p:ext>
            </p:extLst>
          </p:nvPr>
        </p:nvGraphicFramePr>
        <p:xfrm>
          <a:off x="3492000" y="3564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3A62120A-729E-4107-A13F-AFC455D8305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084001"/>
              </p:ext>
            </p:extLst>
          </p:nvPr>
        </p:nvGraphicFramePr>
        <p:xfrm>
          <a:off x="288000" y="5436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71F6B42A-EB67-45F8-9DA9-74FCA29448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5261644"/>
              </p:ext>
            </p:extLst>
          </p:nvPr>
        </p:nvGraphicFramePr>
        <p:xfrm>
          <a:off x="3492000" y="5436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F170FD9B-28FB-4494-A668-AA07C8131C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990456"/>
              </p:ext>
            </p:extLst>
          </p:nvPr>
        </p:nvGraphicFramePr>
        <p:xfrm>
          <a:off x="3492000" y="180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780E3769-979D-4A04-824B-EF0F3E3EB0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6113664"/>
              </p:ext>
            </p:extLst>
          </p:nvPr>
        </p:nvGraphicFramePr>
        <p:xfrm>
          <a:off x="288000" y="1872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09E7BE55-1FBF-4A41-A883-AE48B00F27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1211286"/>
              </p:ext>
            </p:extLst>
          </p:nvPr>
        </p:nvGraphicFramePr>
        <p:xfrm>
          <a:off x="3492000" y="1872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EF316951-DDFD-4C35-9252-61FC3315C9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5007943"/>
              </p:ext>
            </p:extLst>
          </p:nvPr>
        </p:nvGraphicFramePr>
        <p:xfrm>
          <a:off x="288000" y="3564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C7FD7F31-9C06-4D07-B210-B572E64CAC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9090752"/>
              </p:ext>
            </p:extLst>
          </p:nvPr>
        </p:nvGraphicFramePr>
        <p:xfrm>
          <a:off x="288000" y="7308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108D8B4F-4F79-474E-8077-798F8A2B2121}"/>
              </a:ext>
            </a:extLst>
          </p:cNvPr>
          <p:cNvSpPr>
            <a:spLocks noChangeAspect="1"/>
          </p:cNvSpPr>
          <p:nvPr/>
        </p:nvSpPr>
        <p:spPr>
          <a:xfrm>
            <a:off x="3605515" y="7451406"/>
            <a:ext cx="72000" cy="72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1EC7CDBD-3DA9-4793-AF32-728CB1399385}"/>
              </a:ext>
            </a:extLst>
          </p:cNvPr>
          <p:cNvSpPr>
            <a:spLocks noChangeAspect="1"/>
          </p:cNvSpPr>
          <p:nvPr/>
        </p:nvSpPr>
        <p:spPr>
          <a:xfrm>
            <a:off x="3605515" y="7631406"/>
            <a:ext cx="72000" cy="72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3EAD0A7-DB80-49FB-AECB-63FFAA2F9973}"/>
              </a:ext>
            </a:extLst>
          </p:cNvPr>
          <p:cNvSpPr txBox="1"/>
          <p:nvPr/>
        </p:nvSpPr>
        <p:spPr>
          <a:xfrm>
            <a:off x="3679505" y="7371990"/>
            <a:ext cx="6921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N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78F7003-D1EF-485F-8409-E5DB2BB513E4}"/>
              </a:ext>
            </a:extLst>
          </p:cNvPr>
          <p:cNvSpPr txBox="1"/>
          <p:nvPr/>
        </p:nvSpPr>
        <p:spPr>
          <a:xfrm>
            <a:off x="3679504" y="7551990"/>
            <a:ext cx="12604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xperimental Diet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1C2D694-BCF8-43F4-87FE-8D064E4E77ED}"/>
              </a:ext>
            </a:extLst>
          </p:cNvPr>
          <p:cNvSpPr txBox="1"/>
          <p:nvPr/>
        </p:nvSpPr>
        <p:spPr>
          <a:xfrm rot="16200000">
            <a:off x="-634974" y="775258"/>
            <a:ext cx="1715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rum AAs [nmol/10 µL]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D5C93AA-859C-42B2-8247-40F54F73C1F0}"/>
              </a:ext>
            </a:extLst>
          </p:cNvPr>
          <p:cNvSpPr txBox="1"/>
          <p:nvPr/>
        </p:nvSpPr>
        <p:spPr>
          <a:xfrm rot="16200000">
            <a:off x="-634973" y="2474788"/>
            <a:ext cx="171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rum AAs [nmol/10 µL]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76888EF-E41F-4127-858B-DB44B9F55503}"/>
              </a:ext>
            </a:extLst>
          </p:cNvPr>
          <p:cNvSpPr txBox="1"/>
          <p:nvPr/>
        </p:nvSpPr>
        <p:spPr>
          <a:xfrm rot="16200000">
            <a:off x="-634972" y="4165608"/>
            <a:ext cx="171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rum AAs [nmol/10 µL]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F7F334D-D1BA-487F-8275-442409103C7A}"/>
              </a:ext>
            </a:extLst>
          </p:cNvPr>
          <p:cNvSpPr txBox="1"/>
          <p:nvPr/>
        </p:nvSpPr>
        <p:spPr>
          <a:xfrm rot="16200000">
            <a:off x="-634971" y="6030608"/>
            <a:ext cx="171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rum AAs [nmol/10 µL]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9CBA1F4-0F24-4A5A-BFDD-CD06CEADB3E0}"/>
              </a:ext>
            </a:extLst>
          </p:cNvPr>
          <p:cNvSpPr txBox="1"/>
          <p:nvPr/>
        </p:nvSpPr>
        <p:spPr>
          <a:xfrm rot="16200000">
            <a:off x="-616866" y="7931130"/>
            <a:ext cx="16795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rum AAs [nmol/10 µL]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877260E-3FA3-446F-A496-47C0C730CAD3}"/>
              </a:ext>
            </a:extLst>
          </p:cNvPr>
          <p:cNvSpPr txBox="1"/>
          <p:nvPr/>
        </p:nvSpPr>
        <p:spPr>
          <a:xfrm>
            <a:off x="384871" y="9194306"/>
            <a:ext cx="6088258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Rat serum amino acid concentration, related to Figure 1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ontinues to the next page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5DE9F218-7A6A-45F8-A214-03CEFD00BDB3}"/>
              </a:ext>
            </a:extLst>
          </p:cNvPr>
          <p:cNvGrpSpPr/>
          <p:nvPr/>
        </p:nvGrpSpPr>
        <p:grpSpPr>
          <a:xfrm>
            <a:off x="452144" y="1162848"/>
            <a:ext cx="284532" cy="307777"/>
            <a:chOff x="457932" y="1070247"/>
            <a:chExt cx="284532" cy="307777"/>
          </a:xfrm>
        </p:grpSpPr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1009635F-7927-4EFF-B20A-CF4EA96F3449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F5A11F10-8F9B-4689-B2F6-C54F51EADEE0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786FAD08-DEB8-4249-8BB2-5EDE541C91A2}"/>
              </a:ext>
            </a:extLst>
          </p:cNvPr>
          <p:cNvGrpSpPr/>
          <p:nvPr/>
        </p:nvGrpSpPr>
        <p:grpSpPr>
          <a:xfrm>
            <a:off x="2061900" y="1161359"/>
            <a:ext cx="284532" cy="307777"/>
            <a:chOff x="457932" y="1070247"/>
            <a:chExt cx="284532" cy="307777"/>
          </a:xfrm>
        </p:grpSpPr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375C2122-0221-4BAA-9918-06C32EB481F4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D44FCD42-C105-4D5B-B685-0BCD94D0AE7E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0EBA7343-DC82-4A0F-A2FE-3A223B950055}"/>
              </a:ext>
            </a:extLst>
          </p:cNvPr>
          <p:cNvGrpSpPr/>
          <p:nvPr/>
        </p:nvGrpSpPr>
        <p:grpSpPr>
          <a:xfrm>
            <a:off x="2506888" y="1067273"/>
            <a:ext cx="284532" cy="307777"/>
            <a:chOff x="457932" y="1070247"/>
            <a:chExt cx="284532" cy="307777"/>
          </a:xfrm>
        </p:grpSpPr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05F6CC96-5074-41CB-9E03-EE3A8E899714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541FA12D-7187-4653-8E90-C9F096E83F64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A61DB202-753C-4B6B-988F-53BB61AD303A}"/>
              </a:ext>
            </a:extLst>
          </p:cNvPr>
          <p:cNvGrpSpPr/>
          <p:nvPr/>
        </p:nvGrpSpPr>
        <p:grpSpPr>
          <a:xfrm>
            <a:off x="2652048" y="179335"/>
            <a:ext cx="284532" cy="307777"/>
            <a:chOff x="457932" y="1070247"/>
            <a:chExt cx="284532" cy="307777"/>
          </a:xfrm>
        </p:grpSpPr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405ECFF7-5714-4ACE-8C7F-08B4DF6A1AE1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8355C342-EAA1-4CC7-8AE9-1341DE3368D9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4045E16C-A095-4E91-997F-A204EACE60C3}"/>
              </a:ext>
            </a:extLst>
          </p:cNvPr>
          <p:cNvGrpSpPr/>
          <p:nvPr/>
        </p:nvGrpSpPr>
        <p:grpSpPr>
          <a:xfrm>
            <a:off x="3091056" y="441893"/>
            <a:ext cx="284532" cy="307777"/>
            <a:chOff x="457932" y="1070247"/>
            <a:chExt cx="284532" cy="307777"/>
          </a:xfrm>
        </p:grpSpPr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A4653669-04FF-4539-955F-7633FC327E1F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7B2300CA-0E46-451E-8D28-024FA2E3601F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A7BFB2B7-B651-4826-B893-6539CC5FF3B3}"/>
              </a:ext>
            </a:extLst>
          </p:cNvPr>
          <p:cNvGrpSpPr/>
          <p:nvPr/>
        </p:nvGrpSpPr>
        <p:grpSpPr>
          <a:xfrm>
            <a:off x="3794722" y="1165742"/>
            <a:ext cx="284532" cy="307777"/>
            <a:chOff x="457932" y="1070247"/>
            <a:chExt cx="284532" cy="307777"/>
          </a:xfrm>
        </p:grpSpPr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A42B42EB-BACD-4DED-A98E-6BFE81A86671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836C2953-6EB1-4859-8C05-E21F807A777B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3FDED605-4FD0-4438-A86C-2FBF8B743368}"/>
              </a:ext>
            </a:extLst>
          </p:cNvPr>
          <p:cNvGrpSpPr/>
          <p:nvPr/>
        </p:nvGrpSpPr>
        <p:grpSpPr>
          <a:xfrm>
            <a:off x="5266789" y="1161358"/>
            <a:ext cx="284532" cy="307777"/>
            <a:chOff x="457932" y="1070247"/>
            <a:chExt cx="284532" cy="307777"/>
          </a:xfrm>
        </p:grpSpPr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595A2428-1E16-4181-876E-305FCB686533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3BEB200B-41B6-4842-AFA7-58131832BD73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18C88B41-D5CB-47E5-9FFF-021BB9C74A64}"/>
              </a:ext>
            </a:extLst>
          </p:cNvPr>
          <p:cNvGrpSpPr/>
          <p:nvPr/>
        </p:nvGrpSpPr>
        <p:grpSpPr>
          <a:xfrm>
            <a:off x="5861578" y="166107"/>
            <a:ext cx="284532" cy="307777"/>
            <a:chOff x="457932" y="1070247"/>
            <a:chExt cx="284532" cy="307777"/>
          </a:xfrm>
        </p:grpSpPr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04020575-A068-4EBF-A0B5-A365E0EAD139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D311259A-E178-4ABE-ADED-813F0C3B0179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D0988EE1-4CDD-4FF6-BABB-7DEEB24F9E3B}"/>
              </a:ext>
            </a:extLst>
          </p:cNvPr>
          <p:cNvGrpSpPr/>
          <p:nvPr/>
        </p:nvGrpSpPr>
        <p:grpSpPr>
          <a:xfrm>
            <a:off x="6295721" y="519405"/>
            <a:ext cx="284532" cy="307777"/>
            <a:chOff x="457932" y="1070247"/>
            <a:chExt cx="284532" cy="307777"/>
          </a:xfrm>
        </p:grpSpPr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3C7A8621-25F8-4BDA-A7E6-BD58444B4D72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F4AC4169-F1F0-4A3B-9252-2CAC3543C893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id="{DADC8DA0-1147-43B7-BB2A-9884388E517B}"/>
              </a:ext>
            </a:extLst>
          </p:cNvPr>
          <p:cNvGrpSpPr/>
          <p:nvPr/>
        </p:nvGrpSpPr>
        <p:grpSpPr>
          <a:xfrm>
            <a:off x="6448536" y="1098707"/>
            <a:ext cx="284532" cy="307777"/>
            <a:chOff x="457932" y="1070247"/>
            <a:chExt cx="284532" cy="307777"/>
          </a:xfrm>
        </p:grpSpPr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18BDED66-2666-4AB1-B74E-F2D32F00B473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52CCDF22-A06D-448C-82BB-4C1BF0EDFB2A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67" name="グループ化 66">
            <a:extLst>
              <a:ext uri="{FF2B5EF4-FFF2-40B4-BE49-F238E27FC236}">
                <a16:creationId xmlns:a16="http://schemas.microsoft.com/office/drawing/2014/main" id="{B464DD91-5492-4CE1-B009-9FDE0C3DFFCB}"/>
              </a:ext>
            </a:extLst>
          </p:cNvPr>
          <p:cNvGrpSpPr/>
          <p:nvPr/>
        </p:nvGrpSpPr>
        <p:grpSpPr>
          <a:xfrm>
            <a:off x="742464" y="2135153"/>
            <a:ext cx="284532" cy="307777"/>
            <a:chOff x="457932" y="1070247"/>
            <a:chExt cx="284532" cy="307777"/>
          </a:xfrm>
        </p:grpSpPr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20493580-A4BB-432F-962C-E883C18C356B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7D2A0E82-14D5-4B87-980F-1338432E9DA3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id="{9051A483-AE6C-4614-82E1-FD40C8B85DB0}"/>
              </a:ext>
            </a:extLst>
          </p:cNvPr>
          <p:cNvGrpSpPr/>
          <p:nvPr/>
        </p:nvGrpSpPr>
        <p:grpSpPr>
          <a:xfrm>
            <a:off x="2209967" y="2777369"/>
            <a:ext cx="284532" cy="307777"/>
            <a:chOff x="457932" y="1070247"/>
            <a:chExt cx="284532" cy="307777"/>
          </a:xfrm>
        </p:grpSpPr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A8C62F37-7783-44FE-8585-0723EF97585A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0FDE5400-DFCE-497D-9172-F93296592864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id="{8D2AB525-67A4-41BF-B3F9-D57A88EC5FA2}"/>
              </a:ext>
            </a:extLst>
          </p:cNvPr>
          <p:cNvGrpSpPr/>
          <p:nvPr/>
        </p:nvGrpSpPr>
        <p:grpSpPr>
          <a:xfrm>
            <a:off x="3093099" y="2002404"/>
            <a:ext cx="284532" cy="307777"/>
            <a:chOff x="457932" y="1070247"/>
            <a:chExt cx="284532" cy="307777"/>
          </a:xfrm>
        </p:grpSpPr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45425598-3960-483D-9C14-92652A30A811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861B5D4F-79A0-488C-B0B8-5C5F63E9A35D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id="{201AADCE-C69E-4FCE-8C50-6CCCD0F2758F}"/>
              </a:ext>
            </a:extLst>
          </p:cNvPr>
          <p:cNvGrpSpPr/>
          <p:nvPr/>
        </p:nvGrpSpPr>
        <p:grpSpPr>
          <a:xfrm>
            <a:off x="4090338" y="2825196"/>
            <a:ext cx="284532" cy="307777"/>
            <a:chOff x="457932" y="1070247"/>
            <a:chExt cx="284532" cy="307777"/>
          </a:xfrm>
        </p:grpSpPr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37A634A8-8702-406E-A369-A126BCA68046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F68373A4-61A6-427E-9A87-FDED334E741A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88342D29-3AC7-4C7E-A584-B11C1F95B314}"/>
              </a:ext>
            </a:extLst>
          </p:cNvPr>
          <p:cNvGrpSpPr/>
          <p:nvPr/>
        </p:nvGrpSpPr>
        <p:grpSpPr>
          <a:xfrm>
            <a:off x="5412421" y="2798252"/>
            <a:ext cx="284532" cy="307777"/>
            <a:chOff x="457932" y="1070247"/>
            <a:chExt cx="284532" cy="307777"/>
          </a:xfrm>
        </p:grpSpPr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CB969E00-6424-4498-85FF-B6E3023D7151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F506DF97-DF2E-4A11-BD2E-D78DFD80FA15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A8011D1C-A348-4508-A166-12B71E5F04D1}"/>
              </a:ext>
            </a:extLst>
          </p:cNvPr>
          <p:cNvGrpSpPr/>
          <p:nvPr/>
        </p:nvGrpSpPr>
        <p:grpSpPr>
          <a:xfrm>
            <a:off x="5856888" y="1876760"/>
            <a:ext cx="284532" cy="307777"/>
            <a:chOff x="457932" y="1070247"/>
            <a:chExt cx="284532" cy="307777"/>
          </a:xfrm>
        </p:grpSpPr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98A879A6-0E6B-4170-A54A-4D3CD681BAD6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2ABD824B-1DD2-4B7C-A6EA-8024DA6207A8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85" name="グループ化 84">
            <a:extLst>
              <a:ext uri="{FF2B5EF4-FFF2-40B4-BE49-F238E27FC236}">
                <a16:creationId xmlns:a16="http://schemas.microsoft.com/office/drawing/2014/main" id="{2A48DF31-8832-46E4-8B20-40FE9E86B3AC}"/>
              </a:ext>
            </a:extLst>
          </p:cNvPr>
          <p:cNvGrpSpPr/>
          <p:nvPr/>
        </p:nvGrpSpPr>
        <p:grpSpPr>
          <a:xfrm>
            <a:off x="591123" y="4590040"/>
            <a:ext cx="284532" cy="307777"/>
            <a:chOff x="457932" y="1070247"/>
            <a:chExt cx="284532" cy="307777"/>
          </a:xfrm>
        </p:grpSpPr>
        <p:cxnSp>
          <p:nvCxnSpPr>
            <p:cNvPr id="86" name="直線コネクタ 85">
              <a:extLst>
                <a:ext uri="{FF2B5EF4-FFF2-40B4-BE49-F238E27FC236}">
                  <a16:creationId xmlns:a16="http://schemas.microsoft.com/office/drawing/2014/main" id="{6E83461C-F5E6-4735-92B8-C0FC87322CBE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8C087F18-5BB7-4161-A98D-D4E65807E592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9A16129D-71E1-4B50-8C9A-71F0846C29F0}"/>
              </a:ext>
            </a:extLst>
          </p:cNvPr>
          <p:cNvGrpSpPr/>
          <p:nvPr/>
        </p:nvGrpSpPr>
        <p:grpSpPr>
          <a:xfrm>
            <a:off x="1026996" y="4418044"/>
            <a:ext cx="284532" cy="307777"/>
            <a:chOff x="457932" y="1070247"/>
            <a:chExt cx="284532" cy="307777"/>
          </a:xfrm>
        </p:grpSpPr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74F9B115-573A-49E9-8270-A1EDBE6A08E9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E31154CD-57B8-499D-A83D-5C16B61B74A8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id="{7288B1E8-FD73-4EF7-B5BD-2675F97E475A}"/>
              </a:ext>
            </a:extLst>
          </p:cNvPr>
          <p:cNvGrpSpPr/>
          <p:nvPr/>
        </p:nvGrpSpPr>
        <p:grpSpPr>
          <a:xfrm>
            <a:off x="2068103" y="4540950"/>
            <a:ext cx="284532" cy="307777"/>
            <a:chOff x="457932" y="1070247"/>
            <a:chExt cx="284532" cy="307777"/>
          </a:xfrm>
        </p:grpSpPr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id="{1F2AAA32-2E4F-44A2-A42D-642253A38B29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14991902-2A2C-4CDA-9427-1FB766DE48CD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94" name="グループ化 93">
            <a:extLst>
              <a:ext uri="{FF2B5EF4-FFF2-40B4-BE49-F238E27FC236}">
                <a16:creationId xmlns:a16="http://schemas.microsoft.com/office/drawing/2014/main" id="{AA7A95DB-932E-4C8B-BDDA-4CCA72A691A0}"/>
              </a:ext>
            </a:extLst>
          </p:cNvPr>
          <p:cNvGrpSpPr/>
          <p:nvPr/>
        </p:nvGrpSpPr>
        <p:grpSpPr>
          <a:xfrm>
            <a:off x="2359027" y="4576934"/>
            <a:ext cx="284532" cy="307777"/>
            <a:chOff x="457932" y="1070247"/>
            <a:chExt cx="284532" cy="307777"/>
          </a:xfrm>
        </p:grpSpPr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76A877FD-3AAF-4995-B8A1-6A0202686486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2C8DDDF5-3053-40B2-BB97-CD88E19C27D3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97" name="グループ化 96">
            <a:extLst>
              <a:ext uri="{FF2B5EF4-FFF2-40B4-BE49-F238E27FC236}">
                <a16:creationId xmlns:a16="http://schemas.microsoft.com/office/drawing/2014/main" id="{D16125D8-22C6-45BD-B9DB-40849AEFD184}"/>
              </a:ext>
            </a:extLst>
          </p:cNvPr>
          <p:cNvGrpSpPr/>
          <p:nvPr/>
        </p:nvGrpSpPr>
        <p:grpSpPr>
          <a:xfrm>
            <a:off x="2507081" y="4454193"/>
            <a:ext cx="284532" cy="307777"/>
            <a:chOff x="457932" y="1070247"/>
            <a:chExt cx="284532" cy="307777"/>
          </a:xfrm>
        </p:grpSpPr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40E722BC-F2B7-4833-B32B-0E7325641EC3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1EEB7100-0334-4E63-89A4-FA83AB91B01A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00" name="グループ化 99">
            <a:extLst>
              <a:ext uri="{FF2B5EF4-FFF2-40B4-BE49-F238E27FC236}">
                <a16:creationId xmlns:a16="http://schemas.microsoft.com/office/drawing/2014/main" id="{15F77063-B005-4E7B-BB8A-970CFA18FA46}"/>
              </a:ext>
            </a:extLst>
          </p:cNvPr>
          <p:cNvGrpSpPr/>
          <p:nvPr/>
        </p:nvGrpSpPr>
        <p:grpSpPr>
          <a:xfrm>
            <a:off x="3089612" y="3766515"/>
            <a:ext cx="284532" cy="307777"/>
            <a:chOff x="457932" y="1070247"/>
            <a:chExt cx="284532" cy="307777"/>
          </a:xfrm>
        </p:grpSpPr>
        <p:cxnSp>
          <p:nvCxnSpPr>
            <p:cNvPr id="101" name="直線コネクタ 100">
              <a:extLst>
                <a:ext uri="{FF2B5EF4-FFF2-40B4-BE49-F238E27FC236}">
                  <a16:creationId xmlns:a16="http://schemas.microsoft.com/office/drawing/2014/main" id="{9633FBF4-23C8-4896-A2ED-D333C2A13826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60F0FE95-284D-4CA0-AB4E-EAEA51B58D05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03" name="グループ化 102">
            <a:extLst>
              <a:ext uri="{FF2B5EF4-FFF2-40B4-BE49-F238E27FC236}">
                <a16:creationId xmlns:a16="http://schemas.microsoft.com/office/drawing/2014/main" id="{8F6C2934-DA07-46FD-9A86-5EEFD6428308}"/>
              </a:ext>
            </a:extLst>
          </p:cNvPr>
          <p:cNvGrpSpPr/>
          <p:nvPr/>
        </p:nvGrpSpPr>
        <p:grpSpPr>
          <a:xfrm>
            <a:off x="3797616" y="4585035"/>
            <a:ext cx="284532" cy="307777"/>
            <a:chOff x="457932" y="1070247"/>
            <a:chExt cx="284532" cy="307777"/>
          </a:xfrm>
        </p:grpSpPr>
        <p:cxnSp>
          <p:nvCxnSpPr>
            <p:cNvPr id="104" name="直線コネクタ 103">
              <a:extLst>
                <a:ext uri="{FF2B5EF4-FFF2-40B4-BE49-F238E27FC236}">
                  <a16:creationId xmlns:a16="http://schemas.microsoft.com/office/drawing/2014/main" id="{66D115C5-690C-4EDF-9D8D-1CF1FA0F28FC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69779C83-77C3-4B44-BE34-73C1019D891F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06" name="グループ化 105">
            <a:extLst>
              <a:ext uri="{FF2B5EF4-FFF2-40B4-BE49-F238E27FC236}">
                <a16:creationId xmlns:a16="http://schemas.microsoft.com/office/drawing/2014/main" id="{E049F905-1C33-40A2-9D4E-23A6AA414FE3}"/>
              </a:ext>
            </a:extLst>
          </p:cNvPr>
          <p:cNvGrpSpPr/>
          <p:nvPr/>
        </p:nvGrpSpPr>
        <p:grpSpPr>
          <a:xfrm>
            <a:off x="4387947" y="4486583"/>
            <a:ext cx="284532" cy="307777"/>
            <a:chOff x="457932" y="1070247"/>
            <a:chExt cx="284532" cy="307777"/>
          </a:xfrm>
        </p:grpSpPr>
        <p:cxnSp>
          <p:nvCxnSpPr>
            <p:cNvPr id="107" name="直線コネクタ 106">
              <a:extLst>
                <a:ext uri="{FF2B5EF4-FFF2-40B4-BE49-F238E27FC236}">
                  <a16:creationId xmlns:a16="http://schemas.microsoft.com/office/drawing/2014/main" id="{D505D74D-573F-49A3-9B69-A1A7935233C6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D084D18D-9B55-41D0-8E40-33BFDB61B665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09" name="グループ化 108">
            <a:extLst>
              <a:ext uri="{FF2B5EF4-FFF2-40B4-BE49-F238E27FC236}">
                <a16:creationId xmlns:a16="http://schemas.microsoft.com/office/drawing/2014/main" id="{6C9C28C3-FC0E-4A64-93F3-EC88F6CB1A2B}"/>
              </a:ext>
            </a:extLst>
          </p:cNvPr>
          <p:cNvGrpSpPr/>
          <p:nvPr/>
        </p:nvGrpSpPr>
        <p:grpSpPr>
          <a:xfrm>
            <a:off x="6295354" y="3755576"/>
            <a:ext cx="284532" cy="307777"/>
            <a:chOff x="457932" y="1070247"/>
            <a:chExt cx="284532" cy="307777"/>
          </a:xfrm>
        </p:grpSpPr>
        <p:cxnSp>
          <p:nvCxnSpPr>
            <p:cNvPr id="110" name="直線コネクタ 109">
              <a:extLst>
                <a:ext uri="{FF2B5EF4-FFF2-40B4-BE49-F238E27FC236}">
                  <a16:creationId xmlns:a16="http://schemas.microsoft.com/office/drawing/2014/main" id="{D52AAFFE-2069-4E6E-89E0-3B3502599019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D27C0935-72A1-4559-9F42-E4194A85F8FC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id="{B870A653-8048-4F3C-83E9-86C465F7A5A1}"/>
              </a:ext>
            </a:extLst>
          </p:cNvPr>
          <p:cNvGrpSpPr/>
          <p:nvPr/>
        </p:nvGrpSpPr>
        <p:grpSpPr>
          <a:xfrm>
            <a:off x="1330328" y="6104954"/>
            <a:ext cx="284532" cy="307777"/>
            <a:chOff x="457932" y="1070247"/>
            <a:chExt cx="284532" cy="307777"/>
          </a:xfrm>
        </p:grpSpPr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4863F53E-5DBF-488C-A412-EF08D8BA8A7A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9FCBD212-96A0-4B66-AAE1-964F363F1BB9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21" name="グループ化 120">
            <a:extLst>
              <a:ext uri="{FF2B5EF4-FFF2-40B4-BE49-F238E27FC236}">
                <a16:creationId xmlns:a16="http://schemas.microsoft.com/office/drawing/2014/main" id="{C0A2C7AC-4B9D-40FF-B6BC-F60A27A4982C}"/>
              </a:ext>
            </a:extLst>
          </p:cNvPr>
          <p:cNvGrpSpPr/>
          <p:nvPr/>
        </p:nvGrpSpPr>
        <p:grpSpPr>
          <a:xfrm>
            <a:off x="2660730" y="5438234"/>
            <a:ext cx="284532" cy="307777"/>
            <a:chOff x="457932" y="1070247"/>
            <a:chExt cx="284532" cy="307777"/>
          </a:xfrm>
        </p:grpSpPr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id="{CDC8A4CF-6457-499D-B445-2B8D35F5B030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A0FE1CCE-3AA2-41A0-B990-87BA96F2A630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33" name="グループ化 132">
            <a:extLst>
              <a:ext uri="{FF2B5EF4-FFF2-40B4-BE49-F238E27FC236}">
                <a16:creationId xmlns:a16="http://schemas.microsoft.com/office/drawing/2014/main" id="{5ABFFC1F-E66B-4AAD-857A-8DCA9D3EB8BB}"/>
              </a:ext>
            </a:extLst>
          </p:cNvPr>
          <p:cNvGrpSpPr/>
          <p:nvPr/>
        </p:nvGrpSpPr>
        <p:grpSpPr>
          <a:xfrm>
            <a:off x="3795835" y="6470939"/>
            <a:ext cx="284532" cy="307777"/>
            <a:chOff x="457932" y="1070247"/>
            <a:chExt cx="284532" cy="307777"/>
          </a:xfrm>
        </p:grpSpPr>
        <p:cxnSp>
          <p:nvCxnSpPr>
            <p:cNvPr id="134" name="直線コネクタ 133">
              <a:extLst>
                <a:ext uri="{FF2B5EF4-FFF2-40B4-BE49-F238E27FC236}">
                  <a16:creationId xmlns:a16="http://schemas.microsoft.com/office/drawing/2014/main" id="{C17CB7C3-C8E3-41D5-8F35-9BBD21FE9E0E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8364062C-64EE-43D2-B8A8-DADE192946E6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36" name="グループ化 135">
            <a:extLst>
              <a:ext uri="{FF2B5EF4-FFF2-40B4-BE49-F238E27FC236}">
                <a16:creationId xmlns:a16="http://schemas.microsoft.com/office/drawing/2014/main" id="{85DDAF95-6886-4864-BF3B-1C8789C37AC9}"/>
              </a:ext>
            </a:extLst>
          </p:cNvPr>
          <p:cNvGrpSpPr/>
          <p:nvPr/>
        </p:nvGrpSpPr>
        <p:grpSpPr>
          <a:xfrm>
            <a:off x="5270155" y="6411422"/>
            <a:ext cx="284532" cy="307777"/>
            <a:chOff x="457932" y="1070247"/>
            <a:chExt cx="284532" cy="307777"/>
          </a:xfrm>
        </p:grpSpPr>
        <p:cxnSp>
          <p:nvCxnSpPr>
            <p:cNvPr id="137" name="直線コネクタ 136">
              <a:extLst>
                <a:ext uri="{FF2B5EF4-FFF2-40B4-BE49-F238E27FC236}">
                  <a16:creationId xmlns:a16="http://schemas.microsoft.com/office/drawing/2014/main" id="{8843615A-C8E5-48A8-B419-F1A696C5EAB8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8721A5EE-1037-49C2-95C8-A75410DF04C9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39" name="グループ化 138">
            <a:extLst>
              <a:ext uri="{FF2B5EF4-FFF2-40B4-BE49-F238E27FC236}">
                <a16:creationId xmlns:a16="http://schemas.microsoft.com/office/drawing/2014/main" id="{0AD8AB61-3AB9-48BE-95CA-115AB1A8308C}"/>
              </a:ext>
            </a:extLst>
          </p:cNvPr>
          <p:cNvGrpSpPr/>
          <p:nvPr/>
        </p:nvGrpSpPr>
        <p:grpSpPr>
          <a:xfrm>
            <a:off x="5566568" y="6470938"/>
            <a:ext cx="284532" cy="307777"/>
            <a:chOff x="457932" y="1070247"/>
            <a:chExt cx="284532" cy="307777"/>
          </a:xfrm>
        </p:grpSpPr>
        <p:cxnSp>
          <p:nvCxnSpPr>
            <p:cNvPr id="140" name="直線コネクタ 139">
              <a:extLst>
                <a:ext uri="{FF2B5EF4-FFF2-40B4-BE49-F238E27FC236}">
                  <a16:creationId xmlns:a16="http://schemas.microsoft.com/office/drawing/2014/main" id="{0D4AD8A1-C4FE-45E4-9E56-37FE6941AD14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8B40D9DB-9876-433C-BC3C-C5F6EBF0C99E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42" name="グループ化 141">
            <a:extLst>
              <a:ext uri="{FF2B5EF4-FFF2-40B4-BE49-F238E27FC236}">
                <a16:creationId xmlns:a16="http://schemas.microsoft.com/office/drawing/2014/main" id="{606AA52D-F254-476F-96ED-D7C17FED4A8E}"/>
              </a:ext>
            </a:extLst>
          </p:cNvPr>
          <p:cNvGrpSpPr/>
          <p:nvPr/>
        </p:nvGrpSpPr>
        <p:grpSpPr>
          <a:xfrm>
            <a:off x="5861165" y="5436577"/>
            <a:ext cx="284532" cy="307777"/>
            <a:chOff x="457932" y="1070247"/>
            <a:chExt cx="284532" cy="307777"/>
          </a:xfrm>
        </p:grpSpPr>
        <p:cxnSp>
          <p:nvCxnSpPr>
            <p:cNvPr id="143" name="直線コネクタ 142">
              <a:extLst>
                <a:ext uri="{FF2B5EF4-FFF2-40B4-BE49-F238E27FC236}">
                  <a16:creationId xmlns:a16="http://schemas.microsoft.com/office/drawing/2014/main" id="{05FB4514-77CD-4481-AA88-32D1058454A1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F644F60F-A9F9-4A33-A006-90E27D366132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45" name="グループ化 144">
            <a:extLst>
              <a:ext uri="{FF2B5EF4-FFF2-40B4-BE49-F238E27FC236}">
                <a16:creationId xmlns:a16="http://schemas.microsoft.com/office/drawing/2014/main" id="{0D054503-5BE5-45CB-AB97-B712F32851AF}"/>
              </a:ext>
            </a:extLst>
          </p:cNvPr>
          <p:cNvGrpSpPr/>
          <p:nvPr/>
        </p:nvGrpSpPr>
        <p:grpSpPr>
          <a:xfrm>
            <a:off x="6291256" y="5541107"/>
            <a:ext cx="284532" cy="307777"/>
            <a:chOff x="457932" y="1070247"/>
            <a:chExt cx="284532" cy="307777"/>
          </a:xfrm>
        </p:grpSpPr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id="{9838A43B-5C24-4167-BE76-776E81810625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F584ABE8-83C6-4912-90D0-C56680C0D258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48" name="グループ化 147">
            <a:extLst>
              <a:ext uri="{FF2B5EF4-FFF2-40B4-BE49-F238E27FC236}">
                <a16:creationId xmlns:a16="http://schemas.microsoft.com/office/drawing/2014/main" id="{BB87A23F-814A-48D7-9369-1F95E5F81A89}"/>
              </a:ext>
            </a:extLst>
          </p:cNvPr>
          <p:cNvGrpSpPr/>
          <p:nvPr/>
        </p:nvGrpSpPr>
        <p:grpSpPr>
          <a:xfrm>
            <a:off x="1623542" y="8331549"/>
            <a:ext cx="284532" cy="307777"/>
            <a:chOff x="457932" y="1070247"/>
            <a:chExt cx="284532" cy="307777"/>
          </a:xfrm>
        </p:grpSpPr>
        <p:cxnSp>
          <p:nvCxnSpPr>
            <p:cNvPr id="149" name="直線コネクタ 148">
              <a:extLst>
                <a:ext uri="{FF2B5EF4-FFF2-40B4-BE49-F238E27FC236}">
                  <a16:creationId xmlns:a16="http://schemas.microsoft.com/office/drawing/2014/main" id="{A27ACE2C-5A59-49A4-80D6-8ABFE0E5FF24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D4EA6B4B-D10B-44CC-A769-6510F73E25AF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51" name="グループ化 150">
            <a:extLst>
              <a:ext uri="{FF2B5EF4-FFF2-40B4-BE49-F238E27FC236}">
                <a16:creationId xmlns:a16="http://schemas.microsoft.com/office/drawing/2014/main" id="{E6C89DEF-38FA-449F-A8CF-EB45347C2766}"/>
              </a:ext>
            </a:extLst>
          </p:cNvPr>
          <p:cNvGrpSpPr/>
          <p:nvPr/>
        </p:nvGrpSpPr>
        <p:grpSpPr>
          <a:xfrm>
            <a:off x="2067701" y="8287566"/>
            <a:ext cx="284532" cy="307777"/>
            <a:chOff x="457932" y="1070247"/>
            <a:chExt cx="284532" cy="307777"/>
          </a:xfrm>
        </p:grpSpPr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445471B3-7060-4EE9-BBC6-545F5F906BDD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67144DAF-9848-4FE6-BBBA-A3E101A80235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174734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80D6E20-AEBF-4E19-BCA8-31A8D33BC4B3}"/>
              </a:ext>
            </a:extLst>
          </p:cNvPr>
          <p:cNvSpPr txBox="1"/>
          <p:nvPr/>
        </p:nvSpPr>
        <p:spPr>
          <a:xfrm>
            <a:off x="1159200" y="180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Al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936BB6F-15AB-4A06-8BF4-923B78A3A93C}"/>
              </a:ext>
            </a:extLst>
          </p:cNvPr>
          <p:cNvSpPr txBox="1"/>
          <p:nvPr/>
        </p:nvSpPr>
        <p:spPr>
          <a:xfrm>
            <a:off x="4363200" y="180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Arg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0B119AD-2F94-4493-ADBB-D239FE58DBD0}"/>
              </a:ext>
            </a:extLst>
          </p:cNvPr>
          <p:cNvSpPr txBox="1"/>
          <p:nvPr/>
        </p:nvSpPr>
        <p:spPr>
          <a:xfrm>
            <a:off x="1159200" y="1872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Asp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85293D6-F698-4BCB-8868-F1CA96D40BFE}"/>
              </a:ext>
            </a:extLst>
          </p:cNvPr>
          <p:cNvSpPr txBox="1"/>
          <p:nvPr/>
        </p:nvSpPr>
        <p:spPr>
          <a:xfrm>
            <a:off x="4363200" y="1872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Asn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5696D07-D7A1-4597-BCBD-BACAFF6BE461}"/>
              </a:ext>
            </a:extLst>
          </p:cNvPr>
          <p:cNvSpPr txBox="1"/>
          <p:nvPr/>
        </p:nvSpPr>
        <p:spPr>
          <a:xfrm>
            <a:off x="1159200" y="3564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Cys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AB97BAF-174D-4048-A809-66042A946F94}"/>
              </a:ext>
            </a:extLst>
          </p:cNvPr>
          <p:cNvSpPr txBox="1"/>
          <p:nvPr/>
        </p:nvSpPr>
        <p:spPr>
          <a:xfrm>
            <a:off x="4363200" y="3564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Glu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8A0157D-6F86-4CAB-ACD5-84A938B2DCD0}"/>
              </a:ext>
            </a:extLst>
          </p:cNvPr>
          <p:cNvSpPr txBox="1"/>
          <p:nvPr/>
        </p:nvSpPr>
        <p:spPr>
          <a:xfrm>
            <a:off x="1159200" y="5436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Gl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98FAD4D-542E-458C-AC41-A32F994CC361}"/>
              </a:ext>
            </a:extLst>
          </p:cNvPr>
          <p:cNvSpPr txBox="1"/>
          <p:nvPr/>
        </p:nvSpPr>
        <p:spPr>
          <a:xfrm>
            <a:off x="4363200" y="5436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Gly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6E7567F-0C00-4539-9F83-6A0A1F9DF5D9}"/>
              </a:ext>
            </a:extLst>
          </p:cNvPr>
          <p:cNvSpPr txBox="1"/>
          <p:nvPr/>
        </p:nvSpPr>
        <p:spPr>
          <a:xfrm>
            <a:off x="1159200" y="7308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Pro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62CD250-077A-4428-A089-1375478EA556}"/>
              </a:ext>
            </a:extLst>
          </p:cNvPr>
          <p:cNvSpPr txBox="1"/>
          <p:nvPr/>
        </p:nvSpPr>
        <p:spPr>
          <a:xfrm>
            <a:off x="4363200" y="7308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Ser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10C3EAAD-76C7-43A6-8685-70769D4944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212371"/>
              </p:ext>
            </p:extLst>
          </p:nvPr>
        </p:nvGraphicFramePr>
        <p:xfrm>
          <a:off x="288000" y="3564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66F185E0-0D6B-492F-AD05-594BD13A2A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7143394"/>
              </p:ext>
            </p:extLst>
          </p:nvPr>
        </p:nvGraphicFramePr>
        <p:xfrm>
          <a:off x="3492000" y="180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A8EE009F-DEB1-4A42-9B9F-73EBF9D6CE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1532526"/>
              </p:ext>
            </p:extLst>
          </p:nvPr>
        </p:nvGraphicFramePr>
        <p:xfrm>
          <a:off x="288000" y="180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12270727-FAE2-4016-AC4B-2B73E7CBDB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5707769"/>
              </p:ext>
            </p:extLst>
          </p:nvPr>
        </p:nvGraphicFramePr>
        <p:xfrm>
          <a:off x="288000" y="1872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022EA8D2-7CA0-4B5F-AED9-03C844976D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5114353"/>
              </p:ext>
            </p:extLst>
          </p:nvPr>
        </p:nvGraphicFramePr>
        <p:xfrm>
          <a:off x="3492000" y="1872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7" name="グラフ 16">
            <a:extLst>
              <a:ext uri="{FF2B5EF4-FFF2-40B4-BE49-F238E27FC236}">
                <a16:creationId xmlns:a16="http://schemas.microsoft.com/office/drawing/2014/main" id="{04ED7C06-318D-46B2-AD5E-8226D6243B9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3430681"/>
              </p:ext>
            </p:extLst>
          </p:nvPr>
        </p:nvGraphicFramePr>
        <p:xfrm>
          <a:off x="3492000" y="3564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8" name="グラフ 17">
            <a:extLst>
              <a:ext uri="{FF2B5EF4-FFF2-40B4-BE49-F238E27FC236}">
                <a16:creationId xmlns:a16="http://schemas.microsoft.com/office/drawing/2014/main" id="{462B37B0-8ADB-4AB7-B6B5-6938C1E84B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1015896"/>
              </p:ext>
            </p:extLst>
          </p:nvPr>
        </p:nvGraphicFramePr>
        <p:xfrm>
          <a:off x="3492000" y="5436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28818920-7F7C-4CD2-9E26-6470C79C597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3324089"/>
              </p:ext>
            </p:extLst>
          </p:nvPr>
        </p:nvGraphicFramePr>
        <p:xfrm>
          <a:off x="288000" y="7308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6C852F27-CABF-4083-BAD9-6C85AC5E9D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4943839"/>
              </p:ext>
            </p:extLst>
          </p:nvPr>
        </p:nvGraphicFramePr>
        <p:xfrm>
          <a:off x="3492000" y="7308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A5B30FAE-A37E-47B9-BFEA-5DCD560572B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6029079"/>
              </p:ext>
            </p:extLst>
          </p:nvPr>
        </p:nvGraphicFramePr>
        <p:xfrm>
          <a:off x="288000" y="5436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EC33BE57-E09D-4C99-82F6-67274FD53703}"/>
              </a:ext>
            </a:extLst>
          </p:cNvPr>
          <p:cNvSpPr txBox="1"/>
          <p:nvPr/>
        </p:nvSpPr>
        <p:spPr>
          <a:xfrm rot="16200000">
            <a:off x="-634974" y="775258"/>
            <a:ext cx="1715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rum AAs [nmol/10 µL]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045D685-5832-4D1C-A9F8-FFCB28557BBD}"/>
              </a:ext>
            </a:extLst>
          </p:cNvPr>
          <p:cNvSpPr txBox="1"/>
          <p:nvPr/>
        </p:nvSpPr>
        <p:spPr>
          <a:xfrm rot="16200000">
            <a:off x="-634973" y="2474788"/>
            <a:ext cx="171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rum AAs [nmol/10 µL]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725D5A2-DCB1-43F5-B871-91E6EC763865}"/>
              </a:ext>
            </a:extLst>
          </p:cNvPr>
          <p:cNvSpPr txBox="1"/>
          <p:nvPr/>
        </p:nvSpPr>
        <p:spPr>
          <a:xfrm rot="16200000">
            <a:off x="-634972" y="4165608"/>
            <a:ext cx="171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rum AAs [nmol/10 µL]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571038F5-1352-434C-83B1-83A655A22271}"/>
              </a:ext>
            </a:extLst>
          </p:cNvPr>
          <p:cNvSpPr txBox="1"/>
          <p:nvPr/>
        </p:nvSpPr>
        <p:spPr>
          <a:xfrm rot="16200000">
            <a:off x="-634971" y="6030608"/>
            <a:ext cx="171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rum AAs [nmol/10 µL]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AD5292B9-4E22-4C9C-B6F4-B19DC626E783}"/>
              </a:ext>
            </a:extLst>
          </p:cNvPr>
          <p:cNvSpPr txBox="1"/>
          <p:nvPr/>
        </p:nvSpPr>
        <p:spPr>
          <a:xfrm rot="16200000">
            <a:off x="-616866" y="7931130"/>
            <a:ext cx="16795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rum AAs [nmol/10 µL]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25C8A6A9-709A-4C09-8AA4-D77AFBAB797B}"/>
              </a:ext>
            </a:extLst>
          </p:cNvPr>
          <p:cNvGrpSpPr/>
          <p:nvPr/>
        </p:nvGrpSpPr>
        <p:grpSpPr>
          <a:xfrm>
            <a:off x="594016" y="1189324"/>
            <a:ext cx="284532" cy="307777"/>
            <a:chOff x="457932" y="1070247"/>
            <a:chExt cx="284532" cy="307777"/>
          </a:xfrm>
        </p:grpSpPr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CFEE3FCB-E648-4CB6-A28F-671343E993D0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7EE5B09B-F9FC-4054-B7E8-E6E9065C5203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7B018EF1-28F6-45D8-86DC-09658F3B9EE0}"/>
              </a:ext>
            </a:extLst>
          </p:cNvPr>
          <p:cNvGrpSpPr/>
          <p:nvPr/>
        </p:nvGrpSpPr>
        <p:grpSpPr>
          <a:xfrm>
            <a:off x="1182085" y="1111973"/>
            <a:ext cx="284532" cy="307777"/>
            <a:chOff x="457932" y="1070247"/>
            <a:chExt cx="284532" cy="307777"/>
          </a:xfrm>
        </p:grpSpPr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EE200A35-D7F7-48FA-BD26-66BE8FEB9028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18D6C23C-C05F-44C3-AC49-8CEA073A033C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id="{7C774CFD-8D58-4FD3-A30F-2B732C2F47C8}"/>
              </a:ext>
            </a:extLst>
          </p:cNvPr>
          <p:cNvGrpSpPr/>
          <p:nvPr/>
        </p:nvGrpSpPr>
        <p:grpSpPr>
          <a:xfrm>
            <a:off x="2059986" y="1165988"/>
            <a:ext cx="284532" cy="307777"/>
            <a:chOff x="457932" y="1070247"/>
            <a:chExt cx="284532" cy="307777"/>
          </a:xfrm>
        </p:grpSpPr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6F01722B-0497-4EC3-A592-EA2682F5B194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E232C60C-9C2C-4913-879E-89D9F184EEDD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53" name="グループ化 52">
            <a:extLst>
              <a:ext uri="{FF2B5EF4-FFF2-40B4-BE49-F238E27FC236}">
                <a16:creationId xmlns:a16="http://schemas.microsoft.com/office/drawing/2014/main" id="{9CAB50AA-AB90-4483-B006-2BB7CF041A91}"/>
              </a:ext>
            </a:extLst>
          </p:cNvPr>
          <p:cNvGrpSpPr/>
          <p:nvPr/>
        </p:nvGrpSpPr>
        <p:grpSpPr>
          <a:xfrm>
            <a:off x="2653355" y="179378"/>
            <a:ext cx="284532" cy="307777"/>
            <a:chOff x="457932" y="1070247"/>
            <a:chExt cx="284532" cy="307777"/>
          </a:xfrm>
        </p:grpSpPr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C266A192-D807-4D54-A9F6-0E6AB622BDD5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60B4B82C-4C84-460E-8BD5-FA7A0A1D9CB2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035F0772-81BA-40B0-9BC4-057BBCF9D3B8}"/>
              </a:ext>
            </a:extLst>
          </p:cNvPr>
          <p:cNvGrpSpPr/>
          <p:nvPr/>
        </p:nvGrpSpPr>
        <p:grpSpPr>
          <a:xfrm>
            <a:off x="3095702" y="587696"/>
            <a:ext cx="284532" cy="307777"/>
            <a:chOff x="457932" y="1070247"/>
            <a:chExt cx="284532" cy="307777"/>
          </a:xfrm>
        </p:grpSpPr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0E082FD3-8E2D-45A6-89F1-3093F107476C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EFB50B94-F101-4932-9112-4D540E0D6D09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59" name="グループ化 58">
            <a:extLst>
              <a:ext uri="{FF2B5EF4-FFF2-40B4-BE49-F238E27FC236}">
                <a16:creationId xmlns:a16="http://schemas.microsoft.com/office/drawing/2014/main" id="{6029F2F8-AE8B-4253-83C2-103C363FBF4C}"/>
              </a:ext>
            </a:extLst>
          </p:cNvPr>
          <p:cNvGrpSpPr/>
          <p:nvPr/>
        </p:nvGrpSpPr>
        <p:grpSpPr>
          <a:xfrm>
            <a:off x="3707749" y="1205282"/>
            <a:ext cx="284532" cy="307777"/>
            <a:chOff x="457932" y="1070247"/>
            <a:chExt cx="284532" cy="307777"/>
          </a:xfrm>
        </p:grpSpPr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0EAAAD42-177D-429C-991B-35508009D421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AB95A8AB-F473-40C5-ACD2-A5FFEDB3F96B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62" name="グループ化 61">
            <a:extLst>
              <a:ext uri="{FF2B5EF4-FFF2-40B4-BE49-F238E27FC236}">
                <a16:creationId xmlns:a16="http://schemas.microsoft.com/office/drawing/2014/main" id="{8F983678-8001-4E33-80B4-3A9915342D8A}"/>
              </a:ext>
            </a:extLst>
          </p:cNvPr>
          <p:cNvGrpSpPr/>
          <p:nvPr/>
        </p:nvGrpSpPr>
        <p:grpSpPr>
          <a:xfrm>
            <a:off x="3845937" y="1204012"/>
            <a:ext cx="284532" cy="307777"/>
            <a:chOff x="457932" y="1070247"/>
            <a:chExt cx="284532" cy="307777"/>
          </a:xfrm>
        </p:grpSpPr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4B9DB430-A84A-4D17-9E5C-AD34F3287FD7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470DA1A0-38DF-464E-A198-A25356983817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52A926A7-E32C-4CCA-95F3-A820B01D8E42}"/>
              </a:ext>
            </a:extLst>
          </p:cNvPr>
          <p:cNvGrpSpPr/>
          <p:nvPr/>
        </p:nvGrpSpPr>
        <p:grpSpPr>
          <a:xfrm>
            <a:off x="5869027" y="87776"/>
            <a:ext cx="284532" cy="307777"/>
            <a:chOff x="457932" y="1070247"/>
            <a:chExt cx="284532" cy="307777"/>
          </a:xfrm>
        </p:grpSpPr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D2D39C82-3F94-478D-81E3-1CAE3C9FAAE7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0E55CFDD-13BF-4325-A504-F427A657C9F6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E60C1B94-A1C5-4338-A3EF-1E8D7DE2B908}"/>
              </a:ext>
            </a:extLst>
          </p:cNvPr>
          <p:cNvGrpSpPr/>
          <p:nvPr/>
        </p:nvGrpSpPr>
        <p:grpSpPr>
          <a:xfrm>
            <a:off x="3993756" y="533040"/>
            <a:ext cx="284532" cy="307777"/>
            <a:chOff x="457932" y="1070247"/>
            <a:chExt cx="284532" cy="307777"/>
          </a:xfrm>
        </p:grpSpPr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717708A5-07DD-498C-BFF3-79380416DFC4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02B80786-1FC2-4CAD-B836-379731493ACF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71" name="グループ化 70">
            <a:extLst>
              <a:ext uri="{FF2B5EF4-FFF2-40B4-BE49-F238E27FC236}">
                <a16:creationId xmlns:a16="http://schemas.microsoft.com/office/drawing/2014/main" id="{FE129425-72B0-4854-A6B6-C52678340571}"/>
              </a:ext>
            </a:extLst>
          </p:cNvPr>
          <p:cNvGrpSpPr/>
          <p:nvPr/>
        </p:nvGrpSpPr>
        <p:grpSpPr>
          <a:xfrm>
            <a:off x="4859545" y="1193193"/>
            <a:ext cx="284532" cy="307777"/>
            <a:chOff x="457932" y="1070247"/>
            <a:chExt cx="284532" cy="307777"/>
          </a:xfrm>
        </p:grpSpPr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43DB6353-2FA2-47FE-A973-FF8FB4A4D4F3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0D9F1ECE-825B-4E8B-9D71-CD2DDF6A629F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83" name="グループ化 82">
            <a:extLst>
              <a:ext uri="{FF2B5EF4-FFF2-40B4-BE49-F238E27FC236}">
                <a16:creationId xmlns:a16="http://schemas.microsoft.com/office/drawing/2014/main" id="{B493C62A-6AB7-4A0F-8648-8F68EB88A8C1}"/>
              </a:ext>
            </a:extLst>
          </p:cNvPr>
          <p:cNvGrpSpPr/>
          <p:nvPr/>
        </p:nvGrpSpPr>
        <p:grpSpPr>
          <a:xfrm>
            <a:off x="594016" y="2879621"/>
            <a:ext cx="284532" cy="307777"/>
            <a:chOff x="457932" y="1070247"/>
            <a:chExt cx="284532" cy="307777"/>
          </a:xfrm>
        </p:grpSpPr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973B2C71-0F07-4C92-8971-B5D84FB2C9BF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669B8223-B963-4D8B-AC73-3D32B729988E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id="{560F53B6-171D-4B47-BA54-20B10F4E05C2}"/>
              </a:ext>
            </a:extLst>
          </p:cNvPr>
          <p:cNvGrpSpPr/>
          <p:nvPr/>
        </p:nvGrpSpPr>
        <p:grpSpPr>
          <a:xfrm>
            <a:off x="2655949" y="1880747"/>
            <a:ext cx="284532" cy="307777"/>
            <a:chOff x="457932" y="1070247"/>
            <a:chExt cx="284532" cy="307777"/>
          </a:xfrm>
        </p:grpSpPr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6978EF84-A1A7-4311-90FB-95AFE6CB5EE7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D1AAD581-3924-47B9-85BF-723E81CCBFDF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92" name="グループ化 91">
            <a:extLst>
              <a:ext uri="{FF2B5EF4-FFF2-40B4-BE49-F238E27FC236}">
                <a16:creationId xmlns:a16="http://schemas.microsoft.com/office/drawing/2014/main" id="{ADCE02F3-9D19-4A7D-9FFE-2DCA4A6EF46D}"/>
              </a:ext>
            </a:extLst>
          </p:cNvPr>
          <p:cNvGrpSpPr/>
          <p:nvPr/>
        </p:nvGrpSpPr>
        <p:grpSpPr>
          <a:xfrm>
            <a:off x="3795302" y="2879620"/>
            <a:ext cx="284532" cy="307777"/>
            <a:chOff x="457932" y="1070247"/>
            <a:chExt cx="284532" cy="307777"/>
          </a:xfrm>
        </p:grpSpPr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FD978AD3-3174-4B55-964F-5C2BCB078436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A32DB561-F185-4BF7-B893-DB2DB6A713E3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95" name="グループ化 94">
            <a:extLst>
              <a:ext uri="{FF2B5EF4-FFF2-40B4-BE49-F238E27FC236}">
                <a16:creationId xmlns:a16="http://schemas.microsoft.com/office/drawing/2014/main" id="{29E4314E-86DC-4C42-974B-D5E780D5FB91}"/>
              </a:ext>
            </a:extLst>
          </p:cNvPr>
          <p:cNvGrpSpPr/>
          <p:nvPr/>
        </p:nvGrpSpPr>
        <p:grpSpPr>
          <a:xfrm>
            <a:off x="5267063" y="2848344"/>
            <a:ext cx="284532" cy="307777"/>
            <a:chOff x="457932" y="1070247"/>
            <a:chExt cx="284532" cy="307777"/>
          </a:xfrm>
        </p:grpSpPr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93FC3FA0-9348-4099-92F1-3F6B7791FC0A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488E95E4-B8C2-484B-825F-DA7B4D87B085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98" name="グループ化 97">
            <a:extLst>
              <a:ext uri="{FF2B5EF4-FFF2-40B4-BE49-F238E27FC236}">
                <a16:creationId xmlns:a16="http://schemas.microsoft.com/office/drawing/2014/main" id="{367A63A2-813D-4C22-9AEC-D1AB607DB419}"/>
              </a:ext>
            </a:extLst>
          </p:cNvPr>
          <p:cNvGrpSpPr/>
          <p:nvPr/>
        </p:nvGrpSpPr>
        <p:grpSpPr>
          <a:xfrm>
            <a:off x="5419463" y="2798187"/>
            <a:ext cx="284532" cy="307777"/>
            <a:chOff x="457932" y="1070247"/>
            <a:chExt cx="284532" cy="307777"/>
          </a:xfrm>
        </p:grpSpPr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C8717FAB-1F12-44CE-8ED4-6EE8C37FC024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820D8905-CA9D-40AF-B592-A4D43A2922F3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D969052C-CB0B-44FC-BB1B-5A236065A2EC}"/>
              </a:ext>
            </a:extLst>
          </p:cNvPr>
          <p:cNvGrpSpPr/>
          <p:nvPr/>
        </p:nvGrpSpPr>
        <p:grpSpPr>
          <a:xfrm>
            <a:off x="5860345" y="1880746"/>
            <a:ext cx="284532" cy="307777"/>
            <a:chOff x="457932" y="1070247"/>
            <a:chExt cx="284532" cy="307777"/>
          </a:xfrm>
        </p:grpSpPr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4D6EE254-58F4-4FFC-851D-352BCE5D98DB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CBCCC9DB-822D-4F97-9A68-CAB3EE7B70AC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F56C2973-127B-4312-A0DA-67C7EDD285E7}"/>
              </a:ext>
            </a:extLst>
          </p:cNvPr>
          <p:cNvGrpSpPr/>
          <p:nvPr/>
        </p:nvGrpSpPr>
        <p:grpSpPr>
          <a:xfrm>
            <a:off x="6299938" y="2133606"/>
            <a:ext cx="284532" cy="307777"/>
            <a:chOff x="457932" y="1070247"/>
            <a:chExt cx="284532" cy="307777"/>
          </a:xfrm>
        </p:grpSpPr>
        <p:cxnSp>
          <p:nvCxnSpPr>
            <p:cNvPr id="105" name="直線コネクタ 104">
              <a:extLst>
                <a:ext uri="{FF2B5EF4-FFF2-40B4-BE49-F238E27FC236}">
                  <a16:creationId xmlns:a16="http://schemas.microsoft.com/office/drawing/2014/main" id="{183326CE-29C4-4DA4-BA07-046392C17485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612E4952-F126-45EF-9B78-E7415C9682C0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07" name="グループ化 106">
            <a:extLst>
              <a:ext uri="{FF2B5EF4-FFF2-40B4-BE49-F238E27FC236}">
                <a16:creationId xmlns:a16="http://schemas.microsoft.com/office/drawing/2014/main" id="{3E3BF75D-AC66-465B-9F4B-5E436FDC2C04}"/>
              </a:ext>
            </a:extLst>
          </p:cNvPr>
          <p:cNvGrpSpPr/>
          <p:nvPr/>
        </p:nvGrpSpPr>
        <p:grpSpPr>
          <a:xfrm>
            <a:off x="1329665" y="4249394"/>
            <a:ext cx="284532" cy="307777"/>
            <a:chOff x="457932" y="1070247"/>
            <a:chExt cx="284532" cy="307777"/>
          </a:xfrm>
        </p:grpSpPr>
        <p:cxnSp>
          <p:nvCxnSpPr>
            <p:cNvPr id="108" name="直線コネクタ 107">
              <a:extLst>
                <a:ext uri="{FF2B5EF4-FFF2-40B4-BE49-F238E27FC236}">
                  <a16:creationId xmlns:a16="http://schemas.microsoft.com/office/drawing/2014/main" id="{1B1E65A2-F734-4A3E-80A5-8099B8162C2F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43240CE4-4402-4574-9E99-522C2A266204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16" name="グループ化 115">
            <a:extLst>
              <a:ext uri="{FF2B5EF4-FFF2-40B4-BE49-F238E27FC236}">
                <a16:creationId xmlns:a16="http://schemas.microsoft.com/office/drawing/2014/main" id="{ADCD02C9-114B-4544-AE83-1D7FE38F5F3A}"/>
              </a:ext>
            </a:extLst>
          </p:cNvPr>
          <p:cNvGrpSpPr/>
          <p:nvPr/>
        </p:nvGrpSpPr>
        <p:grpSpPr>
          <a:xfrm>
            <a:off x="3092808" y="3865397"/>
            <a:ext cx="284532" cy="307777"/>
            <a:chOff x="457932" y="1070247"/>
            <a:chExt cx="284532" cy="307777"/>
          </a:xfrm>
        </p:grpSpPr>
        <p:cxnSp>
          <p:nvCxnSpPr>
            <p:cNvPr id="117" name="直線コネクタ 116">
              <a:extLst>
                <a:ext uri="{FF2B5EF4-FFF2-40B4-BE49-F238E27FC236}">
                  <a16:creationId xmlns:a16="http://schemas.microsoft.com/office/drawing/2014/main" id="{D48D7C1C-48B1-4409-B947-0549E5690696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387B5143-B391-4CBD-AC5F-544D37138FE1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19" name="グループ化 118">
            <a:extLst>
              <a:ext uri="{FF2B5EF4-FFF2-40B4-BE49-F238E27FC236}">
                <a16:creationId xmlns:a16="http://schemas.microsoft.com/office/drawing/2014/main" id="{FE072822-ABBA-4327-BC98-66D13C50206D}"/>
              </a:ext>
            </a:extLst>
          </p:cNvPr>
          <p:cNvGrpSpPr/>
          <p:nvPr/>
        </p:nvGrpSpPr>
        <p:grpSpPr>
          <a:xfrm>
            <a:off x="2657865" y="3549726"/>
            <a:ext cx="284532" cy="307777"/>
            <a:chOff x="457932" y="1070247"/>
            <a:chExt cx="284532" cy="307777"/>
          </a:xfrm>
        </p:grpSpPr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id="{73BF845F-97AF-4E7B-AC7B-CB21A86E1C9A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979E9328-0A6C-4FC7-8804-4FB5CD00E6FC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25" name="グループ化 124">
            <a:extLst>
              <a:ext uri="{FF2B5EF4-FFF2-40B4-BE49-F238E27FC236}">
                <a16:creationId xmlns:a16="http://schemas.microsoft.com/office/drawing/2014/main" id="{4F6D9099-FC5C-4B70-8312-A00B90CA80FD}"/>
              </a:ext>
            </a:extLst>
          </p:cNvPr>
          <p:cNvGrpSpPr/>
          <p:nvPr/>
        </p:nvGrpSpPr>
        <p:grpSpPr>
          <a:xfrm>
            <a:off x="3801325" y="4594267"/>
            <a:ext cx="284532" cy="307777"/>
            <a:chOff x="457932" y="1070247"/>
            <a:chExt cx="284532" cy="307777"/>
          </a:xfrm>
        </p:grpSpPr>
        <p:cxnSp>
          <p:nvCxnSpPr>
            <p:cNvPr id="126" name="直線コネクタ 125">
              <a:extLst>
                <a:ext uri="{FF2B5EF4-FFF2-40B4-BE49-F238E27FC236}">
                  <a16:creationId xmlns:a16="http://schemas.microsoft.com/office/drawing/2014/main" id="{2D8E0DCA-D0A6-47F9-AD6C-6FC46566C0BA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BF9C923B-2535-4EFD-898D-1587A026AE2F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28" name="グループ化 127">
            <a:extLst>
              <a:ext uri="{FF2B5EF4-FFF2-40B4-BE49-F238E27FC236}">
                <a16:creationId xmlns:a16="http://schemas.microsoft.com/office/drawing/2014/main" id="{AE81C168-A2DB-4112-A62C-D148342B83FC}"/>
              </a:ext>
            </a:extLst>
          </p:cNvPr>
          <p:cNvGrpSpPr/>
          <p:nvPr/>
        </p:nvGrpSpPr>
        <p:grpSpPr>
          <a:xfrm>
            <a:off x="593233" y="6465224"/>
            <a:ext cx="284532" cy="307777"/>
            <a:chOff x="457932" y="1070247"/>
            <a:chExt cx="284532" cy="307777"/>
          </a:xfrm>
        </p:grpSpPr>
        <p:cxnSp>
          <p:nvCxnSpPr>
            <p:cNvPr id="129" name="直線コネクタ 128">
              <a:extLst>
                <a:ext uri="{FF2B5EF4-FFF2-40B4-BE49-F238E27FC236}">
                  <a16:creationId xmlns:a16="http://schemas.microsoft.com/office/drawing/2014/main" id="{C605B64D-9371-4860-8119-DE2CE09A406E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DCF8F3D6-54CF-4F4A-A87C-12660CF25724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31" name="グループ化 130">
            <a:extLst>
              <a:ext uri="{FF2B5EF4-FFF2-40B4-BE49-F238E27FC236}">
                <a16:creationId xmlns:a16="http://schemas.microsoft.com/office/drawing/2014/main" id="{0828DDEA-14C2-40F3-BEC3-9F3093781B37}"/>
              </a:ext>
            </a:extLst>
          </p:cNvPr>
          <p:cNvGrpSpPr/>
          <p:nvPr/>
        </p:nvGrpSpPr>
        <p:grpSpPr>
          <a:xfrm>
            <a:off x="2065883" y="6427660"/>
            <a:ext cx="284532" cy="307777"/>
            <a:chOff x="457932" y="1070247"/>
            <a:chExt cx="284532" cy="307777"/>
          </a:xfrm>
        </p:grpSpPr>
        <p:cxnSp>
          <p:nvCxnSpPr>
            <p:cNvPr id="132" name="直線コネクタ 131">
              <a:extLst>
                <a:ext uri="{FF2B5EF4-FFF2-40B4-BE49-F238E27FC236}">
                  <a16:creationId xmlns:a16="http://schemas.microsoft.com/office/drawing/2014/main" id="{6A103976-46EC-47EB-9131-1AF2EB5FB415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7BE20DBD-FD2B-4AF0-85CB-B2CEA448FAF9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34" name="グループ化 133">
            <a:extLst>
              <a:ext uri="{FF2B5EF4-FFF2-40B4-BE49-F238E27FC236}">
                <a16:creationId xmlns:a16="http://schemas.microsoft.com/office/drawing/2014/main" id="{E2662D5B-E397-4C67-A6A3-25EC765115CD}"/>
              </a:ext>
            </a:extLst>
          </p:cNvPr>
          <p:cNvGrpSpPr/>
          <p:nvPr/>
        </p:nvGrpSpPr>
        <p:grpSpPr>
          <a:xfrm>
            <a:off x="2213700" y="6358084"/>
            <a:ext cx="284532" cy="307777"/>
            <a:chOff x="457932" y="1070247"/>
            <a:chExt cx="284532" cy="307777"/>
          </a:xfrm>
        </p:grpSpPr>
        <p:cxnSp>
          <p:nvCxnSpPr>
            <p:cNvPr id="135" name="直線コネクタ 134">
              <a:extLst>
                <a:ext uri="{FF2B5EF4-FFF2-40B4-BE49-F238E27FC236}">
                  <a16:creationId xmlns:a16="http://schemas.microsoft.com/office/drawing/2014/main" id="{D069CA60-C448-48F0-86B3-4FF79CD7DFAE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4FD6811D-44B2-4046-8C7B-C39BECADEE49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37" name="グループ化 136">
            <a:extLst>
              <a:ext uri="{FF2B5EF4-FFF2-40B4-BE49-F238E27FC236}">
                <a16:creationId xmlns:a16="http://schemas.microsoft.com/office/drawing/2014/main" id="{63CD7A65-6995-45BC-A84A-3D26237FEA12}"/>
              </a:ext>
            </a:extLst>
          </p:cNvPr>
          <p:cNvGrpSpPr/>
          <p:nvPr/>
        </p:nvGrpSpPr>
        <p:grpSpPr>
          <a:xfrm>
            <a:off x="2653315" y="5439620"/>
            <a:ext cx="284532" cy="307777"/>
            <a:chOff x="457932" y="1070247"/>
            <a:chExt cx="284532" cy="307777"/>
          </a:xfrm>
        </p:grpSpPr>
        <p:cxnSp>
          <p:nvCxnSpPr>
            <p:cNvPr id="138" name="直線コネクタ 137">
              <a:extLst>
                <a:ext uri="{FF2B5EF4-FFF2-40B4-BE49-F238E27FC236}">
                  <a16:creationId xmlns:a16="http://schemas.microsoft.com/office/drawing/2014/main" id="{AC563115-8AE2-4BE5-A26F-CE34E8547D0C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71A0F74B-59B2-4A83-9A48-25A155C094E5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40" name="グループ化 139">
            <a:extLst>
              <a:ext uri="{FF2B5EF4-FFF2-40B4-BE49-F238E27FC236}">
                <a16:creationId xmlns:a16="http://schemas.microsoft.com/office/drawing/2014/main" id="{9002E472-5AF5-4E31-8639-DFF5900A5D08}"/>
              </a:ext>
            </a:extLst>
          </p:cNvPr>
          <p:cNvGrpSpPr/>
          <p:nvPr/>
        </p:nvGrpSpPr>
        <p:grpSpPr>
          <a:xfrm>
            <a:off x="3798661" y="6466680"/>
            <a:ext cx="284532" cy="307777"/>
            <a:chOff x="457932" y="1070247"/>
            <a:chExt cx="284532" cy="307777"/>
          </a:xfrm>
        </p:grpSpPr>
        <p:cxnSp>
          <p:nvCxnSpPr>
            <p:cNvPr id="141" name="直線コネクタ 140">
              <a:extLst>
                <a:ext uri="{FF2B5EF4-FFF2-40B4-BE49-F238E27FC236}">
                  <a16:creationId xmlns:a16="http://schemas.microsoft.com/office/drawing/2014/main" id="{4573BACB-D6DF-46C1-8293-2A810A357535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98D002AC-CD5F-48E3-9E0C-9708E59DBDCA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43" name="グループ化 142">
            <a:extLst>
              <a:ext uri="{FF2B5EF4-FFF2-40B4-BE49-F238E27FC236}">
                <a16:creationId xmlns:a16="http://schemas.microsoft.com/office/drawing/2014/main" id="{0EA20EB2-628A-450E-95CC-1B2B9F5C2B0D}"/>
              </a:ext>
            </a:extLst>
          </p:cNvPr>
          <p:cNvGrpSpPr/>
          <p:nvPr/>
        </p:nvGrpSpPr>
        <p:grpSpPr>
          <a:xfrm>
            <a:off x="4383096" y="6385656"/>
            <a:ext cx="284532" cy="307777"/>
            <a:chOff x="457932" y="1070247"/>
            <a:chExt cx="284532" cy="307777"/>
          </a:xfrm>
        </p:grpSpPr>
        <p:cxnSp>
          <p:nvCxnSpPr>
            <p:cNvPr id="144" name="直線コネクタ 143">
              <a:extLst>
                <a:ext uri="{FF2B5EF4-FFF2-40B4-BE49-F238E27FC236}">
                  <a16:creationId xmlns:a16="http://schemas.microsoft.com/office/drawing/2014/main" id="{87754A52-632F-4BEF-9473-E241A1356B05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3FB611A4-284B-428B-95C2-E516720E5FEA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46" name="グループ化 145">
            <a:extLst>
              <a:ext uri="{FF2B5EF4-FFF2-40B4-BE49-F238E27FC236}">
                <a16:creationId xmlns:a16="http://schemas.microsoft.com/office/drawing/2014/main" id="{1881926B-6832-4D31-9368-563E91A96B60}"/>
              </a:ext>
            </a:extLst>
          </p:cNvPr>
          <p:cNvGrpSpPr/>
          <p:nvPr/>
        </p:nvGrpSpPr>
        <p:grpSpPr>
          <a:xfrm>
            <a:off x="4825247" y="6468209"/>
            <a:ext cx="284532" cy="307777"/>
            <a:chOff x="457932" y="1070247"/>
            <a:chExt cx="284532" cy="307777"/>
          </a:xfrm>
        </p:grpSpPr>
        <p:cxnSp>
          <p:nvCxnSpPr>
            <p:cNvPr id="147" name="直線コネクタ 146">
              <a:extLst>
                <a:ext uri="{FF2B5EF4-FFF2-40B4-BE49-F238E27FC236}">
                  <a16:creationId xmlns:a16="http://schemas.microsoft.com/office/drawing/2014/main" id="{995CA756-5F77-4410-8D9A-482ADEF78E34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629B96C1-D8EB-4157-97BA-2D20680A7828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49" name="グループ化 148">
            <a:extLst>
              <a:ext uri="{FF2B5EF4-FFF2-40B4-BE49-F238E27FC236}">
                <a16:creationId xmlns:a16="http://schemas.microsoft.com/office/drawing/2014/main" id="{48E9DBE3-14FA-4BCE-856E-164C91C266E9}"/>
              </a:ext>
            </a:extLst>
          </p:cNvPr>
          <p:cNvGrpSpPr/>
          <p:nvPr/>
        </p:nvGrpSpPr>
        <p:grpSpPr>
          <a:xfrm>
            <a:off x="5414296" y="6369384"/>
            <a:ext cx="284532" cy="307777"/>
            <a:chOff x="457932" y="1070247"/>
            <a:chExt cx="284532" cy="307777"/>
          </a:xfrm>
        </p:grpSpPr>
        <p:cxnSp>
          <p:nvCxnSpPr>
            <p:cNvPr id="150" name="直線コネクタ 149">
              <a:extLst>
                <a:ext uri="{FF2B5EF4-FFF2-40B4-BE49-F238E27FC236}">
                  <a16:creationId xmlns:a16="http://schemas.microsoft.com/office/drawing/2014/main" id="{10AB0604-C290-40AA-B5A7-25D25103BB8E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F47FFA31-2CDD-4B16-B117-800B9996C92B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52" name="グループ化 151">
            <a:extLst>
              <a:ext uri="{FF2B5EF4-FFF2-40B4-BE49-F238E27FC236}">
                <a16:creationId xmlns:a16="http://schemas.microsoft.com/office/drawing/2014/main" id="{402651F5-712A-49C2-8045-2EBECD930C9C}"/>
              </a:ext>
            </a:extLst>
          </p:cNvPr>
          <p:cNvGrpSpPr/>
          <p:nvPr/>
        </p:nvGrpSpPr>
        <p:grpSpPr>
          <a:xfrm>
            <a:off x="5860345" y="5440383"/>
            <a:ext cx="284532" cy="307777"/>
            <a:chOff x="457932" y="1070247"/>
            <a:chExt cx="284532" cy="307777"/>
          </a:xfrm>
        </p:grpSpPr>
        <p:cxnSp>
          <p:nvCxnSpPr>
            <p:cNvPr id="153" name="直線コネクタ 152">
              <a:extLst>
                <a:ext uri="{FF2B5EF4-FFF2-40B4-BE49-F238E27FC236}">
                  <a16:creationId xmlns:a16="http://schemas.microsoft.com/office/drawing/2014/main" id="{F57EA172-F089-48FD-83BE-2E7204980E04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AE7517EC-97D6-4AA6-8212-06B281D84AA9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55" name="グループ化 154">
            <a:extLst>
              <a:ext uri="{FF2B5EF4-FFF2-40B4-BE49-F238E27FC236}">
                <a16:creationId xmlns:a16="http://schemas.microsoft.com/office/drawing/2014/main" id="{FABAA293-CDF2-45CD-B779-8C00AD8929C1}"/>
              </a:ext>
            </a:extLst>
          </p:cNvPr>
          <p:cNvGrpSpPr/>
          <p:nvPr/>
        </p:nvGrpSpPr>
        <p:grpSpPr>
          <a:xfrm>
            <a:off x="1326771" y="7982111"/>
            <a:ext cx="284532" cy="307777"/>
            <a:chOff x="457932" y="1070247"/>
            <a:chExt cx="284532" cy="307777"/>
          </a:xfrm>
        </p:grpSpPr>
        <p:cxnSp>
          <p:nvCxnSpPr>
            <p:cNvPr id="156" name="直線コネクタ 155">
              <a:extLst>
                <a:ext uri="{FF2B5EF4-FFF2-40B4-BE49-F238E27FC236}">
                  <a16:creationId xmlns:a16="http://schemas.microsoft.com/office/drawing/2014/main" id="{9D42EE3B-D328-4D4A-8976-00B478174A47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A57B9964-0BFA-4615-BA67-D85F5F315F3A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58" name="グループ化 157">
            <a:extLst>
              <a:ext uri="{FF2B5EF4-FFF2-40B4-BE49-F238E27FC236}">
                <a16:creationId xmlns:a16="http://schemas.microsoft.com/office/drawing/2014/main" id="{7E199131-29EA-4CBA-B148-D0358CEFDB54}"/>
              </a:ext>
            </a:extLst>
          </p:cNvPr>
          <p:cNvGrpSpPr/>
          <p:nvPr/>
        </p:nvGrpSpPr>
        <p:grpSpPr>
          <a:xfrm>
            <a:off x="2064163" y="8295676"/>
            <a:ext cx="284532" cy="307777"/>
            <a:chOff x="457932" y="1070247"/>
            <a:chExt cx="284532" cy="307777"/>
          </a:xfrm>
        </p:grpSpPr>
        <p:cxnSp>
          <p:nvCxnSpPr>
            <p:cNvPr id="159" name="直線コネクタ 158">
              <a:extLst>
                <a:ext uri="{FF2B5EF4-FFF2-40B4-BE49-F238E27FC236}">
                  <a16:creationId xmlns:a16="http://schemas.microsoft.com/office/drawing/2014/main" id="{4F3E5291-3A0B-4D6F-823B-1D237AC04099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90229A0B-2EF3-455A-84C1-2877C591E817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61" name="グループ化 160">
            <a:extLst>
              <a:ext uri="{FF2B5EF4-FFF2-40B4-BE49-F238E27FC236}">
                <a16:creationId xmlns:a16="http://schemas.microsoft.com/office/drawing/2014/main" id="{1F9EC66D-64C8-49F5-8BE9-0540CED91246}"/>
              </a:ext>
            </a:extLst>
          </p:cNvPr>
          <p:cNvGrpSpPr/>
          <p:nvPr/>
        </p:nvGrpSpPr>
        <p:grpSpPr>
          <a:xfrm>
            <a:off x="2652608" y="7305530"/>
            <a:ext cx="284532" cy="307777"/>
            <a:chOff x="457932" y="1070247"/>
            <a:chExt cx="284532" cy="307777"/>
          </a:xfrm>
        </p:grpSpPr>
        <p:cxnSp>
          <p:nvCxnSpPr>
            <p:cNvPr id="162" name="直線コネクタ 161">
              <a:extLst>
                <a:ext uri="{FF2B5EF4-FFF2-40B4-BE49-F238E27FC236}">
                  <a16:creationId xmlns:a16="http://schemas.microsoft.com/office/drawing/2014/main" id="{1C2152C7-38F8-488E-BF77-B8F5AD19A271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E65AA699-B9EE-4AB6-87FE-2B0278AC64A3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64" name="グループ化 163">
            <a:extLst>
              <a:ext uri="{FF2B5EF4-FFF2-40B4-BE49-F238E27FC236}">
                <a16:creationId xmlns:a16="http://schemas.microsoft.com/office/drawing/2014/main" id="{3C8CAA87-082D-4C58-BEFE-602476BA0652}"/>
              </a:ext>
            </a:extLst>
          </p:cNvPr>
          <p:cNvGrpSpPr/>
          <p:nvPr/>
        </p:nvGrpSpPr>
        <p:grpSpPr>
          <a:xfrm>
            <a:off x="3793899" y="8331930"/>
            <a:ext cx="284532" cy="307777"/>
            <a:chOff x="457932" y="1070247"/>
            <a:chExt cx="284532" cy="307777"/>
          </a:xfrm>
        </p:grpSpPr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9B89B03D-5485-41D0-BC4E-10F97C2DA566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C974D9E4-A10D-4D61-B6EC-2706F8F12AC7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67" name="グループ化 166">
            <a:extLst>
              <a:ext uri="{FF2B5EF4-FFF2-40B4-BE49-F238E27FC236}">
                <a16:creationId xmlns:a16="http://schemas.microsoft.com/office/drawing/2014/main" id="{A6F43B5F-C809-4AC5-BAB9-FD0B0439EBDF}"/>
              </a:ext>
            </a:extLst>
          </p:cNvPr>
          <p:cNvGrpSpPr/>
          <p:nvPr/>
        </p:nvGrpSpPr>
        <p:grpSpPr>
          <a:xfrm>
            <a:off x="5268121" y="8282736"/>
            <a:ext cx="284532" cy="307777"/>
            <a:chOff x="457932" y="1070247"/>
            <a:chExt cx="284532" cy="307777"/>
          </a:xfrm>
        </p:grpSpPr>
        <p:cxnSp>
          <p:nvCxnSpPr>
            <p:cNvPr id="168" name="直線コネクタ 167">
              <a:extLst>
                <a:ext uri="{FF2B5EF4-FFF2-40B4-BE49-F238E27FC236}">
                  <a16:creationId xmlns:a16="http://schemas.microsoft.com/office/drawing/2014/main" id="{99A91EEB-F960-4E42-82EA-E8F1358F808B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C849790A-C577-4227-ACD8-D8D7465B97C2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70" name="グループ化 169">
            <a:extLst>
              <a:ext uri="{FF2B5EF4-FFF2-40B4-BE49-F238E27FC236}">
                <a16:creationId xmlns:a16="http://schemas.microsoft.com/office/drawing/2014/main" id="{57CB9FF6-10FB-49CF-B319-8BA742032A2E}"/>
              </a:ext>
            </a:extLst>
          </p:cNvPr>
          <p:cNvGrpSpPr/>
          <p:nvPr/>
        </p:nvGrpSpPr>
        <p:grpSpPr>
          <a:xfrm>
            <a:off x="5857451" y="7311945"/>
            <a:ext cx="284532" cy="307777"/>
            <a:chOff x="457932" y="1070247"/>
            <a:chExt cx="284532" cy="307777"/>
          </a:xfrm>
        </p:grpSpPr>
        <p:cxnSp>
          <p:nvCxnSpPr>
            <p:cNvPr id="171" name="直線コネクタ 170">
              <a:extLst>
                <a:ext uri="{FF2B5EF4-FFF2-40B4-BE49-F238E27FC236}">
                  <a16:creationId xmlns:a16="http://schemas.microsoft.com/office/drawing/2014/main" id="{C020D022-06C6-4C14-85BF-2979BAFD79A0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AD6A48EC-3EEA-4A02-B13E-45BC9E556739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73" name="グループ化 172">
            <a:extLst>
              <a:ext uri="{FF2B5EF4-FFF2-40B4-BE49-F238E27FC236}">
                <a16:creationId xmlns:a16="http://schemas.microsoft.com/office/drawing/2014/main" id="{700680B4-1FB1-4D0D-BD1D-24216D8786BF}"/>
              </a:ext>
            </a:extLst>
          </p:cNvPr>
          <p:cNvGrpSpPr/>
          <p:nvPr/>
        </p:nvGrpSpPr>
        <p:grpSpPr>
          <a:xfrm>
            <a:off x="6300279" y="7797119"/>
            <a:ext cx="284532" cy="307777"/>
            <a:chOff x="457932" y="1070247"/>
            <a:chExt cx="284532" cy="307777"/>
          </a:xfrm>
        </p:grpSpPr>
        <p:cxnSp>
          <p:nvCxnSpPr>
            <p:cNvPr id="174" name="直線コネクタ 173">
              <a:extLst>
                <a:ext uri="{FF2B5EF4-FFF2-40B4-BE49-F238E27FC236}">
                  <a16:creationId xmlns:a16="http://schemas.microsoft.com/office/drawing/2014/main" id="{351CA7F7-C0A9-4578-AB84-7C9CE122F2A3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D8A4C527-6C4C-45BF-ADAD-B80AF36C7825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E16D9000-A010-4020-81A0-CE930FE0A424}"/>
              </a:ext>
            </a:extLst>
          </p:cNvPr>
          <p:cNvSpPr txBox="1"/>
          <p:nvPr/>
        </p:nvSpPr>
        <p:spPr>
          <a:xfrm>
            <a:off x="384871" y="9194306"/>
            <a:ext cx="6088258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Rat serum amino acid concentration, related to Figure 1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ontinues to the next page.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56480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87522F23-D69D-42D7-A6B9-E16FC1208B3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4820337"/>
              </p:ext>
            </p:extLst>
          </p:nvPr>
        </p:nvGraphicFramePr>
        <p:xfrm>
          <a:off x="288000" y="180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EAA02E7A-A62B-447A-981A-53EE1223499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34453925"/>
              </p:ext>
            </p:extLst>
          </p:nvPr>
        </p:nvGraphicFramePr>
        <p:xfrm>
          <a:off x="3492000" y="180000"/>
          <a:ext cx="3312000" cy="165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8A21133-D214-4828-BF70-7C180AC95270}"/>
              </a:ext>
            </a:extLst>
          </p:cNvPr>
          <p:cNvSpPr txBox="1"/>
          <p:nvPr/>
        </p:nvSpPr>
        <p:spPr>
          <a:xfrm>
            <a:off x="1160228" y="180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ΔTyr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FAE1F67-9CFB-44BA-A9CD-CC6BFD3EE3E1}"/>
              </a:ext>
            </a:extLst>
          </p:cNvPr>
          <p:cNvSpPr txBox="1"/>
          <p:nvPr/>
        </p:nvSpPr>
        <p:spPr>
          <a:xfrm>
            <a:off x="4364229" y="180000"/>
            <a:ext cx="1567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A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FE81998-CF0F-4C15-A16B-F02D9D75AD25}"/>
              </a:ext>
            </a:extLst>
          </p:cNvPr>
          <p:cNvSpPr txBox="1"/>
          <p:nvPr/>
        </p:nvSpPr>
        <p:spPr>
          <a:xfrm rot="16200000">
            <a:off x="-634974" y="775258"/>
            <a:ext cx="17157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rum AAs [nmol/10 µL]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9AE2584-7337-4C50-AF3E-593184CD4128}"/>
              </a:ext>
            </a:extLst>
          </p:cNvPr>
          <p:cNvSpPr txBox="1"/>
          <p:nvPr/>
        </p:nvSpPr>
        <p:spPr>
          <a:xfrm>
            <a:off x="295600" y="2062743"/>
            <a:ext cx="6297310" cy="761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Rat serum amino acid concentration, related to Figure 1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erum of rats used in Figure 1 was collected and amino acid concentrations were measured by LC-MS/MS.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[bar graph: means ±</a:t>
            </a:r>
            <a:r>
              <a:rPr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EM, *</a:t>
            </a: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&lt; 0.05, Student’s T test, n=3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AA4CC355-BBB4-415D-AE43-0E6EDB932201}"/>
              </a:ext>
            </a:extLst>
          </p:cNvPr>
          <p:cNvGrpSpPr/>
          <p:nvPr/>
        </p:nvGrpSpPr>
        <p:grpSpPr>
          <a:xfrm>
            <a:off x="593484" y="1206689"/>
            <a:ext cx="284532" cy="307777"/>
            <a:chOff x="457932" y="1070247"/>
            <a:chExt cx="284532" cy="307777"/>
          </a:xfrm>
        </p:grpSpPr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3CB5E81D-1E7C-43C3-A8E1-08700CE58EC0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A60429F0-0B6B-4FDF-8272-B3F5BE73B07F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25E0541E-2C0D-4B3D-BD4C-8548B3FA5F00}"/>
              </a:ext>
            </a:extLst>
          </p:cNvPr>
          <p:cNvGrpSpPr/>
          <p:nvPr/>
        </p:nvGrpSpPr>
        <p:grpSpPr>
          <a:xfrm>
            <a:off x="1328640" y="848323"/>
            <a:ext cx="284532" cy="307777"/>
            <a:chOff x="457932" y="1070247"/>
            <a:chExt cx="284532" cy="307777"/>
          </a:xfrm>
        </p:grpSpPr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8B2988E7-7862-46B0-8505-4A7A52B0BE73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3F0B9260-AF11-49E5-9338-5B686AF0B372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FDA52D2B-5B18-4EC9-B022-F35DC6182DF9}"/>
              </a:ext>
            </a:extLst>
          </p:cNvPr>
          <p:cNvGrpSpPr/>
          <p:nvPr/>
        </p:nvGrpSpPr>
        <p:grpSpPr>
          <a:xfrm>
            <a:off x="2061900" y="1170207"/>
            <a:ext cx="284532" cy="307777"/>
            <a:chOff x="457932" y="1070247"/>
            <a:chExt cx="284532" cy="307777"/>
          </a:xfrm>
        </p:grpSpPr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91D5B45C-6268-4DD4-9D12-E8E9F14A7873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897C4726-3B64-48D4-8CB3-E771290EAABC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8C2388C1-7EDB-4F84-A733-5DDA14C97F1D}"/>
              </a:ext>
            </a:extLst>
          </p:cNvPr>
          <p:cNvGrpSpPr/>
          <p:nvPr/>
        </p:nvGrpSpPr>
        <p:grpSpPr>
          <a:xfrm>
            <a:off x="3996450" y="663134"/>
            <a:ext cx="284532" cy="307777"/>
            <a:chOff x="457932" y="1070247"/>
            <a:chExt cx="284532" cy="307777"/>
          </a:xfrm>
        </p:grpSpPr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EA013F71-E13E-4DC9-B9C5-20D418D22EDF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E36AA329-1481-45DF-A94A-BAB62D0AD9CE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0D550029-3718-4509-9442-6B4BB9151D05}"/>
              </a:ext>
            </a:extLst>
          </p:cNvPr>
          <p:cNvGrpSpPr/>
          <p:nvPr/>
        </p:nvGrpSpPr>
        <p:grpSpPr>
          <a:xfrm>
            <a:off x="4573214" y="965123"/>
            <a:ext cx="284532" cy="307777"/>
            <a:chOff x="457932" y="1070247"/>
            <a:chExt cx="284532" cy="307777"/>
          </a:xfrm>
        </p:grpSpPr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8EFAD7DF-37CE-4284-916C-6E0771FFF685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0D0A1A88-05F5-4E87-8FE2-6A8B5BA71439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2ED41A28-2BC6-4049-B0D3-B413561A874D}"/>
              </a:ext>
            </a:extLst>
          </p:cNvPr>
          <p:cNvGrpSpPr/>
          <p:nvPr/>
        </p:nvGrpSpPr>
        <p:grpSpPr>
          <a:xfrm>
            <a:off x="4860574" y="1218262"/>
            <a:ext cx="284532" cy="307777"/>
            <a:chOff x="457932" y="1070247"/>
            <a:chExt cx="284532" cy="307777"/>
          </a:xfrm>
        </p:grpSpPr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DA023269-C91E-4E03-BDBA-91131096FA23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32679AE8-7F42-4624-805A-3BA6D6811AAD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7F86F574-E455-47C2-B25F-6E41740FA3A1}"/>
              </a:ext>
            </a:extLst>
          </p:cNvPr>
          <p:cNvGrpSpPr/>
          <p:nvPr/>
        </p:nvGrpSpPr>
        <p:grpSpPr>
          <a:xfrm>
            <a:off x="5289440" y="1164787"/>
            <a:ext cx="284532" cy="307777"/>
            <a:chOff x="457932" y="1070247"/>
            <a:chExt cx="284532" cy="307777"/>
          </a:xfrm>
        </p:grpSpPr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767F4A15-549A-4109-ADE5-8E31DB49E786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E16AC041-CDE0-4307-AE7F-E75C14D7D2A2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EB53D099-4548-4EEB-9109-F782DCCAF71A}"/>
              </a:ext>
            </a:extLst>
          </p:cNvPr>
          <p:cNvGrpSpPr/>
          <p:nvPr/>
        </p:nvGrpSpPr>
        <p:grpSpPr>
          <a:xfrm>
            <a:off x="6014650" y="787336"/>
            <a:ext cx="284532" cy="307777"/>
            <a:chOff x="457932" y="1070247"/>
            <a:chExt cx="284532" cy="307777"/>
          </a:xfrm>
        </p:grpSpPr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98CC5E46-E351-46BF-B32E-0B7A7A81F703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35CBCBD9-F412-4702-8C13-5DBFF8C6904C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B8582F0D-BFFC-44FC-8264-12CE92365F81}"/>
              </a:ext>
            </a:extLst>
          </p:cNvPr>
          <p:cNvGrpSpPr/>
          <p:nvPr/>
        </p:nvGrpSpPr>
        <p:grpSpPr>
          <a:xfrm>
            <a:off x="6294232" y="96320"/>
            <a:ext cx="284532" cy="307777"/>
            <a:chOff x="457932" y="1070247"/>
            <a:chExt cx="284532" cy="307777"/>
          </a:xfrm>
        </p:grpSpPr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30ABA08F-F5D5-427F-82C7-639B473477E8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19178CCB-8EBF-4BD5-893B-90F9CF9DC81E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78EF8844-3B9F-4C4A-845F-9D7B030ACA52}"/>
              </a:ext>
            </a:extLst>
          </p:cNvPr>
          <p:cNvGrpSpPr/>
          <p:nvPr/>
        </p:nvGrpSpPr>
        <p:grpSpPr>
          <a:xfrm>
            <a:off x="6450644" y="1137538"/>
            <a:ext cx="284532" cy="307777"/>
            <a:chOff x="457932" y="1070247"/>
            <a:chExt cx="284532" cy="307777"/>
          </a:xfrm>
        </p:grpSpPr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0778DE4F-4149-45F6-8173-898BF799092E}"/>
                </a:ext>
              </a:extLst>
            </p:cNvPr>
            <p:cNvCxnSpPr>
              <a:cxnSpLocks/>
            </p:cNvCxnSpPr>
            <p:nvPr/>
          </p:nvCxnSpPr>
          <p:spPr>
            <a:xfrm>
              <a:off x="549798" y="1251708"/>
              <a:ext cx="100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554F2A88-B09A-4EA2-BCBA-B051C470437B}"/>
                </a:ext>
              </a:extLst>
            </p:cNvPr>
            <p:cNvSpPr txBox="1"/>
            <p:nvPr/>
          </p:nvSpPr>
          <p:spPr>
            <a:xfrm>
              <a:off x="457932" y="1070247"/>
              <a:ext cx="284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39814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5972937-EBDF-4C34-A278-93405751A64F}"/>
              </a:ext>
            </a:extLst>
          </p:cNvPr>
          <p:cNvSpPr txBox="1"/>
          <p:nvPr/>
        </p:nvSpPr>
        <p:spPr>
          <a:xfrm>
            <a:off x="383073" y="4046558"/>
            <a:ext cx="6191250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Amino acids are required for IGF-I mRNA expression in cultured hepatocyte models, related to Figure 3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Rat primary hepatocytes and HepG2 human hepatoma cells were cultured in Full and Zero medium for 24 hours, and </a:t>
            </a:r>
            <a:r>
              <a:rPr kumimoji="1"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Igf1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mRNA levels were quantified by </a:t>
            </a:r>
            <a:r>
              <a:rPr kumimoji="1"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realtime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qPCR. Values were normalized against </a:t>
            </a:r>
            <a:r>
              <a:rPr kumimoji="1" lang="en-US" altLang="ja-JP" sz="1050" i="1" dirty="0" err="1"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mRNA levels.</a:t>
            </a: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[bar graph: means ±</a:t>
            </a:r>
            <a:r>
              <a:rPr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SEM, *</a:t>
            </a:r>
            <a:r>
              <a:rPr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&lt; 0.05, Student’s T test, n=4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EC162211-7F69-47F8-BEE3-E9439DFC1F28}"/>
              </a:ext>
            </a:extLst>
          </p:cNvPr>
          <p:cNvGraphicFramePr>
            <a:graphicFrameLocks/>
          </p:cNvGraphicFramePr>
          <p:nvPr/>
        </p:nvGraphicFramePr>
        <p:xfrm>
          <a:off x="1095249" y="1512770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6F243057-C70D-49B9-8537-0FDA425A5167}"/>
              </a:ext>
            </a:extLst>
          </p:cNvPr>
          <p:cNvSpPr/>
          <p:nvPr/>
        </p:nvSpPr>
        <p:spPr>
          <a:xfrm>
            <a:off x="1122216" y="1246416"/>
            <a:ext cx="221406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8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rat primary hepatocytes</a:t>
            </a:r>
            <a:endParaRPr lang="ja-JP" alt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0F10571-08A0-4E1C-A99D-B0824A684D2A}"/>
              </a:ext>
            </a:extLst>
          </p:cNvPr>
          <p:cNvSpPr txBox="1"/>
          <p:nvPr/>
        </p:nvSpPr>
        <p:spPr>
          <a:xfrm>
            <a:off x="4335618" y="1246416"/>
            <a:ext cx="12089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HepG2</a:t>
            </a:r>
            <a:r>
              <a:rPr kumimoji="1" lang="ja-JP" alt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kumimoji="1" lang="ja-JP" alt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グラフ 28">
            <a:extLst>
              <a:ext uri="{FF2B5EF4-FFF2-40B4-BE49-F238E27FC236}">
                <a16:creationId xmlns:a16="http://schemas.microsoft.com/office/drawing/2014/main" id="{A8DCD3C4-6F3B-43A8-B350-44AEA99E2864}"/>
              </a:ext>
            </a:extLst>
          </p:cNvPr>
          <p:cNvGraphicFramePr>
            <a:graphicFrameLocks/>
          </p:cNvGraphicFramePr>
          <p:nvPr/>
        </p:nvGraphicFramePr>
        <p:xfrm>
          <a:off x="3772312" y="1512770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E0CBCE1-6DD1-472E-B852-63BA45DC5BD9}"/>
              </a:ext>
            </a:extLst>
          </p:cNvPr>
          <p:cNvSpPr txBox="1"/>
          <p:nvPr/>
        </p:nvSpPr>
        <p:spPr>
          <a:xfrm>
            <a:off x="5236838" y="2426581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FE884D8-1B60-4121-A75A-78F18E456D07}"/>
              </a:ext>
            </a:extLst>
          </p:cNvPr>
          <p:cNvSpPr txBox="1"/>
          <p:nvPr/>
        </p:nvSpPr>
        <p:spPr>
          <a:xfrm>
            <a:off x="2291258" y="2817361"/>
            <a:ext cx="8559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83779FC-E55B-4559-B963-009EA3A04700}"/>
              </a:ext>
            </a:extLst>
          </p:cNvPr>
          <p:cNvSpPr txBox="1"/>
          <p:nvPr/>
        </p:nvSpPr>
        <p:spPr>
          <a:xfrm>
            <a:off x="649290" y="1213004"/>
            <a:ext cx="6322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8A27AAB8-E017-4CF6-B247-1DC8DFF17209}"/>
              </a:ext>
            </a:extLst>
          </p:cNvPr>
          <p:cNvSpPr txBox="1"/>
          <p:nvPr/>
        </p:nvSpPr>
        <p:spPr>
          <a:xfrm>
            <a:off x="3289216" y="1213004"/>
            <a:ext cx="6322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236560C-54BC-4C3F-8D09-929CC8F2C7DA}"/>
              </a:ext>
            </a:extLst>
          </p:cNvPr>
          <p:cNvSpPr txBox="1"/>
          <p:nvPr/>
        </p:nvSpPr>
        <p:spPr>
          <a:xfrm rot="16200000">
            <a:off x="303310" y="2359365"/>
            <a:ext cx="136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Igf1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mRNA [fold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978D2E1-DCCD-4F46-ADCF-C9D38726AF32}"/>
              </a:ext>
            </a:extLst>
          </p:cNvPr>
          <p:cNvSpPr txBox="1"/>
          <p:nvPr/>
        </p:nvSpPr>
        <p:spPr>
          <a:xfrm rot="16200000">
            <a:off x="2989004" y="2359365"/>
            <a:ext cx="1368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Igf1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mRNA [fold]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08637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F636E19A-DC38-404D-BEF0-FF6CF8065E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1930543"/>
              </p:ext>
            </p:extLst>
          </p:nvPr>
        </p:nvGraphicFramePr>
        <p:xfrm>
          <a:off x="948071" y="1310615"/>
          <a:ext cx="4961857" cy="7042596"/>
        </p:xfrm>
        <a:graphic>
          <a:graphicData uri="http://schemas.openxmlformats.org/drawingml/2006/table">
            <a:tbl>
              <a:tblPr/>
              <a:tblGrid>
                <a:gridCol w="1244287">
                  <a:extLst>
                    <a:ext uri="{9D8B030D-6E8A-4147-A177-3AD203B41FA5}">
                      <a16:colId xmlns:a16="http://schemas.microsoft.com/office/drawing/2014/main" val="1230255025"/>
                    </a:ext>
                  </a:extLst>
                </a:gridCol>
                <a:gridCol w="530746">
                  <a:extLst>
                    <a:ext uri="{9D8B030D-6E8A-4147-A177-3AD203B41FA5}">
                      <a16:colId xmlns:a16="http://schemas.microsoft.com/office/drawing/2014/main" val="4283902110"/>
                    </a:ext>
                  </a:extLst>
                </a:gridCol>
                <a:gridCol w="531333">
                  <a:extLst>
                    <a:ext uri="{9D8B030D-6E8A-4147-A177-3AD203B41FA5}">
                      <a16:colId xmlns:a16="http://schemas.microsoft.com/office/drawing/2014/main" val="3079953268"/>
                    </a:ext>
                  </a:extLst>
                </a:gridCol>
                <a:gridCol w="530746">
                  <a:extLst>
                    <a:ext uri="{9D8B030D-6E8A-4147-A177-3AD203B41FA5}">
                      <a16:colId xmlns:a16="http://schemas.microsoft.com/office/drawing/2014/main" val="2599591641"/>
                    </a:ext>
                  </a:extLst>
                </a:gridCol>
                <a:gridCol w="531333">
                  <a:extLst>
                    <a:ext uri="{9D8B030D-6E8A-4147-A177-3AD203B41FA5}">
                      <a16:colId xmlns:a16="http://schemas.microsoft.com/office/drawing/2014/main" val="1247161949"/>
                    </a:ext>
                  </a:extLst>
                </a:gridCol>
                <a:gridCol w="531333">
                  <a:extLst>
                    <a:ext uri="{9D8B030D-6E8A-4147-A177-3AD203B41FA5}">
                      <a16:colId xmlns:a16="http://schemas.microsoft.com/office/drawing/2014/main" val="2230933598"/>
                    </a:ext>
                  </a:extLst>
                </a:gridCol>
                <a:gridCol w="530746">
                  <a:extLst>
                    <a:ext uri="{9D8B030D-6E8A-4147-A177-3AD203B41FA5}">
                      <a16:colId xmlns:a16="http://schemas.microsoft.com/office/drawing/2014/main" val="2628629248"/>
                    </a:ext>
                  </a:extLst>
                </a:gridCol>
                <a:gridCol w="531333">
                  <a:extLst>
                    <a:ext uri="{9D8B030D-6E8A-4147-A177-3AD203B41FA5}">
                      <a16:colId xmlns:a16="http://schemas.microsoft.com/office/drawing/2014/main" val="1290981885"/>
                    </a:ext>
                  </a:extLst>
                </a:gridCol>
              </a:tblGrid>
              <a:tr h="354278">
                <a:tc>
                  <a:txBody>
                    <a:bodyPr/>
                    <a:lstStyle/>
                    <a:p>
                      <a:pPr algn="ctr" fontAlgn="ctr"/>
                      <a:r>
                        <a:rPr lang="ja-JP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　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N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AA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l-GR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Il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ΔLeu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b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ΔLys</a:t>
                      </a:r>
                      <a:endParaRPr lang="ja-JP" altLang="ja-JP" sz="11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b="1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ΔMet</a:t>
                      </a:r>
                      <a:endParaRPr lang="ja-JP" altLang="ja-JP" sz="11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…</a:t>
                      </a:r>
                      <a:endParaRPr lang="ja-JP" altLang="ja-JP" sz="110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8914429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Isoleuc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4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4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0919148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Leuc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3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3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3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4.3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4.3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4.3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2211658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Lysine</a:t>
                      </a:r>
                      <a:r>
                        <a:rPr lang="ja-JP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・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HCl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7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7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3202605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D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Methion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.4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.4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.4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.4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1</a:t>
                      </a: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9486001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Cyst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8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3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8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8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8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8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897021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Phenylalan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4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3103103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Tyros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8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6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7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8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8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.8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3554602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Threon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0127841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Tryptophan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.7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6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.7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.7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.7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.7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3252159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Val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7600434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Histid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.3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4402043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Argin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.7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2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5591511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Alan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.3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499353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Aspartic acid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.7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6405187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Asparagine</a:t>
                      </a:r>
                      <a:r>
                        <a:rPr lang="ja-JP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・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H</a:t>
                      </a:r>
                      <a:r>
                        <a:rPr lang="ja-JP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₂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O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8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.9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7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8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8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8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833217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Glutamic acid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6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9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7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6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6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6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2711119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lyc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6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9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6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6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6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6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9049440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Prol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5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5.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5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5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5.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3855983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Ser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.7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.1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8.1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7547320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  L</a:t>
                      </a: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-Glutamin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6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.9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7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6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6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4.6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3734450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ellulos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6321952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vitamin mixture 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2887863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mineral mixtue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31448527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soybean oil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5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6401375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orn starch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47.5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49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52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656.2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656.9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kern="100" dirty="0">
                          <a:effectLst/>
                          <a:latin typeface="Arial" panose="020B0604020202020204" pitchFamily="34" charset="0"/>
                          <a:ea typeface="ＭＳ 明朝" panose="02020609040205080304" pitchFamily="17" charset="-128"/>
                          <a:cs typeface="Arial" panose="020B0604020202020204" pitchFamily="34" charset="0"/>
                        </a:rPr>
                        <a:t>651.8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8680976"/>
                  </a:ext>
                </a:extLst>
              </a:tr>
              <a:tr h="2572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total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0</a:t>
                      </a:r>
                      <a:endParaRPr lang="ja-JP" sz="1050" kern="10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000</a:t>
                      </a:r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endParaRPr lang="ja-JP" sz="1050" kern="100" dirty="0">
                        <a:effectLst/>
                        <a:latin typeface="Arial" panose="020B0604020202020204" pitchFamily="34" charset="0"/>
                        <a:ea typeface="ＭＳ 明朝" panose="02020609040205080304" pitchFamily="17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5983531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FF6E7C4-E8B8-4989-9FB9-CC367CC35865}"/>
              </a:ext>
            </a:extLst>
          </p:cNvPr>
          <p:cNvSpPr txBox="1"/>
          <p:nvPr/>
        </p:nvSpPr>
        <p:spPr>
          <a:xfrm>
            <a:off x="629978" y="607497"/>
            <a:ext cx="55980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 Amino acid composition of the experimental diets, related to Figure 1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CCC1620-A618-465F-A2E9-F957C2755A47}"/>
              </a:ext>
            </a:extLst>
          </p:cNvPr>
          <p:cNvSpPr txBox="1"/>
          <p:nvPr/>
        </p:nvSpPr>
        <p:spPr>
          <a:xfrm>
            <a:off x="5668923" y="8367547"/>
            <a:ext cx="4820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[g]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8657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101D473-98FB-4697-8207-5D2736D9E1B4}"/>
              </a:ext>
            </a:extLst>
          </p:cNvPr>
          <p:cNvSpPr txBox="1"/>
          <p:nvPr/>
        </p:nvSpPr>
        <p:spPr>
          <a:xfrm>
            <a:off x="915337" y="1069162"/>
            <a:ext cx="50273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 Composition of experimental diets, related to Figure 2</a:t>
            </a:r>
          </a:p>
        </p:txBody>
      </p:sp>
      <p:graphicFrame>
        <p:nvGraphicFramePr>
          <p:cNvPr id="3" name="表 3">
            <a:extLst>
              <a:ext uri="{FF2B5EF4-FFF2-40B4-BE49-F238E27FC236}">
                <a16:creationId xmlns:a16="http://schemas.microsoft.com/office/drawing/2014/main" id="{F7AA9D29-F232-4965-A046-DA36E8FB61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7043083"/>
              </p:ext>
            </p:extLst>
          </p:nvPr>
        </p:nvGraphicFramePr>
        <p:xfrm>
          <a:off x="1393240" y="1614872"/>
          <a:ext cx="4071520" cy="27651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49302">
                  <a:extLst>
                    <a:ext uri="{9D8B030D-6E8A-4147-A177-3AD203B41FA5}">
                      <a16:colId xmlns:a16="http://schemas.microsoft.com/office/drawing/2014/main" val="622584357"/>
                    </a:ext>
                  </a:extLst>
                </a:gridCol>
                <a:gridCol w="1061109">
                  <a:extLst>
                    <a:ext uri="{9D8B030D-6E8A-4147-A177-3AD203B41FA5}">
                      <a16:colId xmlns:a16="http://schemas.microsoft.com/office/drawing/2014/main" val="3967087803"/>
                    </a:ext>
                  </a:extLst>
                </a:gridCol>
                <a:gridCol w="1061109">
                  <a:extLst>
                    <a:ext uri="{9D8B030D-6E8A-4147-A177-3AD203B41FA5}">
                      <a16:colId xmlns:a16="http://schemas.microsoft.com/office/drawing/2014/main" val="901430243"/>
                    </a:ext>
                  </a:extLst>
                </a:gridCol>
              </a:tblGrid>
              <a:tr h="29106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kg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0715517"/>
                  </a:ext>
                </a:extLst>
              </a:tr>
              <a:tr h="274893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in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838491"/>
                  </a:ext>
                </a:extLst>
              </a:tr>
              <a:tr h="274893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methionin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3533070"/>
                  </a:ext>
                </a:extLst>
              </a:tr>
              <a:tr h="274893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nstarch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8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4304749"/>
                  </a:ext>
                </a:extLst>
              </a:tr>
              <a:tr h="274893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ros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4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5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8927427"/>
                  </a:ext>
                </a:extLst>
              </a:tr>
              <a:tr h="274893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ulos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2467717"/>
                  </a:ext>
                </a:extLst>
              </a:tr>
              <a:tr h="274893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N93 vitamin mixtur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9787367"/>
                  </a:ext>
                </a:extLst>
              </a:tr>
              <a:tr h="274893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IN93G mineral mixtur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3811700"/>
                  </a:ext>
                </a:extLst>
              </a:tr>
              <a:tr h="274893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n oil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3794118"/>
                  </a:ext>
                </a:extLst>
              </a:tr>
              <a:tr h="274893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05592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54142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101D473-98FB-4697-8207-5D2736D9E1B4}"/>
              </a:ext>
            </a:extLst>
          </p:cNvPr>
          <p:cNvSpPr txBox="1"/>
          <p:nvPr/>
        </p:nvSpPr>
        <p:spPr>
          <a:xfrm>
            <a:off x="437435" y="1069162"/>
            <a:ext cx="59831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3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 Tissue weight of mice, related to Figure 2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alues are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s±SEM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n=6).</a:t>
            </a:r>
          </a:p>
        </p:txBody>
      </p:sp>
      <p:graphicFrame>
        <p:nvGraphicFramePr>
          <p:cNvPr id="3" name="表 3">
            <a:extLst>
              <a:ext uri="{FF2B5EF4-FFF2-40B4-BE49-F238E27FC236}">
                <a16:creationId xmlns:a16="http://schemas.microsoft.com/office/drawing/2014/main" id="{F7AA9D29-F232-4965-A046-DA36E8FB616A}"/>
              </a:ext>
            </a:extLst>
          </p:cNvPr>
          <p:cNvGraphicFramePr>
            <a:graphicFrameLocks noGrp="1"/>
          </p:cNvGraphicFramePr>
          <p:nvPr/>
        </p:nvGraphicFramePr>
        <p:xfrm>
          <a:off x="332131" y="1770321"/>
          <a:ext cx="6193738" cy="23807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49302">
                  <a:extLst>
                    <a:ext uri="{9D8B030D-6E8A-4147-A177-3AD203B41FA5}">
                      <a16:colId xmlns:a16="http://schemas.microsoft.com/office/drawing/2014/main" val="622584357"/>
                    </a:ext>
                  </a:extLst>
                </a:gridCol>
                <a:gridCol w="1061109">
                  <a:extLst>
                    <a:ext uri="{9D8B030D-6E8A-4147-A177-3AD203B41FA5}">
                      <a16:colId xmlns:a16="http://schemas.microsoft.com/office/drawing/2014/main" val="3967087803"/>
                    </a:ext>
                  </a:extLst>
                </a:gridCol>
                <a:gridCol w="1061109">
                  <a:extLst>
                    <a:ext uri="{9D8B030D-6E8A-4147-A177-3AD203B41FA5}">
                      <a16:colId xmlns:a16="http://schemas.microsoft.com/office/drawing/2014/main" val="901430243"/>
                    </a:ext>
                  </a:extLst>
                </a:gridCol>
                <a:gridCol w="1061109">
                  <a:extLst>
                    <a:ext uri="{9D8B030D-6E8A-4147-A177-3AD203B41FA5}">
                      <a16:colId xmlns:a16="http://schemas.microsoft.com/office/drawing/2014/main" val="3327643576"/>
                    </a:ext>
                  </a:extLst>
                </a:gridCol>
                <a:gridCol w="1061109">
                  <a:extLst>
                    <a:ext uri="{9D8B030D-6E8A-4147-A177-3AD203B41FA5}">
                      <a16:colId xmlns:a16="http://schemas.microsoft.com/office/drawing/2014/main" val="3900369016"/>
                    </a:ext>
                  </a:extLst>
                </a:gridCol>
              </a:tblGrid>
              <a:tr h="358849">
                <a:tc>
                  <a:txBody>
                    <a:bodyPr/>
                    <a:lstStyle/>
                    <a:p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 protein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8287587"/>
                  </a:ext>
                </a:extLst>
              </a:tr>
              <a:tr h="358849"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IGF</a:t>
                      </a: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I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IGF</a:t>
                      </a:r>
                      <a:r>
                        <a:rPr kumimoji="1" lang="en-US" altLang="ja-JP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I</a:t>
                      </a:r>
                      <a:endParaRPr kumimoji="1" lang="ja-JP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0715517"/>
                  </a:ext>
                </a:extLst>
              </a:tr>
              <a:tr h="332606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 [mg]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3.6</a:t>
                      </a:r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33.5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8.4±25.6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2.8±16.9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7.1±11.7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838491"/>
                  </a:ext>
                </a:extLst>
              </a:tr>
              <a:tr h="332606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strocnemius muscle [mg]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2.5±5.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7.4±7.3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.9±6.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1.5±6.9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3533070"/>
                  </a:ext>
                </a:extLst>
              </a:tr>
              <a:tr h="332606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eus muscle [mg]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0±0.15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4±0.53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4±0.3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5±0.58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4304749"/>
                  </a:ext>
                </a:extLst>
              </a:tr>
              <a:tr h="332606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uinal WAT [mg]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.1±9.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.0±15.8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.7±9.9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.2±11.0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8927427"/>
                  </a:ext>
                </a:extLst>
              </a:tr>
              <a:tr h="332606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didymal WAT [mg]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5.0±19.2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9.4±25.9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4.3±14.5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.4±15.7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05592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22747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18</TotalTime>
  <Words>1237</Words>
  <Application>Microsoft Office PowerPoint</Application>
  <PresentationFormat>A4 Paper (210x297 mm)</PresentationFormat>
  <Paragraphs>596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20" baseType="lpstr">
      <vt:lpstr>ＭＳ 明朝</vt:lpstr>
      <vt:lpstr>ＭＳ Ｐゴシック</vt:lpstr>
      <vt:lpstr>游ゴシック</vt:lpstr>
      <vt:lpstr>游ゴシック Light</vt:lpstr>
      <vt:lpstr>游明朝</vt:lpstr>
      <vt:lpstr>Arial</vt:lpstr>
      <vt:lpstr>Calibri</vt:lpstr>
      <vt:lpstr>Calibri Light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Daisuke Yamanaka</dc:creator>
  <cp:lastModifiedBy>MDPI</cp:lastModifiedBy>
  <cp:revision>332</cp:revision>
  <cp:lastPrinted>2019-02-26T07:22:58Z</cp:lastPrinted>
  <dcterms:created xsi:type="dcterms:W3CDTF">2018-05-09T05:59:20Z</dcterms:created>
  <dcterms:modified xsi:type="dcterms:W3CDTF">2022-05-02T08:52:50Z</dcterms:modified>
</cp:coreProperties>
</file>